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  <p:sldId id="267" r:id="rId6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3D3EB4E-0FDD-DAB9-62B5-5D4BB27E12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2682DAF0-A4E4-7F40-CA35-1F428FAD0B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9127DD6F-8282-D826-742E-4BDF75900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ACE589A8-07C2-D398-5024-84D814B25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03BBE8ED-4132-90C9-D9C1-A14AA0D62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70677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A18142C-CDFE-547F-3C69-4B12251288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6A171963-386D-8D95-5487-EF002306F2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178EA5D-CEED-8F7A-434F-A3B8B72A2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EF3970C-B95F-CE71-BD56-79AE731F5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7AFB0A5-2092-22E5-329D-3CC07FC06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1834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8F90296C-F140-C5D5-3839-44D222BF9F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A9F68C5D-AF0B-00A6-2382-21BEFD512F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B613BAB-988B-B11B-2CAA-44C53106C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4D4BD31-E7B0-2CB8-DBD0-E113E8526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A9BDE5A-DA49-2D4F-AE08-0FDC2C3DD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96030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306890D-953B-A523-D491-7F11DB806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52838409-7F06-49AF-1375-9FAF69F3AC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7BA1735-F4C4-E5BC-C631-087F053E5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D762BD8-419F-7B68-FE0A-D96246A61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2EA530B-D3BB-C24F-1E63-A92F4F983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71500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CFA2DBD-226E-9F87-01DC-4E0CBE7598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A3923EEC-2545-A34E-C388-145E73517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6D1716F-41BC-3A0A-79C9-9FD600D76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4E20AF0-E01B-DCF0-E353-F7FF3A543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524D8FD-7037-A81D-67CF-CB81A477C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03048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911CB4C-2B15-3509-45F7-2DF644714F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F3411103-0948-6130-A09E-941C0219A8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18316E82-BE57-3BF8-74A7-11D4B0C1A3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DA4B0C3F-BF58-D699-510B-7C314233E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86EF3B0B-C6D5-5572-39AF-7E87BF07C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D24B19B3-1C44-EE5A-2E54-7BE1FD226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49160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6051A81-9269-A031-1439-951A50176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3E735BDB-B78C-6A5D-387C-9E948F2F36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039BE8D8-D06E-CA01-0348-C8A09ED7AD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907B9B77-D522-8C56-EB62-7826ACC5A5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112960BD-3823-CB1D-8794-322A75235C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10AE7140-FBD9-81AC-591D-8DDEBCCF8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520E7E60-A060-B8DC-9C33-E70F3D996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75F0E0F3-9A79-AED0-14F1-3B2DCF3C3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13711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CA2F278-0655-A398-F982-468D2E6EBA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6146CBDF-52F2-03AB-FEB4-37DCD6317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7CD74A26-663F-59A7-4AFD-2EE2CFC87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C9E09467-A6FE-5B16-165E-67E685704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96912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5D9A19CE-B9A8-05B5-79B8-68D7A6454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C39B68FF-469A-0288-2C31-DE640D68D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454C1566-9FFE-391A-B50C-EDCCA41484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58426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C8E1726-18C6-98BC-3C9B-42E98B9F05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6B4EF117-5E4C-53D6-C6FD-2B8503E285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76CE4C73-1399-26BF-5064-BF2FE49638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24034B12-3B4D-3E0E-1850-125039B32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80C3718-0B99-1E4D-A5BE-4F02CF65C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A056087C-2178-34D1-9999-525FD44C0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91772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241D0E5-3CC6-BB73-7801-1E21358692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A4550096-2B35-7649-C9A6-92525879B5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2DF7DFFC-5EDD-592F-907A-AEBD2A0CD7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FA50EBCD-5314-6286-2A6A-F239C7064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EFBC52E-3B91-39DA-1EF3-A7A88562A8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AC8AA4DE-44D0-E589-9C32-F95830450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00532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6CE8559C-B575-BF2E-B70B-D19E0B524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DEA01872-7F80-2350-ED99-961E6B4DE1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8E67A6B-F86B-E496-F259-CC5BD46D6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C9C150-77B5-4C87-B17F-3F93BA6E7554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A164B19-A872-2E22-BE5E-9D6EAA68BA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7DFAC13-AB3A-0719-EBE6-7F346631DA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42160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7" Type="http://schemas.openxmlformats.org/officeDocument/2006/relationships/image" Target="../media/image18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if"/><Relationship Id="rId5" Type="http://schemas.openxmlformats.org/officeDocument/2006/relationships/image" Target="../media/image16.tif"/><Relationship Id="rId4" Type="http://schemas.openxmlformats.org/officeDocument/2006/relationships/image" Target="../media/image15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"/><Relationship Id="rId3" Type="http://schemas.openxmlformats.org/officeDocument/2006/relationships/image" Target="../media/image20.tif"/><Relationship Id="rId7" Type="http://schemas.openxmlformats.org/officeDocument/2006/relationships/image" Target="../media/image24.tif"/><Relationship Id="rId2" Type="http://schemas.openxmlformats.org/officeDocument/2006/relationships/image" Target="../media/image19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tif"/><Relationship Id="rId5" Type="http://schemas.openxmlformats.org/officeDocument/2006/relationships/image" Target="../media/image22.tif"/><Relationship Id="rId4" Type="http://schemas.openxmlformats.org/officeDocument/2006/relationships/image" Target="../media/image21.tif"/><Relationship Id="rId9" Type="http://schemas.openxmlformats.org/officeDocument/2006/relationships/image" Target="../media/image26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"/><Relationship Id="rId2" Type="http://schemas.openxmlformats.org/officeDocument/2006/relationships/image" Target="../media/image27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0.tif"/><Relationship Id="rId4" Type="http://schemas.openxmlformats.org/officeDocument/2006/relationships/image" Target="../media/image29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"/><Relationship Id="rId7" Type="http://schemas.openxmlformats.org/officeDocument/2006/relationships/image" Target="../media/image36.tif"/><Relationship Id="rId2" Type="http://schemas.openxmlformats.org/officeDocument/2006/relationships/image" Target="../media/image3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tif"/><Relationship Id="rId5" Type="http://schemas.openxmlformats.org/officeDocument/2006/relationships/image" Target="../media/image34.tif"/><Relationship Id="rId4" Type="http://schemas.openxmlformats.org/officeDocument/2006/relationships/image" Target="../media/image3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4E61EA46-CF03-FBB6-50D2-3D75129E7EDA}"/>
              </a:ext>
            </a:extLst>
          </p:cNvPr>
          <p:cNvSpPr txBox="1"/>
          <p:nvPr/>
        </p:nvSpPr>
        <p:spPr>
          <a:xfrm>
            <a:off x="68367" y="68366"/>
            <a:ext cx="2250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/>
              <a:t>Oxidative</a:t>
            </a:r>
            <a:r>
              <a:rPr lang="hu-HU" b="1" dirty="0"/>
              <a:t> </a:t>
            </a:r>
            <a:r>
              <a:rPr lang="hu-HU" b="1" dirty="0" err="1"/>
              <a:t>markers</a:t>
            </a:r>
            <a:r>
              <a:rPr lang="hu-HU" b="1" dirty="0"/>
              <a:t>:</a:t>
            </a:r>
          </a:p>
        </p:txBody>
      </p:sp>
      <p:grpSp>
        <p:nvGrpSpPr>
          <p:cNvPr id="89" name="Csoportba foglalás 88">
            <a:extLst>
              <a:ext uri="{FF2B5EF4-FFF2-40B4-BE49-F238E27FC236}">
                <a16:creationId xmlns:a16="http://schemas.microsoft.com/office/drawing/2014/main" id="{9296E3BB-606B-022C-FFBA-D3C63F72677E}"/>
              </a:ext>
            </a:extLst>
          </p:cNvPr>
          <p:cNvGrpSpPr/>
          <p:nvPr/>
        </p:nvGrpSpPr>
        <p:grpSpPr>
          <a:xfrm>
            <a:off x="68367" y="378270"/>
            <a:ext cx="11964550" cy="2059144"/>
            <a:chOff x="68367" y="378270"/>
            <a:chExt cx="11964550" cy="2059144"/>
          </a:xfrm>
        </p:grpSpPr>
        <p:grpSp>
          <p:nvGrpSpPr>
            <p:cNvPr id="84" name="Csoportba foglalás 83">
              <a:extLst>
                <a:ext uri="{FF2B5EF4-FFF2-40B4-BE49-F238E27FC236}">
                  <a16:creationId xmlns:a16="http://schemas.microsoft.com/office/drawing/2014/main" id="{18E7F1C3-AF13-E0A3-FD2E-A353B3E64B92}"/>
                </a:ext>
              </a:extLst>
            </p:cNvPr>
            <p:cNvGrpSpPr/>
            <p:nvPr/>
          </p:nvGrpSpPr>
          <p:grpSpPr>
            <a:xfrm>
              <a:off x="68367" y="378270"/>
              <a:ext cx="11964550" cy="2059144"/>
              <a:chOff x="68367" y="378270"/>
              <a:chExt cx="11964550" cy="2059144"/>
            </a:xfrm>
          </p:grpSpPr>
          <p:grpSp>
            <p:nvGrpSpPr>
              <p:cNvPr id="78" name="Csoportba foglalás 77">
                <a:extLst>
                  <a:ext uri="{FF2B5EF4-FFF2-40B4-BE49-F238E27FC236}">
                    <a16:creationId xmlns:a16="http://schemas.microsoft.com/office/drawing/2014/main" id="{62190350-4B7C-AEF1-8E9D-1830DB078026}"/>
                  </a:ext>
                </a:extLst>
              </p:cNvPr>
              <p:cNvGrpSpPr/>
              <p:nvPr/>
            </p:nvGrpSpPr>
            <p:grpSpPr>
              <a:xfrm>
                <a:off x="68367" y="378270"/>
                <a:ext cx="11964550" cy="2059144"/>
                <a:chOff x="68367" y="378270"/>
                <a:chExt cx="11964550" cy="2059144"/>
              </a:xfrm>
            </p:grpSpPr>
            <p:pic>
              <p:nvPicPr>
                <p:cNvPr id="37" name="Kép 36" descr="A képen fekete-fehér, fekete, Monokróm fényképezés, monokróm látható&#10;&#10;Automatikusan generált leírás">
                  <a:extLst>
                    <a:ext uri="{FF2B5EF4-FFF2-40B4-BE49-F238E27FC236}">
                      <a16:creationId xmlns:a16="http://schemas.microsoft.com/office/drawing/2014/main" id="{140F68DB-B89B-F35E-9D5F-FDC198B0D6F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32166" y="876821"/>
                  <a:ext cx="2340000" cy="54000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  <p:grpSp>
              <p:nvGrpSpPr>
                <p:cNvPr id="77" name="Csoportba foglalás 76">
                  <a:extLst>
                    <a:ext uri="{FF2B5EF4-FFF2-40B4-BE49-F238E27FC236}">
                      <a16:creationId xmlns:a16="http://schemas.microsoft.com/office/drawing/2014/main" id="{C569ACAC-D16B-0D65-7D7D-1F76F44BC39F}"/>
                    </a:ext>
                  </a:extLst>
                </p:cNvPr>
                <p:cNvGrpSpPr/>
                <p:nvPr/>
              </p:nvGrpSpPr>
              <p:grpSpPr>
                <a:xfrm>
                  <a:off x="68367" y="378270"/>
                  <a:ext cx="11964550" cy="2059144"/>
                  <a:chOff x="68367" y="378270"/>
                  <a:chExt cx="11964550" cy="2059144"/>
                </a:xfrm>
              </p:grpSpPr>
              <p:grpSp>
                <p:nvGrpSpPr>
                  <p:cNvPr id="66" name="Csoportba foglalás 65">
                    <a:extLst>
                      <a:ext uri="{FF2B5EF4-FFF2-40B4-BE49-F238E27FC236}">
                        <a16:creationId xmlns:a16="http://schemas.microsoft.com/office/drawing/2014/main" id="{D6C9B411-C1E3-BBAA-4EDB-B51F0FAB8755}"/>
                      </a:ext>
                    </a:extLst>
                  </p:cNvPr>
                  <p:cNvGrpSpPr/>
                  <p:nvPr/>
                </p:nvGrpSpPr>
                <p:grpSpPr>
                  <a:xfrm>
                    <a:off x="68367" y="378270"/>
                    <a:ext cx="11964550" cy="2059144"/>
                    <a:chOff x="68367" y="378270"/>
                    <a:chExt cx="11964550" cy="2059144"/>
                  </a:xfrm>
                </p:grpSpPr>
                <p:grpSp>
                  <p:nvGrpSpPr>
                    <p:cNvPr id="55" name="Csoportba foglalás 54">
                      <a:extLst>
                        <a:ext uri="{FF2B5EF4-FFF2-40B4-BE49-F238E27FC236}">
                          <a16:creationId xmlns:a16="http://schemas.microsoft.com/office/drawing/2014/main" id="{B208A52F-F241-4C85-A7AA-64EA20BF16B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7" y="378270"/>
                      <a:ext cx="11964550" cy="2059144"/>
                      <a:chOff x="68367" y="378270"/>
                      <a:chExt cx="11964550" cy="2059144"/>
                    </a:xfrm>
                  </p:grpSpPr>
                  <p:grpSp>
                    <p:nvGrpSpPr>
                      <p:cNvPr id="33" name="Csoportba foglalás 32">
                        <a:extLst>
                          <a:ext uri="{FF2B5EF4-FFF2-40B4-BE49-F238E27FC236}">
                            <a16:creationId xmlns:a16="http://schemas.microsoft.com/office/drawing/2014/main" id="{74234755-A58A-362A-7964-89361751F9A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7" y="378270"/>
                        <a:ext cx="11964550" cy="2059144"/>
                        <a:chOff x="68367" y="378270"/>
                        <a:chExt cx="11964550" cy="2059144"/>
                      </a:xfrm>
                    </p:grpSpPr>
                    <p:grpSp>
                      <p:nvGrpSpPr>
                        <p:cNvPr id="29" name="Csoportba foglalás 28">
                          <a:extLst>
                            <a:ext uri="{FF2B5EF4-FFF2-40B4-BE49-F238E27FC236}">
                              <a16:creationId xmlns:a16="http://schemas.microsoft.com/office/drawing/2014/main" id="{88326EFE-B619-7E6D-1EA2-D393C420E49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7" y="378270"/>
                          <a:ext cx="11964550" cy="2059144"/>
                          <a:chOff x="68367" y="378270"/>
                          <a:chExt cx="11964550" cy="2059144"/>
                        </a:xfrm>
                      </p:grpSpPr>
                      <p:grpSp>
                        <p:nvGrpSpPr>
                          <p:cNvPr id="22" name="Csoportba foglalás 21">
                            <a:extLst>
                              <a:ext uri="{FF2B5EF4-FFF2-40B4-BE49-F238E27FC236}">
                                <a16:creationId xmlns:a16="http://schemas.microsoft.com/office/drawing/2014/main" id="{BEE41243-DEF0-695A-74F2-20214D9B4C58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7" y="378270"/>
                            <a:ext cx="11964550" cy="2059144"/>
                            <a:chOff x="68367" y="378270"/>
                            <a:chExt cx="11964550" cy="2059144"/>
                          </a:xfrm>
                        </p:grpSpPr>
                        <p:grpSp>
                          <p:nvGrpSpPr>
                            <p:cNvPr id="14" name="Csoportba foglalás 13">
                              <a:extLst>
                                <a:ext uri="{FF2B5EF4-FFF2-40B4-BE49-F238E27FC236}">
                                  <a16:creationId xmlns:a16="http://schemas.microsoft.com/office/drawing/2014/main" id="{541167DF-5407-7CBE-3B02-E3ACE616F486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7" y="378270"/>
                              <a:ext cx="11964550" cy="2059144"/>
                              <a:chOff x="68367" y="378270"/>
                              <a:chExt cx="11964550" cy="2059144"/>
                            </a:xfrm>
                          </p:grpSpPr>
                          <p:grpSp>
                            <p:nvGrpSpPr>
                              <p:cNvPr id="82" name="Csoportba foglalás 81">
                                <a:extLst>
                                  <a:ext uri="{FF2B5EF4-FFF2-40B4-BE49-F238E27FC236}">
                                    <a16:creationId xmlns:a16="http://schemas.microsoft.com/office/drawing/2014/main" id="{E4D819F0-F49E-F51F-1614-D4572937A902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7" y="378270"/>
                                <a:ext cx="11964550" cy="2059144"/>
                                <a:chOff x="68367" y="378270"/>
                                <a:chExt cx="11964550" cy="2059144"/>
                              </a:xfrm>
                            </p:grpSpPr>
                            <p:grpSp>
                              <p:nvGrpSpPr>
                                <p:cNvPr id="76" name="Csoportba foglalás 75">
                                  <a:extLst>
                                    <a:ext uri="{FF2B5EF4-FFF2-40B4-BE49-F238E27FC236}">
                                      <a16:creationId xmlns:a16="http://schemas.microsoft.com/office/drawing/2014/main" id="{07F847BE-36B5-68B3-4646-5E2854D87DFD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8367" y="378270"/>
                                  <a:ext cx="11964550" cy="2059144"/>
                                  <a:chOff x="68367" y="378270"/>
                                  <a:chExt cx="11964550" cy="2059144"/>
                                </a:xfrm>
                              </p:grpSpPr>
                              <p:grpSp>
                                <p:nvGrpSpPr>
                                  <p:cNvPr id="70" name="Csoportba foglalás 69">
                                    <a:extLst>
                                      <a:ext uri="{FF2B5EF4-FFF2-40B4-BE49-F238E27FC236}">
                                        <a16:creationId xmlns:a16="http://schemas.microsoft.com/office/drawing/2014/main" id="{60DE8A5E-1551-9ADE-B800-4FE5FDE480CA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8367" y="378270"/>
                                    <a:ext cx="11964550" cy="2059144"/>
                                    <a:chOff x="68367" y="378270"/>
                                    <a:chExt cx="11964550" cy="2059144"/>
                                  </a:xfrm>
                                </p:grpSpPr>
                                <p:grpSp>
                                  <p:nvGrpSpPr>
                                    <p:cNvPr id="64" name="Csoportba foglalás 63">
                                      <a:extLst>
                                        <a:ext uri="{FF2B5EF4-FFF2-40B4-BE49-F238E27FC236}">
                                          <a16:creationId xmlns:a16="http://schemas.microsoft.com/office/drawing/2014/main" id="{99070FB3-458C-B6BA-F426-7CBE7ACAB0A8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8367" y="378270"/>
                                      <a:ext cx="11964550" cy="2059144"/>
                                      <a:chOff x="68367" y="378270"/>
                                      <a:chExt cx="11964550" cy="2059144"/>
                                    </a:xfrm>
                                  </p:grpSpPr>
                                  <p:grpSp>
                                    <p:nvGrpSpPr>
                                      <p:cNvPr id="59" name="Csoportba foglalás 58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D69FBEC8-63C6-D8A3-6667-5AB6865BEE97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8367" y="378270"/>
                                        <a:ext cx="11964550" cy="2059144"/>
                                        <a:chOff x="68367" y="378270"/>
                                        <a:chExt cx="11964550" cy="2059144"/>
                                      </a:xfrm>
                                    </p:grpSpPr>
                                    <p:grpSp>
                                      <p:nvGrpSpPr>
                                        <p:cNvPr id="5" name="Csoportba foglalás 4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666EC76C-2260-6217-0624-8D898ED5A4E4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8367" y="378270"/>
                                          <a:ext cx="11964550" cy="2059144"/>
                                          <a:chOff x="68367" y="378270"/>
                                          <a:chExt cx="11964550" cy="2059144"/>
                                        </a:xfrm>
                                      </p:grpSpPr>
                                      <p:sp>
                                        <p:nvSpPr>
                                          <p:cNvPr id="6" name="Szövegdoboz 5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1EE92C5E-E4EC-2CEC-670B-01AFCBAF0098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5619768" y="1528132"/>
                                            <a:ext cx="47000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DMSO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7" name="Szövegdoboz 6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DCA53139-B3EF-2478-66CC-2DBFD2DA811A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6628634" y="1525040"/>
                                            <a:ext cx="457176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UDCA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8" name="Szövegdoboz 7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59B18E5D-9CAA-1B96-B3D8-B587D74C772B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3716712" y="1516044"/>
                                            <a:ext cx="47000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DMSO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9" name="Szövegdoboz 8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CBA7CB9F-0B07-F693-FF24-6BAB2FD09EA9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3343447" y="1522379"/>
                                            <a:ext cx="457176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UDCA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0" name="Szövegdoboz 9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26D52466-16B5-4210-DBA7-126A8D1CC5F2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9993201" y="1510630"/>
                                            <a:ext cx="47000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DMSO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1" name="Szövegdoboz 10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E1C1C8CB-BEF3-799C-6817-7756DC67E587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10401483" y="1514943"/>
                                            <a:ext cx="457176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UDCA</a:t>
                                            </a:r>
                                          </a:p>
                                        </p:txBody>
                                      </p:sp>
                                      <p:grpSp>
                                        <p:nvGrpSpPr>
                                          <p:cNvPr id="13" name="Csoportba foglalás 12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F7953510-80C4-08DE-5F12-30E0E9381EFE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68367" y="378270"/>
                                            <a:ext cx="11964550" cy="2059144"/>
                                            <a:chOff x="68367" y="378270"/>
                                            <a:chExt cx="11964550" cy="2059144"/>
                                          </a:xfrm>
                                        </p:grpSpPr>
                                        <p:grpSp>
                                          <p:nvGrpSpPr>
                                            <p:cNvPr id="17" name="Csoportba foglalás 16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D2869022-5E02-D495-459D-4C73CF0945AD}"/>
                                                </a:ext>
                                              </a:extLst>
                                            </p:cNvPr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68367" y="378270"/>
                                              <a:ext cx="11964550" cy="2059144"/>
                                              <a:chOff x="68367" y="378270"/>
                                              <a:chExt cx="11964550" cy="2059144"/>
                                            </a:xfrm>
                                          </p:grpSpPr>
                                          <p:sp>
                                            <p:nvSpPr>
                                              <p:cNvPr id="24" name="Szövegdoboz 23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9DBE9E64-7749-5286-A934-87C2DA3328AA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5682070" y="649865"/>
                                                <a:ext cx="470000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DMSO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25" name="Szövegdoboz 24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74AB1839-0AF7-9320-D373-719005F5B9E5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6675690" y="656200"/>
                                                <a:ext cx="457176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UDCA</a:t>
                                                </a:r>
                                              </a:p>
                                            </p:txBody>
                                          </p:sp>
                                          <p:grpSp>
                                            <p:nvGrpSpPr>
                                              <p:cNvPr id="40" name="Csoportba foglalás 39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AD74C5FA-955A-53AC-A5DE-7102165BBD28}"/>
                                                  </a:ext>
                                                </a:extLst>
                                              </p:cNvPr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68367" y="378270"/>
                                                <a:ext cx="11964550" cy="2059144"/>
                                                <a:chOff x="68367" y="415477"/>
                                                <a:chExt cx="11964550" cy="2059144"/>
                                              </a:xfrm>
                                            </p:grpSpPr>
                                            <p:sp>
                                              <p:nvSpPr>
                                                <p:cNvPr id="45" name="Szövegdoboz 44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66D3585D-B626-E2C5-481E-54A1670C3C57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8367" y="1048238"/>
                                                  <a:ext cx="999857" cy="307777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squar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1400" dirty="0" err="1"/>
                                                    <a:t>iNOS</a:t>
                                                  </a:r>
                                                  <a:r>
                                                    <a:rPr lang="hu-HU" sz="1400" dirty="0"/>
                                                    <a:t>:</a:t>
                                                  </a:r>
                                                </a:p>
                                              </p:txBody>
                                            </p:sp>
                                            <p:sp>
                                              <p:nvSpPr>
                                                <p:cNvPr id="46" name="Szövegdoboz 45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D28978E5-AA9F-8E23-7150-26C97BBEA88B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8367" y="1815547"/>
                                                  <a:ext cx="803304" cy="307777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squar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1400" dirty="0"/>
                                                    <a:t>β-</a:t>
                                                  </a:r>
                                                  <a:r>
                                                    <a:rPr lang="hu-HU" sz="1400" dirty="0" err="1"/>
                                                    <a:t>actin</a:t>
                                                  </a:r>
                                                  <a:r>
                                                    <a:rPr lang="hu-HU" sz="1400" dirty="0"/>
                                                    <a:t>:</a:t>
                                                  </a:r>
                                                </a:p>
                                              </p:txBody>
                                            </p:sp>
                                            <p:grpSp>
                                              <p:nvGrpSpPr>
                                                <p:cNvPr id="47" name="Csoportba foglalás 46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ECC78131-FA46-9B9E-121A-F2AFAC1773DF}"/>
                                                    </a:ext>
                                                  </a:extLst>
                                                </p:cNvPr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2797923" y="415641"/>
                                                  <a:ext cx="1377794" cy="490549"/>
                                                  <a:chOff x="2797923" y="415641"/>
                                                  <a:chExt cx="1377794" cy="490549"/>
                                                </a:xfrm>
                                              </p:grpSpPr>
                                              <p:grpSp>
                                                <p:nvGrpSpPr>
                                                  <p:cNvPr id="51" name="Csoportba foglalás 50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D1F86804-959C-FDB1-6496-7E5C944541AE}"/>
                                                      </a:ext>
                                                    </a:extLst>
                                                  </p:cNvPr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3341880" y="684411"/>
                                                    <a:ext cx="833837" cy="221779"/>
                                                    <a:chOff x="3341880" y="308401"/>
                                                    <a:chExt cx="833837" cy="221779"/>
                                                  </a:xfrm>
                                                </p:grpSpPr>
                                                <p:sp>
                                                  <p:nvSpPr>
                                                    <p:cNvPr id="53" name="Szövegdoboz 52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4185ACB4-2E26-53E4-7817-E9EC98D80B21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3705717" y="308401"/>
                                                      <a:ext cx="470000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DMSO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  <p:sp>
                                                  <p:nvSpPr>
                                                    <p:cNvPr id="54" name="Szövegdoboz 53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FBEA5532-CAE2-88D1-FBDE-A57D01FAD56E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3341880" y="314736"/>
                                                      <a:ext cx="457176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UDCA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</p:grpSp>
                                              <p:sp>
                                                <p:nvSpPr>
                                                  <p:cNvPr id="52" name="Szövegdoboz 51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87C03FB1-0305-6610-B2F8-3AF2F9687DAF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2797923" y="415641"/>
                                                    <a:ext cx="332142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b="1" dirty="0"/>
                                                      <a:t>1.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</p:grpSp>
                                            <p:sp>
                                              <p:nvSpPr>
                                                <p:cNvPr id="48" name="Szövegdoboz 47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FF8775A9-DE28-A990-FA6B-A5EA7988A5B4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271647" y="416294"/>
                                                  <a:ext cx="335348" cy="307777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1400" b="1" dirty="0"/>
                                                    <a:t>2.</a:t>
                                                  </a:r>
                                                </a:p>
                                              </p:txBody>
                                            </p:sp>
                                            <p:sp>
                                              <p:nvSpPr>
                                                <p:cNvPr id="49" name="Szövegdoboz 48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D9333B53-470F-176B-2960-30B707B78615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10016820" y="415477"/>
                                                  <a:ext cx="335348" cy="307777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1400" b="1" dirty="0"/>
                                                    <a:t>3.</a:t>
                                                  </a:r>
                                                </a:p>
                                              </p:txBody>
                                            </p:sp>
                                            <p:sp>
                                              <p:nvSpPr>
                                                <p:cNvPr id="50" name="Téglalap 49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7EE5AF85-79AD-2E88-859A-74FA3BC508C3}"/>
                                                    </a:ext>
                                                  </a:extLst>
                                                </p:cNvPr>
                                                <p:cNvSpPr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70822" y="474905"/>
                                                  <a:ext cx="11962095" cy="1999716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style>
                                                <a:lnRef idx="2">
                                                  <a:schemeClr val="accent1">
                                                    <a:shade val="15000"/>
                                                  </a:schemeClr>
                                                </a:lnRef>
                                                <a:fillRef idx="1">
                                                  <a:schemeClr val="accent1"/>
                                                </a:fillRef>
                                                <a:effectRef idx="0">
                                                  <a:schemeClr val="accent1"/>
                                                </a:effectRef>
                                                <a:fontRef idx="minor">
                                                  <a:schemeClr val="lt1"/>
                                                </a:fontRef>
                                              </p:style>
                                              <p:txBody>
                                                <a:bodyPr rtlCol="0" anchor="ctr"/>
                                                <a:lstStyle/>
                                                <a:p>
                                                  <a:pPr algn="ctr"/>
                                                  <a:endParaRPr lang="hu-HU"/>
                                                </a:p>
                                              </p:txBody>
                                            </p:sp>
                                          </p:grpSp>
                                        </p:grpSp>
                                        <p:sp>
                                          <p:nvSpPr>
                                            <p:cNvPr id="19" name="Szövegdoboz 18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BF3BA821-64F9-7542-13DC-3694C7DD53BF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9718250" y="651217"/>
                                              <a:ext cx="47000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DMSO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20" name="Szövegdoboz 19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BFA7C2B5-D68F-0DB7-73EE-E123146A0886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0239664" y="655530"/>
                                              <a:ext cx="457176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UDCA</a:t>
                                              </a:r>
                                            </a:p>
                                          </p:txBody>
                                        </p:sp>
                                      </p:grpSp>
                                    </p:grpSp>
                                    <p:sp>
                                      <p:nvSpPr>
                                        <p:cNvPr id="58" name="Szövegdoboz 57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0FA3A88A-7BFD-0A39-C497-4857235015E0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1433108" y="808961"/>
                                          <a:ext cx="348172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250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63" name="Szövegdoboz 62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1C6F6342-181D-2A47-4D70-C59B7A57178E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491238" y="1696650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55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68" name="Szövegdoboz 67">
                                      <a:extLst>
                                        <a:ext uri="{FF2B5EF4-FFF2-40B4-BE49-F238E27FC236}">
                                          <a16:creationId xmlns:a16="http://schemas.microsoft.com/office/drawing/2014/main" id="{8DBE66C4-12F2-DD57-ECF1-DA0D24D51BFB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912432" y="1189865"/>
                                      <a:ext cx="348172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100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69" name="Szövegdoboz 68">
                                      <a:extLst>
                                        <a:ext uri="{FF2B5EF4-FFF2-40B4-BE49-F238E27FC236}">
                                          <a16:creationId xmlns:a16="http://schemas.microsoft.com/office/drawing/2014/main" id="{BCBE7002-9572-864F-B271-4C392B6D54C9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914000" y="880351"/>
                                      <a:ext cx="348172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130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74" name="Szövegdoboz 73">
                                    <a:extLst>
                                      <a:ext uri="{FF2B5EF4-FFF2-40B4-BE49-F238E27FC236}">
                                        <a16:creationId xmlns:a16="http://schemas.microsoft.com/office/drawing/2014/main" id="{3B0CFB52-98AD-0BAE-3F2B-AA20920D756B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4961135" y="1917300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35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75" name="Szövegdoboz 74">
                                    <a:extLst>
                                      <a:ext uri="{FF2B5EF4-FFF2-40B4-BE49-F238E27FC236}">
                                        <a16:creationId xmlns:a16="http://schemas.microsoft.com/office/drawing/2014/main" id="{CA52119A-7028-EC42-B001-B72931896E94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4962703" y="1683202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55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80" name="Szövegdoboz 79">
                                  <a:extLst>
                                    <a:ext uri="{FF2B5EF4-FFF2-40B4-BE49-F238E27FC236}">
                                      <a16:creationId xmlns:a16="http://schemas.microsoft.com/office/drawing/2014/main" id="{BE0AE24B-F7DA-5C43-7207-DD5032C6A0E0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8628166" y="1691054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55</a:t>
                                  </a:r>
                                </a:p>
                              </p:txBody>
                            </p:sp>
                          </p:grpSp>
                          <p:pic>
                            <p:nvPicPr>
                              <p:cNvPr id="12" name="Kép 11" descr="A képen fehér, fekete, fekete-fehér, monokróm látható&#10;&#10;Automatikusan generált leírás">
                                <a:extLst>
                                  <a:ext uri="{FF2B5EF4-FFF2-40B4-BE49-F238E27FC236}">
                                    <a16:creationId xmlns:a16="http://schemas.microsoft.com/office/drawing/2014/main" id="{E66DCC8D-AFF8-4244-5944-4763EB2A81EB}"/>
                                  </a:ext>
                                </a:extLst>
                              </p:cNvPr>
                              <p:cNvPicPr>
                                <a:picLocks/>
                              </p:cNvPicPr>
                              <p:nvPr/>
                            </p:nvPicPr>
                            <p:blipFill>
                              <a:blip r:embed="rId3">
                                <a:extLst>
                                  <a:ext uri="{28A0092B-C50C-407E-A947-70E740481C1C}">
                                    <a14:useLocalDpi xmlns:a14="http://schemas.microsoft.com/office/drawing/2010/main" val="0"/>
                                  </a:ext>
                                </a:extLst>
                              </a:blip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792767" y="876821"/>
                                <a:ext cx="2340000" cy="540000"/>
                              </a:xfrm>
                              <a:prstGeom prst="rect">
                                <a:avLst/>
                              </a:prstGeom>
                              <a:ln w="9525">
                                <a:solidFill>
                                  <a:schemeClr val="tx1"/>
                                </a:solidFill>
                              </a:ln>
                            </p:spPr>
                          </p:pic>
                        </p:grpSp>
                        <p:sp>
                          <p:nvSpPr>
                            <p:cNvPr id="18" name="Szövegdoboz 17">
                              <a:extLst>
                                <a:ext uri="{FF2B5EF4-FFF2-40B4-BE49-F238E27FC236}">
                                  <a16:creationId xmlns:a16="http://schemas.microsoft.com/office/drawing/2014/main" id="{5EB4E4E8-4465-901C-0C1F-467C42EC9A2A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434676" y="1046204"/>
                              <a:ext cx="348172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130</a:t>
                              </a:r>
                            </a:p>
                          </p:txBody>
                        </p:sp>
                        <p:sp>
                          <p:nvSpPr>
                            <p:cNvPr id="21" name="Szövegdoboz 20">
                              <a:extLst>
                                <a:ext uri="{FF2B5EF4-FFF2-40B4-BE49-F238E27FC236}">
                                  <a16:creationId xmlns:a16="http://schemas.microsoft.com/office/drawing/2014/main" id="{7056F621-6DE4-7B91-184D-1C9EE20A6CD2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436246" y="1264593"/>
                              <a:ext cx="348172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100</a:t>
                              </a:r>
                            </a:p>
                          </p:txBody>
                        </p:sp>
                      </p:grpSp>
                      <p:pic>
                        <p:nvPicPr>
                          <p:cNvPr id="28" name="Kép 27" descr="A képen fekete, fehér, homályos, fekete-fehér látható&#10;&#10;Automatikusan generált leírás">
                            <a:extLst>
                              <a:ext uri="{FF2B5EF4-FFF2-40B4-BE49-F238E27FC236}">
                                <a16:creationId xmlns:a16="http://schemas.microsoft.com/office/drawing/2014/main" id="{2A302230-52A1-CE78-F1FD-B7911CB375BB}"/>
                              </a:ext>
                            </a:extLst>
                          </p:cNvPr>
                          <p:cNvPicPr>
                            <a:picLocks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1792767" y="1746319"/>
                            <a:ext cx="2340000" cy="540000"/>
                          </a:xfrm>
                          <a:prstGeom prst="rect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</p:pic>
                    </p:grpSp>
                    <p:sp>
                      <p:nvSpPr>
                        <p:cNvPr id="32" name="Szövegdoboz 31">
                          <a:extLst>
                            <a:ext uri="{FF2B5EF4-FFF2-40B4-BE49-F238E27FC236}">
                              <a16:creationId xmlns:a16="http://schemas.microsoft.com/office/drawing/2014/main" id="{4E50FDCC-5278-358B-F6B8-D5CD847F821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483379" y="2113002"/>
                          <a:ext cx="293670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35</a:t>
                          </a:r>
                        </a:p>
                      </p:txBody>
                    </p:sp>
                  </p:grpSp>
                  <p:sp>
                    <p:nvSpPr>
                      <p:cNvPr id="38" name="Szövegdoboz 37">
                        <a:extLst>
                          <a:ext uri="{FF2B5EF4-FFF2-40B4-BE49-F238E27FC236}">
                            <a16:creationId xmlns:a16="http://schemas.microsoft.com/office/drawing/2014/main" id="{E16B3E01-124D-D197-00C9-8DFEA703668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580198" y="791675"/>
                        <a:ext cx="34817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250</a:t>
                        </a:r>
                      </a:p>
                    </p:txBody>
                  </p:sp>
                  <p:sp>
                    <p:nvSpPr>
                      <p:cNvPr id="42" name="Szövegdoboz 41">
                        <a:extLst>
                          <a:ext uri="{FF2B5EF4-FFF2-40B4-BE49-F238E27FC236}">
                            <a16:creationId xmlns:a16="http://schemas.microsoft.com/office/drawing/2014/main" id="{D7D5A1D8-9B08-8B67-BD2A-D0C7AD16B4E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581766" y="1028918"/>
                        <a:ext cx="34817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130</a:t>
                        </a:r>
                      </a:p>
                    </p:txBody>
                  </p:sp>
                  <p:sp>
                    <p:nvSpPr>
                      <p:cNvPr id="43" name="Szövegdoboz 42">
                        <a:extLst>
                          <a:ext uri="{FF2B5EF4-FFF2-40B4-BE49-F238E27FC236}">
                            <a16:creationId xmlns:a16="http://schemas.microsoft.com/office/drawing/2014/main" id="{546524FE-6B32-7EA5-0C2D-A5917FA4A87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583336" y="1247307"/>
                        <a:ext cx="34817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100</a:t>
                        </a:r>
                      </a:p>
                    </p:txBody>
                  </p:sp>
                </p:grpSp>
                <p:pic>
                  <p:nvPicPr>
                    <p:cNvPr id="65" name="Kép 64" descr="A képen fekete, fekete-fehér, monokróm, Monokróm fényképezés látható&#10;&#10;Automatikusan generált leírás">
                      <a:extLst>
                        <a:ext uri="{FF2B5EF4-FFF2-40B4-BE49-F238E27FC236}">
                          <a16:creationId xmlns:a16="http://schemas.microsoft.com/office/drawing/2014/main" id="{423395D3-630B-F9C7-B821-5D90FAB9EBB5}"/>
                        </a:ext>
                      </a:extLst>
                    </p:cNvPr>
                    <p:cNvPicPr>
                      <a:picLocks/>
                    </p:cNvPicPr>
                    <p:nvPr/>
                  </p:nvPicPr>
                  <p:blipFill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8929938" y="1746319"/>
                      <a:ext cx="2340000" cy="540000"/>
                    </a:xfrm>
                    <a:prstGeom prst="rect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</p:pic>
              </p:grpSp>
              <p:sp>
                <p:nvSpPr>
                  <p:cNvPr id="73" name="Szövegdoboz 72">
                    <a:extLst>
                      <a:ext uri="{FF2B5EF4-FFF2-40B4-BE49-F238E27FC236}">
                        <a16:creationId xmlns:a16="http://schemas.microsoft.com/office/drawing/2014/main" id="{8C45F1EF-436E-B74A-BAF6-0C9C20D9DD4E}"/>
                      </a:ext>
                    </a:extLst>
                  </p:cNvPr>
                  <p:cNvSpPr txBox="1"/>
                  <p:nvPr/>
                </p:nvSpPr>
                <p:spPr>
                  <a:xfrm>
                    <a:off x="8621039" y="2105143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35</a:t>
                    </a:r>
                  </a:p>
                </p:txBody>
              </p:sp>
            </p:grpSp>
          </p:grpSp>
          <p:pic>
            <p:nvPicPr>
              <p:cNvPr id="83" name="Kép 82" descr="A képen fekete, fekete-fehér, fehér, Monokróm fényképezés látható&#10;&#10;Automatikusan generált leírás">
                <a:extLst>
                  <a:ext uri="{FF2B5EF4-FFF2-40B4-BE49-F238E27FC236}">
                    <a16:creationId xmlns:a16="http://schemas.microsoft.com/office/drawing/2014/main" id="{95262A08-1190-B26E-FC34-42E6E88FD8F9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72091" y="880267"/>
                <a:ext cx="2340000" cy="5400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  <p:pic>
          <p:nvPicPr>
            <p:cNvPr id="88" name="Kép 87" descr="A képen fekete, fehér, fekete-fehér, monokróm látható&#10;&#10;Automatikusan generált leírás">
              <a:extLst>
                <a:ext uri="{FF2B5EF4-FFF2-40B4-BE49-F238E27FC236}">
                  <a16:creationId xmlns:a16="http://schemas.microsoft.com/office/drawing/2014/main" id="{5ED74F29-1716-E0AA-DCC3-62517E9F4DB0}"/>
                </a:ext>
              </a:extLst>
            </p:cNvPr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72091" y="1746319"/>
              <a:ext cx="2340000" cy="54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</p:grpSp>
      <p:grpSp>
        <p:nvGrpSpPr>
          <p:cNvPr id="117" name="Csoportba foglalás 116">
            <a:extLst>
              <a:ext uri="{FF2B5EF4-FFF2-40B4-BE49-F238E27FC236}">
                <a16:creationId xmlns:a16="http://schemas.microsoft.com/office/drawing/2014/main" id="{01531A67-C061-4B33-752E-A2D8AB0A33F9}"/>
              </a:ext>
            </a:extLst>
          </p:cNvPr>
          <p:cNvGrpSpPr/>
          <p:nvPr/>
        </p:nvGrpSpPr>
        <p:grpSpPr>
          <a:xfrm>
            <a:off x="68367" y="2517741"/>
            <a:ext cx="11964550" cy="2059144"/>
            <a:chOff x="68367" y="2517741"/>
            <a:chExt cx="11964550" cy="2059144"/>
          </a:xfrm>
        </p:grpSpPr>
        <p:grpSp>
          <p:nvGrpSpPr>
            <p:cNvPr id="114" name="Csoportba foglalás 113">
              <a:extLst>
                <a:ext uri="{FF2B5EF4-FFF2-40B4-BE49-F238E27FC236}">
                  <a16:creationId xmlns:a16="http://schemas.microsoft.com/office/drawing/2014/main" id="{0265D2BA-C624-F47D-46BF-1D13DC465C40}"/>
                </a:ext>
              </a:extLst>
            </p:cNvPr>
            <p:cNvGrpSpPr/>
            <p:nvPr/>
          </p:nvGrpSpPr>
          <p:grpSpPr>
            <a:xfrm>
              <a:off x="68367" y="2517741"/>
              <a:ext cx="11964550" cy="2059144"/>
              <a:chOff x="68367" y="2517741"/>
              <a:chExt cx="11964550" cy="2059144"/>
            </a:xfrm>
          </p:grpSpPr>
          <p:grpSp>
            <p:nvGrpSpPr>
              <p:cNvPr id="112" name="Csoportba foglalás 111">
                <a:extLst>
                  <a:ext uri="{FF2B5EF4-FFF2-40B4-BE49-F238E27FC236}">
                    <a16:creationId xmlns:a16="http://schemas.microsoft.com/office/drawing/2014/main" id="{AACB662C-BCA8-FA7B-6820-594B0EC5802F}"/>
                  </a:ext>
                </a:extLst>
              </p:cNvPr>
              <p:cNvGrpSpPr/>
              <p:nvPr/>
            </p:nvGrpSpPr>
            <p:grpSpPr>
              <a:xfrm>
                <a:off x="68367" y="2517741"/>
                <a:ext cx="11964550" cy="2059144"/>
                <a:chOff x="68367" y="2517741"/>
                <a:chExt cx="11964550" cy="2059144"/>
              </a:xfrm>
            </p:grpSpPr>
            <p:grpSp>
              <p:nvGrpSpPr>
                <p:cNvPr id="108" name="Csoportba foglalás 107">
                  <a:extLst>
                    <a:ext uri="{FF2B5EF4-FFF2-40B4-BE49-F238E27FC236}">
                      <a16:creationId xmlns:a16="http://schemas.microsoft.com/office/drawing/2014/main" id="{6A8C7C6C-F128-DC65-C969-E20497E54A17}"/>
                    </a:ext>
                  </a:extLst>
                </p:cNvPr>
                <p:cNvGrpSpPr/>
                <p:nvPr/>
              </p:nvGrpSpPr>
              <p:grpSpPr>
                <a:xfrm>
                  <a:off x="68367" y="2517741"/>
                  <a:ext cx="11964550" cy="2059144"/>
                  <a:chOff x="68367" y="2517741"/>
                  <a:chExt cx="11964550" cy="2059144"/>
                </a:xfrm>
              </p:grpSpPr>
              <p:grpSp>
                <p:nvGrpSpPr>
                  <p:cNvPr id="104" name="Csoportba foglalás 103">
                    <a:extLst>
                      <a:ext uri="{FF2B5EF4-FFF2-40B4-BE49-F238E27FC236}">
                        <a16:creationId xmlns:a16="http://schemas.microsoft.com/office/drawing/2014/main" id="{3C5410F5-950F-C152-7F81-AAB7960A5AA9}"/>
                      </a:ext>
                    </a:extLst>
                  </p:cNvPr>
                  <p:cNvGrpSpPr/>
                  <p:nvPr/>
                </p:nvGrpSpPr>
                <p:grpSpPr>
                  <a:xfrm>
                    <a:off x="68367" y="2517741"/>
                    <a:ext cx="11964550" cy="2059144"/>
                    <a:chOff x="68367" y="2517741"/>
                    <a:chExt cx="11964550" cy="2059144"/>
                  </a:xfrm>
                </p:grpSpPr>
                <p:grpSp>
                  <p:nvGrpSpPr>
                    <p:cNvPr id="101" name="Csoportba foglalás 100">
                      <a:extLst>
                        <a:ext uri="{FF2B5EF4-FFF2-40B4-BE49-F238E27FC236}">
                          <a16:creationId xmlns:a16="http://schemas.microsoft.com/office/drawing/2014/main" id="{9E32BED4-F057-625B-236D-49CD8E19D75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7" y="2517741"/>
                      <a:ext cx="11964550" cy="2059144"/>
                      <a:chOff x="68367" y="2517741"/>
                      <a:chExt cx="11964550" cy="2059144"/>
                    </a:xfrm>
                  </p:grpSpPr>
                  <p:grpSp>
                    <p:nvGrpSpPr>
                      <p:cNvPr id="98" name="Csoportba foglalás 97">
                        <a:extLst>
                          <a:ext uri="{FF2B5EF4-FFF2-40B4-BE49-F238E27FC236}">
                            <a16:creationId xmlns:a16="http://schemas.microsoft.com/office/drawing/2014/main" id="{7CA4322E-35DA-0E1D-C3D4-34FDB5E25D9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7" y="2517741"/>
                        <a:ext cx="11964550" cy="2059144"/>
                        <a:chOff x="68367" y="2517741"/>
                        <a:chExt cx="11964550" cy="2059144"/>
                      </a:xfrm>
                    </p:grpSpPr>
                    <p:grpSp>
                      <p:nvGrpSpPr>
                        <p:cNvPr id="93" name="Csoportba foglalás 92">
                          <a:extLst>
                            <a:ext uri="{FF2B5EF4-FFF2-40B4-BE49-F238E27FC236}">
                              <a16:creationId xmlns:a16="http://schemas.microsoft.com/office/drawing/2014/main" id="{B4BF2BDF-2EB7-A1C8-D2D7-9755198A847C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7" y="2517741"/>
                          <a:ext cx="11964550" cy="2059144"/>
                          <a:chOff x="68367" y="2517741"/>
                          <a:chExt cx="11964550" cy="2059144"/>
                        </a:xfrm>
                      </p:grpSpPr>
                      <p:grpSp>
                        <p:nvGrpSpPr>
                          <p:cNvPr id="3" name="Csoportba foglalás 2">
                            <a:extLst>
                              <a:ext uri="{FF2B5EF4-FFF2-40B4-BE49-F238E27FC236}">
                                <a16:creationId xmlns:a16="http://schemas.microsoft.com/office/drawing/2014/main" id="{29AD2744-BA9D-EBEE-87A9-E0CC31EFBC68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7" y="2517741"/>
                            <a:ext cx="11964550" cy="2059144"/>
                            <a:chOff x="68367" y="378270"/>
                            <a:chExt cx="11964550" cy="2059144"/>
                          </a:xfrm>
                        </p:grpSpPr>
                        <p:grpSp>
                          <p:nvGrpSpPr>
                            <p:cNvPr id="15" name="Csoportba foglalás 14">
                              <a:extLst>
                                <a:ext uri="{FF2B5EF4-FFF2-40B4-BE49-F238E27FC236}">
                                  <a16:creationId xmlns:a16="http://schemas.microsoft.com/office/drawing/2014/main" id="{4CD5BDF3-1E96-50C1-D1F8-09CAA96DED45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7" y="378270"/>
                              <a:ext cx="11964550" cy="2059144"/>
                              <a:chOff x="68367" y="378270"/>
                              <a:chExt cx="11964550" cy="2059144"/>
                            </a:xfrm>
                          </p:grpSpPr>
                          <p:grpSp>
                            <p:nvGrpSpPr>
                              <p:cNvPr id="23" name="Csoportba foglalás 22">
                                <a:extLst>
                                  <a:ext uri="{FF2B5EF4-FFF2-40B4-BE49-F238E27FC236}">
                                    <a16:creationId xmlns:a16="http://schemas.microsoft.com/office/drawing/2014/main" id="{48AFB3D1-AFAF-FE71-A078-1C54CA3D2679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7" y="378270"/>
                                <a:ext cx="11964550" cy="2059144"/>
                                <a:chOff x="68367" y="378270"/>
                                <a:chExt cx="11964550" cy="2059144"/>
                              </a:xfrm>
                            </p:grpSpPr>
                            <p:grpSp>
                              <p:nvGrpSpPr>
                                <p:cNvPr id="31" name="Csoportba foglalás 30">
                                  <a:extLst>
                                    <a:ext uri="{FF2B5EF4-FFF2-40B4-BE49-F238E27FC236}">
                                      <a16:creationId xmlns:a16="http://schemas.microsoft.com/office/drawing/2014/main" id="{B8B8AE69-43B6-8B13-7F94-BFA740A3F063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8367" y="378270"/>
                                  <a:ext cx="11964550" cy="2059144"/>
                                  <a:chOff x="68367" y="378270"/>
                                  <a:chExt cx="11964550" cy="2059144"/>
                                </a:xfrm>
                              </p:grpSpPr>
                              <p:grpSp>
                                <p:nvGrpSpPr>
                                  <p:cNvPr id="39" name="Csoportba foglalás 38">
                                    <a:extLst>
                                      <a:ext uri="{FF2B5EF4-FFF2-40B4-BE49-F238E27FC236}">
                                        <a16:creationId xmlns:a16="http://schemas.microsoft.com/office/drawing/2014/main" id="{B426255A-D7C9-9379-61BB-C1D719A3D6C3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8367" y="378270"/>
                                    <a:ext cx="11964550" cy="2059144"/>
                                    <a:chOff x="68367" y="378270"/>
                                    <a:chExt cx="11964550" cy="2059144"/>
                                  </a:xfrm>
                                </p:grpSpPr>
                                <p:grpSp>
                                  <p:nvGrpSpPr>
                                    <p:cNvPr id="115" name="Csoportba foglalás 114">
                                      <a:extLst>
                                        <a:ext uri="{FF2B5EF4-FFF2-40B4-BE49-F238E27FC236}">
                                          <a16:creationId xmlns:a16="http://schemas.microsoft.com/office/drawing/2014/main" id="{ED6C8540-0F0B-76EE-1329-F88D9A0C0C9D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8367" y="378270"/>
                                      <a:ext cx="11964550" cy="2059144"/>
                                      <a:chOff x="68367" y="378270"/>
                                      <a:chExt cx="11964550" cy="2059144"/>
                                    </a:xfrm>
                                  </p:grpSpPr>
                                  <p:grpSp>
                                    <p:nvGrpSpPr>
                                      <p:cNvPr id="130" name="Csoportba foglalás 129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A509F151-A84F-9423-5DF1-59B58F8AE480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8367" y="378270"/>
                                        <a:ext cx="11964550" cy="2059144"/>
                                        <a:chOff x="68367" y="378270"/>
                                        <a:chExt cx="11964550" cy="2059144"/>
                                      </a:xfrm>
                                    </p:grpSpPr>
                                    <p:sp>
                                      <p:nvSpPr>
                                        <p:cNvPr id="133" name="Szövegdoboz 132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7FE0271E-D3CB-1C63-5D4F-3CC4B7A21D1C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5457394" y="1528132"/>
                                          <a:ext cx="47000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DMSO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134" name="Szövegdoboz 133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8F76D84F-8BE4-1BDE-14F1-09E6E49443BB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5791141" y="1525040"/>
                                          <a:ext cx="457176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UDCA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135" name="Szövegdoboz 134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CEAEA855-17FC-469A-FB82-07D7014C67DB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2085876" y="1497190"/>
                                          <a:ext cx="47000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DMSO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136" name="Szövegdoboz 135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E12913C1-395B-367D-94F1-8264BC926283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3107779" y="1503525"/>
                                          <a:ext cx="457176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UDCA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137" name="Szövegdoboz 136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392CEEB2-A6B3-4649-4170-7A90B9F2CA7F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9606694" y="1510630"/>
                                          <a:ext cx="47000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DMSO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139" name="Szövegdoboz 138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81E4901D-40D8-867B-3BA3-191A7204492F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10024410" y="1514943"/>
                                          <a:ext cx="457176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UDCA</a:t>
                                          </a:r>
                                        </a:p>
                                      </p:txBody>
                                    </p:sp>
                                    <p:grpSp>
                                      <p:nvGrpSpPr>
                                        <p:cNvPr id="140" name="Csoportba foglalás 139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35DC03D4-D429-718A-ADFA-50F44C9CCC46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8367" y="378270"/>
                                          <a:ext cx="11964550" cy="2059144"/>
                                          <a:chOff x="68367" y="378270"/>
                                          <a:chExt cx="11964550" cy="2059144"/>
                                        </a:xfrm>
                                      </p:grpSpPr>
                                      <p:grpSp>
                                        <p:nvGrpSpPr>
                                          <p:cNvPr id="143" name="Csoportba foglalás 142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E3A05487-DF0E-F5F2-CA77-6152AD03521F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68367" y="378270"/>
                                            <a:ext cx="11964550" cy="2059144"/>
                                            <a:chOff x="68367" y="378270"/>
                                            <a:chExt cx="11964550" cy="2059144"/>
                                          </a:xfrm>
                                        </p:grpSpPr>
                                        <p:sp>
                                          <p:nvSpPr>
                                            <p:cNvPr id="147" name="Szövegdoboz 146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EFFF1FB2-9399-D9BB-FFDD-A85F3460B6E4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5333274" y="631011"/>
                                              <a:ext cx="47000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DMSO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49" name="Szövegdoboz 148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AE8CDBE1-23CC-11FE-E5EC-8D6A4BABCB73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5723580" y="637346"/>
                                              <a:ext cx="457176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UDCA</a:t>
                                              </a:r>
                                            </a:p>
                                          </p:txBody>
                                        </p:sp>
                                        <p:grpSp>
                                          <p:nvGrpSpPr>
                                            <p:cNvPr id="186" name="Csoportba foglalás 185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285BE8DF-32E8-22A3-20F7-CF02D2079DC6}"/>
                                                </a:ext>
                                              </a:extLst>
                                            </p:cNvPr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68367" y="378270"/>
                                              <a:ext cx="11964550" cy="2059144"/>
                                              <a:chOff x="68367" y="415477"/>
                                              <a:chExt cx="11964550" cy="2059144"/>
                                            </a:xfrm>
                                          </p:grpSpPr>
                                          <p:sp>
                                            <p:nvSpPr>
                                              <p:cNvPr id="189" name="Szövegdoboz 188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EA75328F-B48D-F03F-2FDA-CBC7A9E58CCF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68367" y="1048238"/>
                                                <a:ext cx="999857" cy="307777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squar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1400" dirty="0"/>
                                                  <a:t>NRF-2: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192" name="Szövegdoboz 191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5E76A2CE-7AC3-01BE-3D67-B90DF5823806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68367" y="1815547"/>
                                                <a:ext cx="803304" cy="307777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squar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1400" dirty="0"/>
                                                  <a:t>β-</a:t>
                                                </a:r>
                                                <a:r>
                                                  <a:rPr lang="hu-HU" sz="1400" dirty="0" err="1"/>
                                                  <a:t>actin</a:t>
                                                </a:r>
                                                <a:r>
                                                  <a:rPr lang="hu-HU" sz="1400" dirty="0"/>
                                                  <a:t>:</a:t>
                                                </a:r>
                                              </a:p>
                                            </p:txBody>
                                          </p:sp>
                                          <p:grpSp>
                                            <p:nvGrpSpPr>
                                              <p:cNvPr id="195" name="Csoportba foglalás 194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B7351B9A-5D5E-0455-5CCF-B3EDB1CD1C3C}"/>
                                                  </a:ext>
                                                </a:extLst>
                                              </p:cNvPr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2027746" y="415641"/>
                                                <a:ext cx="1507358" cy="484214"/>
                                                <a:chOff x="2027746" y="415641"/>
                                                <a:chExt cx="1507358" cy="484214"/>
                                              </a:xfrm>
                                            </p:grpSpPr>
                                            <p:grpSp>
                                              <p:nvGrpSpPr>
                                                <p:cNvPr id="205" name="Csoportba foglalás 204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613031AC-857D-AC4B-8136-6C051C9F3484}"/>
                                                    </a:ext>
                                                  </a:extLst>
                                                </p:cNvPr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2027746" y="681319"/>
                                                  <a:ext cx="1507358" cy="218536"/>
                                                  <a:chOff x="2027746" y="305309"/>
                                                  <a:chExt cx="1507358" cy="218536"/>
                                                </a:xfrm>
                                              </p:grpSpPr>
                                              <p:sp>
                                                <p:nvSpPr>
                                                  <p:cNvPr id="207" name="Szövegdoboz 206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DC785693-AAC4-97FB-553B-E083977F6204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2027746" y="308401"/>
                                                    <a:ext cx="470000" cy="215444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800" dirty="0"/>
                                                      <a:t>DMSO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  <p:sp>
                                                <p:nvSpPr>
                                                  <p:cNvPr id="208" name="Szövegdoboz 207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B16D0573-0BF7-CAD3-AA9F-EDCC9EDB04A4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3077928" y="305309"/>
                                                    <a:ext cx="457176" cy="215444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800" dirty="0"/>
                                                      <a:t>UDCA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</p:grpSp>
                                            <p:sp>
                                              <p:nvSpPr>
                                                <p:cNvPr id="206" name="Szövegdoboz 205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2DE4BE31-441A-0328-59CA-A36DCD064A70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2797923" y="415641"/>
                                                  <a:ext cx="332142" cy="307777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1400" b="1" dirty="0"/>
                                                    <a:t>1.</a:t>
                                                  </a:r>
                                                </a:p>
                                              </p:txBody>
                                            </p:sp>
                                          </p:grpSp>
                                          <p:sp>
                                            <p:nvSpPr>
                                              <p:cNvPr id="198" name="Szövegdoboz 197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02759803-CC98-45F3-C3AF-05AA128F230E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6271647" y="416294"/>
                                                <a:ext cx="335348" cy="307777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1400" b="1" dirty="0"/>
                                                  <a:t>2.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201" name="Szövegdoboz 200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678E5271-9918-AC90-2357-67BFA5024666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10016820" y="415477"/>
                                                <a:ext cx="335348" cy="307777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1400" b="1" dirty="0"/>
                                                  <a:t>3.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204" name="Téglalap 203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4C3F2B9E-A1F5-7A7A-9176-71FEBFDFC3EA}"/>
                                                  </a:ext>
                                                </a:extLst>
                                              </p:cNvPr>
                                              <p:cNvSpPr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70822" y="474905"/>
                                                <a:ext cx="11962095" cy="1999716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15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/>
                                              <a:p>
                                                <a:pPr algn="ctr"/>
                                                <a:endParaRPr lang="hu-HU"/>
                                              </a:p>
                                            </p:txBody>
                                          </p:sp>
                                        </p:grpSp>
                                      </p:grpSp>
                                      <p:sp>
                                        <p:nvSpPr>
                                          <p:cNvPr id="144" name="Szövegdoboz 143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B353D6E0-33E5-4052-E997-B758DF0FB1C7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9727677" y="632363"/>
                                            <a:ext cx="47000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DMSO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46" name="Szövegdoboz 145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C66FFE90-BC18-3A9A-55AF-7D8583D71C87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10267945" y="636676"/>
                                            <a:ext cx="457176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UDCA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</p:grpSp>
                                  <p:sp>
                                    <p:nvSpPr>
                                      <p:cNvPr id="124" name="Szövegdoboz 123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D2D11BC2-8FE7-CD2C-C2B0-A9B8AF23FB61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489670" y="856089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70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110" name="Szövegdoboz 109">
                                      <a:extLst>
                                        <a:ext uri="{FF2B5EF4-FFF2-40B4-BE49-F238E27FC236}">
                                          <a16:creationId xmlns:a16="http://schemas.microsoft.com/office/drawing/2014/main" id="{DE19081A-DD7E-9FA7-EDC8-57A916A3B82D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491238" y="1668369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55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41" name="Szövegdoboz 40">
                                    <a:extLst>
                                      <a:ext uri="{FF2B5EF4-FFF2-40B4-BE49-F238E27FC236}">
                                        <a16:creationId xmlns:a16="http://schemas.microsoft.com/office/drawing/2014/main" id="{024511CC-02FD-694C-EAD4-C014E3168F7C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4968994" y="1180438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55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44" name="Szövegdoboz 43">
                                    <a:extLst>
                                      <a:ext uri="{FF2B5EF4-FFF2-40B4-BE49-F238E27FC236}">
                                        <a16:creationId xmlns:a16="http://schemas.microsoft.com/office/drawing/2014/main" id="{B5C40E28-1589-8796-A844-55E9F5DAC0D2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4970562" y="804935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70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35" name="Szövegdoboz 34">
                                  <a:extLst>
                                    <a:ext uri="{FF2B5EF4-FFF2-40B4-BE49-F238E27FC236}">
                                      <a16:creationId xmlns:a16="http://schemas.microsoft.com/office/drawing/2014/main" id="{0D156093-C65F-6627-1C5D-86D78BFF401B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970562" y="2086986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35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36" name="Szövegdoboz 35">
                                  <a:extLst>
                                    <a:ext uri="{FF2B5EF4-FFF2-40B4-BE49-F238E27FC236}">
                                      <a16:creationId xmlns:a16="http://schemas.microsoft.com/office/drawing/2014/main" id="{AB41236A-3040-EA7A-6E8E-16E7A6061A29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962703" y="1683202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55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26" name="Szövegdoboz 25">
                                <a:extLst>
                                  <a:ext uri="{FF2B5EF4-FFF2-40B4-BE49-F238E27FC236}">
                                    <a16:creationId xmlns:a16="http://schemas.microsoft.com/office/drawing/2014/main" id="{A008058A-D773-4A7D-0941-BE81F252B167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8628166" y="1672200"/>
                                <a:ext cx="29367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55</a:t>
                                </a:r>
                              </a:p>
                            </p:txBody>
                          </p:sp>
                          <p:sp>
                            <p:nvSpPr>
                              <p:cNvPr id="30" name="Szövegdoboz 29">
                                <a:extLst>
                                  <a:ext uri="{FF2B5EF4-FFF2-40B4-BE49-F238E27FC236}">
                                    <a16:creationId xmlns:a16="http://schemas.microsoft.com/office/drawing/2014/main" id="{1F2B1F8E-AAB0-46F7-F656-1B485C600C2E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8620307" y="1211863"/>
                                <a:ext cx="29367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55</a:t>
                                </a:r>
                              </a:p>
                            </p:txBody>
                          </p:sp>
                        </p:grpSp>
                        <p:sp>
                          <p:nvSpPr>
                            <p:cNvPr id="16" name="Szövegdoboz 15">
                              <a:extLst>
                                <a:ext uri="{FF2B5EF4-FFF2-40B4-BE49-F238E27FC236}">
                                  <a16:creationId xmlns:a16="http://schemas.microsoft.com/office/drawing/2014/main" id="{2A9B8FFF-1BBA-A59E-31B5-51D0C5AB3B7F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8620307" y="815930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70</a:t>
                              </a:r>
                            </a:p>
                          </p:txBody>
                        </p:sp>
                      </p:grpSp>
                      <p:pic>
                        <p:nvPicPr>
                          <p:cNvPr id="91" name="Kép 90" descr="A képen röntgenfilm, fekete, fehér, fekete-fehér látható&#10;&#10;Automatikusan generált leírás">
                            <a:extLst>
                              <a:ext uri="{FF2B5EF4-FFF2-40B4-BE49-F238E27FC236}">
                                <a16:creationId xmlns:a16="http://schemas.microsoft.com/office/drawing/2014/main" id="{3F250194-EAC6-DC54-98A6-D5CE07801780}"/>
                              </a:ext>
                            </a:extLst>
                          </p:cNvPr>
                          <p:cNvPicPr>
                            <a:picLocks/>
                          </p:cNvPicPr>
                          <p:nvPr/>
                        </p:nvPicPr>
                        <p:blipFill>
                          <a:blip r:embed="rId8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1792767" y="3006151"/>
                            <a:ext cx="2340000" cy="540000"/>
                          </a:xfrm>
                          <a:prstGeom prst="rect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</p:pic>
                      <p:sp>
                        <p:nvSpPr>
                          <p:cNvPr id="92" name="Szövegdoboz 91">
                            <a:extLst>
                              <a:ext uri="{FF2B5EF4-FFF2-40B4-BE49-F238E27FC236}">
                                <a16:creationId xmlns:a16="http://schemas.microsoft.com/office/drawing/2014/main" id="{F348676C-8760-0DCF-9E86-23026630F7B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491238" y="3374202"/>
                            <a:ext cx="29367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55</a:t>
                            </a:r>
                          </a:p>
                        </p:txBody>
                      </p:sp>
                    </p:grpSp>
                    <p:pic>
                      <p:nvPicPr>
                        <p:cNvPr id="97" name="Kép 96" descr="A képen fekete-fehér, fekete, fehér, monokróm látható&#10;&#10;Automatikusan generált leírás">
                          <a:extLst>
                            <a:ext uri="{FF2B5EF4-FFF2-40B4-BE49-F238E27FC236}">
                              <a16:creationId xmlns:a16="http://schemas.microsoft.com/office/drawing/2014/main" id="{2E6A6533-A580-EC1D-1934-530553E8C0FB}"/>
                            </a:ext>
                          </a:extLst>
                        </p:cNvPr>
                        <p:cNvPicPr>
                          <a:picLocks/>
                        </p:cNvPicPr>
                        <p:nvPr/>
                      </p:nvPicPr>
                      <p:blipFill>
                        <a:blip r:embed="rId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92695" y="3863490"/>
                          <a:ext cx="2340000" cy="540000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</p:pic>
                  </p:grpSp>
                  <p:pic>
                    <p:nvPicPr>
                      <p:cNvPr id="100" name="Kép 99" descr="A képen fekete, fekete-fehér, fehér, monokróm látható&#10;&#10;Automatikusan generált leírás">
                        <a:extLst>
                          <a:ext uri="{FF2B5EF4-FFF2-40B4-BE49-F238E27FC236}">
                            <a16:creationId xmlns:a16="http://schemas.microsoft.com/office/drawing/2014/main" id="{4D921D4F-0D7A-C609-3B81-E3E512864ADB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272091" y="3001688"/>
                        <a:ext cx="2340000" cy="540000"/>
                      </a:xfrm>
                      <a:prstGeom prst="rect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</p:pic>
                </p:grpSp>
                <p:pic>
                  <p:nvPicPr>
                    <p:cNvPr id="103" name="Kép 102" descr="A képen fehér, klarinét, fekete-fehér, síp látható&#10;&#10;Automatikusan generált leírás">
                      <a:extLst>
                        <a:ext uri="{FF2B5EF4-FFF2-40B4-BE49-F238E27FC236}">
                          <a16:creationId xmlns:a16="http://schemas.microsoft.com/office/drawing/2014/main" id="{7AE7EFBB-7B68-D74D-3DBB-EC81E15CA889}"/>
                        </a:ext>
                      </a:extLst>
                    </p:cNvPr>
                    <p:cNvPicPr>
                      <a:picLocks/>
                    </p:cNvPicPr>
                    <p:nvPr/>
                  </p:nvPicPr>
                  <p:blipFill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271251" y="3863490"/>
                      <a:ext cx="2340000" cy="540000"/>
                    </a:xfrm>
                    <a:prstGeom prst="rect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</p:pic>
              </p:grpSp>
              <p:pic>
                <p:nvPicPr>
                  <p:cNvPr id="107" name="Kép 106" descr="A képen fekete-fehér, fekete, fehér, homályos látható&#10;&#10;Automatikusan generált leírás">
                    <a:extLst>
                      <a:ext uri="{FF2B5EF4-FFF2-40B4-BE49-F238E27FC236}">
                        <a16:creationId xmlns:a16="http://schemas.microsoft.com/office/drawing/2014/main" id="{0619FD57-80A0-A347-711B-0C2BAD4096E7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1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29938" y="2995353"/>
                    <a:ext cx="2340000" cy="540000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</p:grpSp>
            <p:pic>
              <p:nvPicPr>
                <p:cNvPr id="111" name="Kép 110" descr="A képen fekete, fekete-fehér, fehér, röntgenfilm látható&#10;&#10;Automatikusan generált leírás">
                  <a:extLst>
                    <a:ext uri="{FF2B5EF4-FFF2-40B4-BE49-F238E27FC236}">
                      <a16:creationId xmlns:a16="http://schemas.microsoft.com/office/drawing/2014/main" id="{97BE7D61-D8F8-84BB-0A6F-8A88A8B56FC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28370" y="3863791"/>
                  <a:ext cx="2340000" cy="54000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</p:grpSp>
          <p:sp>
            <p:nvSpPr>
              <p:cNvPr id="113" name="Szövegdoboz 112">
                <a:extLst>
                  <a:ext uri="{FF2B5EF4-FFF2-40B4-BE49-F238E27FC236}">
                    <a16:creationId xmlns:a16="http://schemas.microsoft.com/office/drawing/2014/main" id="{C74EC081-888C-897C-B697-3DAA235729A7}"/>
                  </a:ext>
                </a:extLst>
              </p:cNvPr>
              <p:cNvSpPr txBox="1"/>
              <p:nvPr/>
            </p:nvSpPr>
            <p:spPr>
              <a:xfrm>
                <a:off x="8620307" y="4218595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35</a:t>
                </a:r>
              </a:p>
            </p:txBody>
          </p:sp>
        </p:grpSp>
        <p:sp>
          <p:nvSpPr>
            <p:cNvPr id="116" name="Szövegdoboz 115">
              <a:extLst>
                <a:ext uri="{FF2B5EF4-FFF2-40B4-BE49-F238E27FC236}">
                  <a16:creationId xmlns:a16="http://schemas.microsoft.com/office/drawing/2014/main" id="{EC6D5E30-E87A-9040-D9F3-E22B3CA4057C}"/>
                </a:ext>
              </a:extLst>
            </p:cNvPr>
            <p:cNvSpPr txBox="1"/>
            <p:nvPr/>
          </p:nvSpPr>
          <p:spPr>
            <a:xfrm>
              <a:off x="1484221" y="4246875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3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831646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4E61EA46-CF03-FBB6-50D2-3D75129E7EDA}"/>
              </a:ext>
            </a:extLst>
          </p:cNvPr>
          <p:cNvSpPr txBox="1"/>
          <p:nvPr/>
        </p:nvSpPr>
        <p:spPr>
          <a:xfrm>
            <a:off x="68367" y="68366"/>
            <a:ext cx="2250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/>
              <a:t>4HNE:</a:t>
            </a:r>
          </a:p>
        </p:txBody>
      </p:sp>
      <p:grpSp>
        <p:nvGrpSpPr>
          <p:cNvPr id="72" name="Csoportba foglalás 71">
            <a:extLst>
              <a:ext uri="{FF2B5EF4-FFF2-40B4-BE49-F238E27FC236}">
                <a16:creationId xmlns:a16="http://schemas.microsoft.com/office/drawing/2014/main" id="{9190BF1A-3D56-DC3A-EE1E-33FBAD0DE615}"/>
              </a:ext>
            </a:extLst>
          </p:cNvPr>
          <p:cNvGrpSpPr/>
          <p:nvPr/>
        </p:nvGrpSpPr>
        <p:grpSpPr>
          <a:xfrm>
            <a:off x="68367" y="378270"/>
            <a:ext cx="11964550" cy="3851654"/>
            <a:chOff x="68367" y="378270"/>
            <a:chExt cx="11964550" cy="3851654"/>
          </a:xfrm>
        </p:grpSpPr>
        <p:grpSp>
          <p:nvGrpSpPr>
            <p:cNvPr id="66" name="Csoportba foglalás 65">
              <a:extLst>
                <a:ext uri="{FF2B5EF4-FFF2-40B4-BE49-F238E27FC236}">
                  <a16:creationId xmlns:a16="http://schemas.microsoft.com/office/drawing/2014/main" id="{2AAF2096-4A08-B39C-BD9A-FD3159E62FE7}"/>
                </a:ext>
              </a:extLst>
            </p:cNvPr>
            <p:cNvGrpSpPr/>
            <p:nvPr/>
          </p:nvGrpSpPr>
          <p:grpSpPr>
            <a:xfrm>
              <a:off x="68367" y="378270"/>
              <a:ext cx="11964550" cy="3851654"/>
              <a:chOff x="68367" y="378270"/>
              <a:chExt cx="11964550" cy="3851654"/>
            </a:xfrm>
          </p:grpSpPr>
          <p:grpSp>
            <p:nvGrpSpPr>
              <p:cNvPr id="29" name="Csoportba foglalás 28">
                <a:extLst>
                  <a:ext uri="{FF2B5EF4-FFF2-40B4-BE49-F238E27FC236}">
                    <a16:creationId xmlns:a16="http://schemas.microsoft.com/office/drawing/2014/main" id="{9D07D83D-FF83-B8D2-1532-FD39A54671A7}"/>
                  </a:ext>
                </a:extLst>
              </p:cNvPr>
              <p:cNvGrpSpPr/>
              <p:nvPr/>
            </p:nvGrpSpPr>
            <p:grpSpPr>
              <a:xfrm>
                <a:off x="68367" y="378270"/>
                <a:ext cx="11964550" cy="3851654"/>
                <a:chOff x="68367" y="378270"/>
                <a:chExt cx="11964550" cy="3851654"/>
              </a:xfrm>
            </p:grpSpPr>
            <p:grpSp>
              <p:nvGrpSpPr>
                <p:cNvPr id="44" name="Csoportba foglalás 43">
                  <a:extLst>
                    <a:ext uri="{FF2B5EF4-FFF2-40B4-BE49-F238E27FC236}">
                      <a16:creationId xmlns:a16="http://schemas.microsoft.com/office/drawing/2014/main" id="{9964DE4C-EACB-442C-87D1-D7377A23C221}"/>
                    </a:ext>
                  </a:extLst>
                </p:cNvPr>
                <p:cNvGrpSpPr/>
                <p:nvPr/>
              </p:nvGrpSpPr>
              <p:grpSpPr>
                <a:xfrm>
                  <a:off x="68367" y="378270"/>
                  <a:ext cx="11964550" cy="3851654"/>
                  <a:chOff x="68367" y="378270"/>
                  <a:chExt cx="11964550" cy="3851654"/>
                </a:xfrm>
              </p:grpSpPr>
              <p:pic>
                <p:nvPicPr>
                  <p:cNvPr id="39" name="Kép 38" descr="A képen homályos, fekete, fekete-fehér, monokróm látható&#10;&#10;Automatikusan generált leírás">
                    <a:extLst>
                      <a:ext uri="{FF2B5EF4-FFF2-40B4-BE49-F238E27FC236}">
                        <a16:creationId xmlns:a16="http://schemas.microsoft.com/office/drawing/2014/main" id="{1ACA8565-000C-E06D-E009-34DD268851EB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364055" y="3514058"/>
                    <a:ext cx="1620000" cy="540000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  <p:grpSp>
                <p:nvGrpSpPr>
                  <p:cNvPr id="43" name="Csoportba foglalás 42">
                    <a:extLst>
                      <a:ext uri="{FF2B5EF4-FFF2-40B4-BE49-F238E27FC236}">
                        <a16:creationId xmlns:a16="http://schemas.microsoft.com/office/drawing/2014/main" id="{EAAEA6FD-8F77-73D9-F9E5-0E47E76DC3C8}"/>
                      </a:ext>
                    </a:extLst>
                  </p:cNvPr>
                  <p:cNvGrpSpPr/>
                  <p:nvPr/>
                </p:nvGrpSpPr>
                <p:grpSpPr>
                  <a:xfrm>
                    <a:off x="68367" y="378270"/>
                    <a:ext cx="11964550" cy="3851654"/>
                    <a:chOff x="68367" y="378270"/>
                    <a:chExt cx="11964550" cy="3851654"/>
                  </a:xfrm>
                </p:grpSpPr>
                <p:grpSp>
                  <p:nvGrpSpPr>
                    <p:cNvPr id="41" name="Csoportba foglalás 40">
                      <a:extLst>
                        <a:ext uri="{FF2B5EF4-FFF2-40B4-BE49-F238E27FC236}">
                          <a16:creationId xmlns:a16="http://schemas.microsoft.com/office/drawing/2014/main" id="{9362B450-5A4E-9181-C08C-22CE9B4B347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7" y="378270"/>
                      <a:ext cx="11964550" cy="3851654"/>
                      <a:chOff x="68367" y="378270"/>
                      <a:chExt cx="11964550" cy="3851654"/>
                    </a:xfrm>
                  </p:grpSpPr>
                  <p:grpSp>
                    <p:nvGrpSpPr>
                      <p:cNvPr id="35" name="Csoportba foglalás 34">
                        <a:extLst>
                          <a:ext uri="{FF2B5EF4-FFF2-40B4-BE49-F238E27FC236}">
                            <a16:creationId xmlns:a16="http://schemas.microsoft.com/office/drawing/2014/main" id="{B5A4A1FC-5E70-3594-3500-EB5F8AC8B6E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7" y="378270"/>
                        <a:ext cx="11964550" cy="3851654"/>
                        <a:chOff x="68367" y="378270"/>
                        <a:chExt cx="11964550" cy="3851654"/>
                      </a:xfrm>
                    </p:grpSpPr>
                    <p:grpSp>
                      <p:nvGrpSpPr>
                        <p:cNvPr id="31" name="Csoportba foglalás 30">
                          <a:extLst>
                            <a:ext uri="{FF2B5EF4-FFF2-40B4-BE49-F238E27FC236}">
                              <a16:creationId xmlns:a16="http://schemas.microsoft.com/office/drawing/2014/main" id="{A41AEF7A-F49B-E3E9-EE29-D00E4A48C07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7" y="378270"/>
                          <a:ext cx="11964550" cy="3851654"/>
                          <a:chOff x="68367" y="378270"/>
                          <a:chExt cx="11964550" cy="3851654"/>
                        </a:xfrm>
                      </p:grpSpPr>
                      <p:grpSp>
                        <p:nvGrpSpPr>
                          <p:cNvPr id="23" name="Csoportba foglalás 22">
                            <a:extLst>
                              <a:ext uri="{FF2B5EF4-FFF2-40B4-BE49-F238E27FC236}">
                                <a16:creationId xmlns:a16="http://schemas.microsoft.com/office/drawing/2014/main" id="{42391ED3-CCE5-F366-ABE9-3F3CBCCF37EA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7" y="378270"/>
                            <a:ext cx="11964550" cy="3851654"/>
                            <a:chOff x="68367" y="378270"/>
                            <a:chExt cx="11964550" cy="3851654"/>
                          </a:xfrm>
                        </p:grpSpPr>
                        <p:grpSp>
                          <p:nvGrpSpPr>
                            <p:cNvPr id="16" name="Csoportba foglalás 15">
                              <a:extLst>
                                <a:ext uri="{FF2B5EF4-FFF2-40B4-BE49-F238E27FC236}">
                                  <a16:creationId xmlns:a16="http://schemas.microsoft.com/office/drawing/2014/main" id="{5798E537-7548-375B-4BA2-757621D6325E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7" y="378270"/>
                              <a:ext cx="11964550" cy="3851654"/>
                              <a:chOff x="68367" y="378270"/>
                              <a:chExt cx="11964550" cy="3851654"/>
                            </a:xfrm>
                          </p:grpSpPr>
                          <p:grpSp>
                            <p:nvGrpSpPr>
                              <p:cNvPr id="129" name="Csoportba foglalás 128">
                                <a:extLst>
                                  <a:ext uri="{FF2B5EF4-FFF2-40B4-BE49-F238E27FC236}">
                                    <a16:creationId xmlns:a16="http://schemas.microsoft.com/office/drawing/2014/main" id="{5520BFF5-8A90-0445-343E-1A426AB1C18E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7" y="378270"/>
                                <a:ext cx="11964550" cy="3851654"/>
                                <a:chOff x="68367" y="378270"/>
                                <a:chExt cx="11964550" cy="3851654"/>
                              </a:xfrm>
                            </p:grpSpPr>
                            <p:grpSp>
                              <p:nvGrpSpPr>
                                <p:cNvPr id="102" name="Csoportba foglalás 101">
                                  <a:extLst>
                                    <a:ext uri="{FF2B5EF4-FFF2-40B4-BE49-F238E27FC236}">
                                      <a16:creationId xmlns:a16="http://schemas.microsoft.com/office/drawing/2014/main" id="{2093C254-E0DA-7308-383C-98B07D39683E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8367" y="378270"/>
                                  <a:ext cx="11964550" cy="3851654"/>
                                  <a:chOff x="68367" y="378270"/>
                                  <a:chExt cx="11964550" cy="3851654"/>
                                </a:xfrm>
                              </p:grpSpPr>
                              <p:grpSp>
                                <p:nvGrpSpPr>
                                  <p:cNvPr id="61" name="Csoportba foglalás 60">
                                    <a:extLst>
                                      <a:ext uri="{FF2B5EF4-FFF2-40B4-BE49-F238E27FC236}">
                                        <a16:creationId xmlns:a16="http://schemas.microsoft.com/office/drawing/2014/main" id="{36FDC435-F37D-965C-CF10-8F2CBC0071F1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8367" y="378270"/>
                                    <a:ext cx="11964550" cy="3851654"/>
                                    <a:chOff x="68367" y="378270"/>
                                    <a:chExt cx="11964550" cy="3851654"/>
                                  </a:xfrm>
                                </p:grpSpPr>
                                <p:grpSp>
                                  <p:nvGrpSpPr>
                                    <p:cNvPr id="77" name="Csoportba foglalás 76">
                                      <a:extLst>
                                        <a:ext uri="{FF2B5EF4-FFF2-40B4-BE49-F238E27FC236}">
                                          <a16:creationId xmlns:a16="http://schemas.microsoft.com/office/drawing/2014/main" id="{C569ACAC-D16B-0D65-7D7D-1F76F44BC39F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8367" y="378270"/>
                                      <a:ext cx="11964550" cy="3851654"/>
                                      <a:chOff x="68367" y="378270"/>
                                      <a:chExt cx="11964550" cy="3851654"/>
                                    </a:xfrm>
                                  </p:grpSpPr>
                                  <p:grpSp>
                                    <p:nvGrpSpPr>
                                      <p:cNvPr id="33" name="Csoportba foglalás 32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74234755-A58A-362A-7964-89361751F9AD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8367" y="378270"/>
                                        <a:ext cx="11964550" cy="3851654"/>
                                        <a:chOff x="68367" y="378270"/>
                                        <a:chExt cx="11964550" cy="3851654"/>
                                      </a:xfrm>
                                    </p:grpSpPr>
                                    <p:grpSp>
                                      <p:nvGrpSpPr>
                                        <p:cNvPr id="22" name="Csoportba foglalás 21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BEE41243-DEF0-695A-74F2-20214D9B4C58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8367" y="378270"/>
                                          <a:ext cx="11964550" cy="3851654"/>
                                          <a:chOff x="68367" y="378270"/>
                                          <a:chExt cx="11964550" cy="3851654"/>
                                        </a:xfrm>
                                      </p:grpSpPr>
                                      <p:grpSp>
                                        <p:nvGrpSpPr>
                                          <p:cNvPr id="82" name="Csoportba foglalás 81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E4D819F0-F49E-F51F-1614-D4572937A902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68367" y="378270"/>
                                            <a:ext cx="11964550" cy="3851654"/>
                                            <a:chOff x="68367" y="378270"/>
                                            <a:chExt cx="11964550" cy="3851654"/>
                                          </a:xfrm>
                                        </p:grpSpPr>
                                        <p:grpSp>
                                          <p:nvGrpSpPr>
                                            <p:cNvPr id="76" name="Csoportba foglalás 75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07F847BE-36B5-68B3-4646-5E2854D87DFD}"/>
                                                </a:ext>
                                              </a:extLst>
                                            </p:cNvPr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68367" y="378270"/>
                                              <a:ext cx="11964550" cy="3851654"/>
                                              <a:chOff x="68367" y="378270"/>
                                              <a:chExt cx="11964550" cy="3851654"/>
                                            </a:xfrm>
                                          </p:grpSpPr>
                                          <p:grpSp>
                                            <p:nvGrpSpPr>
                                              <p:cNvPr id="64" name="Csoportba foglalás 63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99070FB3-458C-B6BA-F426-7CBE7ACAB0A8}"/>
                                                  </a:ext>
                                                </a:extLst>
                                              </p:cNvPr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68367" y="378270"/>
                                                <a:ext cx="11964550" cy="3851654"/>
                                                <a:chOff x="68367" y="378270"/>
                                                <a:chExt cx="11964550" cy="3851654"/>
                                              </a:xfrm>
                                            </p:grpSpPr>
                                            <p:grpSp>
                                              <p:nvGrpSpPr>
                                                <p:cNvPr id="59" name="Csoportba foglalás 58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D69FBEC8-63C6-D8A3-6667-5AB6865BEE97}"/>
                                                    </a:ext>
                                                  </a:extLst>
                                                </p:cNvPr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68367" y="378270"/>
                                                  <a:ext cx="11964550" cy="3851654"/>
                                                  <a:chOff x="68367" y="378270"/>
                                                  <a:chExt cx="11964550" cy="3851654"/>
                                                </a:xfrm>
                                              </p:grpSpPr>
                                              <p:grpSp>
                                                <p:nvGrpSpPr>
                                                  <p:cNvPr id="5" name="Csoportba foglalás 4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666EC76C-2260-6217-0624-8D898ED5A4E4}"/>
                                                      </a:ext>
                                                    </a:extLst>
                                                  </p:cNvPr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68367" y="378270"/>
                                                    <a:ext cx="11964550" cy="3851654"/>
                                                    <a:chOff x="68367" y="378270"/>
                                                    <a:chExt cx="11964550" cy="3851654"/>
                                                  </a:xfrm>
                                                </p:grpSpPr>
                                                <p:sp>
                                                  <p:nvSpPr>
                                                    <p:cNvPr id="6" name="Szövegdoboz 5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1EE92C5E-E4EC-2CEC-670B-01AFCBAF0098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6018131" y="3293501"/>
                                                      <a:ext cx="470000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DMSO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  <p:sp>
                                                  <p:nvSpPr>
                                                    <p:cNvPr id="7" name="Szövegdoboz 6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DCA53139-B3EF-2478-66CC-2DBFD2DA811A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6719523" y="3290410"/>
                                                      <a:ext cx="457176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UDCA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  <p:sp>
                                                  <p:nvSpPr>
                                                    <p:cNvPr id="8" name="Szövegdoboz 7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59B18E5D-9CAA-1B96-B3D8-B587D74C772B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2315926" y="3294565"/>
                                                      <a:ext cx="470000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DMSO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  <p:sp>
                                                  <p:nvSpPr>
                                                    <p:cNvPr id="9" name="Szövegdoboz 8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CBA7CB9F-0B07-F693-FF24-6BAB2FD09EA9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2913625" y="3291475"/>
                                                      <a:ext cx="457176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UDCA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  <p:sp>
                                                  <p:nvSpPr>
                                                    <p:cNvPr id="10" name="Szövegdoboz 9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26D52466-16B5-4210-DBA7-126A8D1CC5F2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9752793" y="3285007"/>
                                                      <a:ext cx="470000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DMSO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  <p:sp>
                                                  <p:nvSpPr>
                                                    <p:cNvPr id="11" name="Szövegdoboz 10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E1C1C8CB-BEF3-799C-6817-7756DC67E587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10415597" y="3289320"/>
                                                      <a:ext cx="457176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UDCA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  <p:grpSp>
                                                  <p:nvGrpSpPr>
                                                    <p:cNvPr id="13" name="Csoportba foglalás 12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F7953510-80C4-08DE-5F12-30E0E9381EFE}"/>
                                                        </a:ext>
                                                      </a:extLst>
                                                    </p:cNvPr>
                                                    <p:cNvGrpSpPr/>
                                                    <p:nvPr/>
                                                  </p:nvGrpSpPr>
                                                  <p:grpSpPr>
                                                    <a:xfrm>
                                                      <a:off x="68367" y="378270"/>
                                                      <a:ext cx="11964550" cy="3851654"/>
                                                      <a:chOff x="68367" y="378270"/>
                                                      <a:chExt cx="11964550" cy="3851654"/>
                                                    </a:xfrm>
                                                  </p:grpSpPr>
                                                  <p:grpSp>
                                                    <p:nvGrpSpPr>
                                                      <p:cNvPr id="17" name="Csoportba foglalás 16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D2869022-5E02-D495-459D-4C73CF0945AD}"/>
                                                          </a:ext>
                                                        </a:extLst>
                                                      </p:cNvPr>
                                                      <p:cNvGrpSpPr/>
                                                      <p:nvPr/>
                                                    </p:nvGrpSpPr>
                                                    <p:grpSpPr>
                                                      <a:xfrm>
                                                        <a:off x="68367" y="378270"/>
                                                        <a:ext cx="11964550" cy="3851654"/>
                                                        <a:chOff x="68367" y="378270"/>
                                                        <a:chExt cx="11964550" cy="3851654"/>
                                                      </a:xfrm>
                                                    </p:grpSpPr>
                                                    <p:sp>
                                                      <p:nvSpPr>
                                                        <p:cNvPr id="24" name="Szövegdoboz 23">
                                                          <a:extLst>
                                                            <a:ext uri="{FF2B5EF4-FFF2-40B4-BE49-F238E27FC236}">
                                                              <a16:creationId xmlns:a16="http://schemas.microsoft.com/office/drawing/2014/main" id="{9DBE9E64-7749-5286-A934-87C2DA3328AA}"/>
                                                            </a:ext>
                                                          </a:extLst>
                                                        </p:cNvPr>
                                                        <p:cNvSpPr txBox="1"/>
                                                        <p:nvPr/>
                                                      </p:nvSpPr>
                                                      <p:spPr>
                                                        <a:xfrm>
                                                          <a:off x="6021441" y="621584"/>
                                                          <a:ext cx="470000" cy="215444"/>
                                                        </a:xfrm>
                                                        <a:prstGeom prst="rect">
                                                          <a:avLst/>
                                                        </a:prstGeom>
                                                        <a:noFill/>
                                                      </p:spPr>
                                                      <p:txBody>
                                                        <a:bodyPr wrap="none" rtlCol="0">
                                                          <a:spAutoFit/>
                                                        </a:bodyPr>
                                                        <a:lstStyle/>
                                                        <a:p>
                                                          <a:r>
                                                            <a:rPr lang="hu-HU" sz="800" dirty="0"/>
                                                            <a:t>DMSO</a:t>
                                                          </a:r>
                                                        </a:p>
                                                      </p:txBody>
                                                    </p:sp>
                                                    <p:sp>
                                                      <p:nvSpPr>
                                                        <p:cNvPr id="25" name="Szövegdoboz 24">
                                                          <a:extLst>
                                                            <a:ext uri="{FF2B5EF4-FFF2-40B4-BE49-F238E27FC236}">
                                                              <a16:creationId xmlns:a16="http://schemas.microsoft.com/office/drawing/2014/main" id="{74AB1839-0AF7-9320-D373-719005F5B9E5}"/>
                                                            </a:ext>
                                                          </a:extLst>
                                                        </p:cNvPr>
                                                        <p:cNvSpPr txBox="1"/>
                                                        <p:nvPr/>
                                                      </p:nvSpPr>
                                                      <p:spPr>
                                                        <a:xfrm>
                                                          <a:off x="6637982" y="627919"/>
                                                          <a:ext cx="457176" cy="215444"/>
                                                        </a:xfrm>
                                                        <a:prstGeom prst="rect">
                                                          <a:avLst/>
                                                        </a:prstGeom>
                                                        <a:noFill/>
                                                      </p:spPr>
                                                      <p:txBody>
                                                        <a:bodyPr wrap="none" rtlCol="0">
                                                          <a:spAutoFit/>
                                                        </a:bodyPr>
                                                        <a:lstStyle/>
                                                        <a:p>
                                                          <a:r>
                                                            <a:rPr lang="hu-HU" sz="800" dirty="0"/>
                                                            <a:t>UDCA</a:t>
                                                          </a:r>
                                                        </a:p>
                                                      </p:txBody>
                                                    </p:sp>
                                                    <p:grpSp>
                                                      <p:nvGrpSpPr>
                                                        <p:cNvPr id="40" name="Csoportba foglalás 39">
                                                          <a:extLst>
                                                            <a:ext uri="{FF2B5EF4-FFF2-40B4-BE49-F238E27FC236}">
                                                              <a16:creationId xmlns:a16="http://schemas.microsoft.com/office/drawing/2014/main" id="{AD74C5FA-955A-53AC-A5DE-7102165BBD28}"/>
                                                            </a:ext>
                                                          </a:extLst>
                                                        </p:cNvPr>
                                                        <p:cNvGrpSpPr/>
                                                        <p:nvPr/>
                                                      </p:nvGrpSpPr>
                                                      <p:grpSpPr>
                                                        <a:xfrm>
                                                          <a:off x="68367" y="378270"/>
                                                          <a:ext cx="11964550" cy="3851654"/>
                                                          <a:chOff x="68367" y="415477"/>
                                                          <a:chExt cx="11964550" cy="3851654"/>
                                                        </a:xfrm>
                                                      </p:grpSpPr>
                                                      <p:sp>
                                                        <p:nvSpPr>
                                                          <p:cNvPr id="45" name="Szövegdoboz 44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id="{66D3585D-B626-E2C5-481E-54A1670C3C57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SpPr txBox="1"/>
                                                          <p:nvPr/>
                                                        </p:nvSpPr>
                                                        <p:spPr>
                                                          <a:xfrm>
                                                            <a:off x="68367" y="869125"/>
                                                            <a:ext cx="1271179" cy="307777"/>
                                                          </a:xfrm>
                                                          <a:prstGeom prst="rect">
                                                            <a:avLst/>
                                                          </a:prstGeom>
                                                          <a:noFill/>
                                                        </p:spPr>
                                                        <p:txBody>
                                                          <a:bodyPr wrap="square" rtlCol="0">
                                                            <a:spAutoFit/>
                                                          </a:bodyPr>
                                                          <a:lstStyle/>
                                                          <a:p>
                                                            <a:r>
                                                              <a:rPr lang="hu-HU" sz="1400" dirty="0"/>
                                                              <a:t>4HNE:</a:t>
                                                            </a:r>
                                                          </a:p>
                                                        </p:txBody>
                                                      </p:sp>
                                                      <p:sp>
                                                        <p:nvSpPr>
                                                          <p:cNvPr id="46" name="Szövegdoboz 45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id="{D28978E5-AA9F-8E23-7150-26C97BBEA88B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SpPr txBox="1"/>
                                                          <p:nvPr/>
                                                        </p:nvSpPr>
                                                        <p:spPr>
                                                          <a:xfrm>
                                                            <a:off x="68367" y="3653777"/>
                                                            <a:ext cx="803304" cy="307777"/>
                                                          </a:xfrm>
                                                          <a:prstGeom prst="rect">
                                                            <a:avLst/>
                                                          </a:prstGeom>
                                                          <a:noFill/>
                                                        </p:spPr>
                                                        <p:txBody>
                                                          <a:bodyPr wrap="square" rtlCol="0">
                                                            <a:spAutoFit/>
                                                          </a:bodyPr>
                                                          <a:lstStyle/>
                                                          <a:p>
                                                            <a:r>
                                                              <a:rPr lang="hu-HU" sz="1400" dirty="0"/>
                                                              <a:t>β-</a:t>
                                                            </a:r>
                                                            <a:r>
                                                              <a:rPr lang="hu-HU" sz="1400" dirty="0" err="1"/>
                                                              <a:t>actin</a:t>
                                                            </a:r>
                                                            <a:r>
                                                              <a:rPr lang="hu-HU" sz="1400" dirty="0"/>
                                                              <a:t>:</a:t>
                                                            </a:r>
                                                          </a:p>
                                                        </p:txBody>
                                                      </p:sp>
                                                      <p:grpSp>
                                                        <p:nvGrpSpPr>
                                                          <p:cNvPr id="47" name="Csoportba foglalás 46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id="{ECC78131-FA46-9B9E-121A-F2AFAC1773DF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GrpSpPr/>
                                                          <p:nvPr/>
                                                        </p:nvGrpSpPr>
                                                        <p:grpSpPr>
                                                          <a:xfrm>
                                                            <a:off x="2329408" y="415641"/>
                                                            <a:ext cx="1026590" cy="471695"/>
                                                            <a:chOff x="2329408" y="415641"/>
                                                            <a:chExt cx="1026590" cy="471695"/>
                                                          </a:xfrm>
                                                        </p:grpSpPr>
                                                        <p:grpSp>
                                                          <p:nvGrpSpPr>
                                                            <p:cNvPr id="51" name="Csoportba foglalás 50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id="{D1F86804-959C-FDB1-6496-7E5C944541AE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GrpSpPr/>
                                                            <p:nvPr/>
                                                          </p:nvGrpSpPr>
                                                          <p:grpSpPr>
                                                            <a:xfrm>
                                                              <a:off x="2329408" y="665557"/>
                                                              <a:ext cx="1026590" cy="221779"/>
                                                              <a:chOff x="2329408" y="289547"/>
                                                              <a:chExt cx="1026590" cy="221779"/>
                                                            </a:xfrm>
                                                          </p:grpSpPr>
                                                          <p:sp>
                                                            <p:nvSpPr>
                                                              <p:cNvPr id="53" name="Szövegdoboz 52">
                                                                <a:extLst>
                                                                  <a:ext uri="{FF2B5EF4-FFF2-40B4-BE49-F238E27FC236}">
                                                                    <a16:creationId xmlns:a16="http://schemas.microsoft.com/office/drawing/2014/main" id="{4185ACB4-2E26-53E4-7817-E9EC98D80B21}"/>
                                                                  </a:ext>
                                                                </a:extLst>
                                                              </p:cNvPr>
                                                              <p:cNvSpPr txBox="1"/>
                                                              <p:nvPr/>
                                                            </p:nvSpPr>
                                                            <p:spPr>
                                                              <a:xfrm>
                                                                <a:off x="2329408" y="289547"/>
                                                                <a:ext cx="470000" cy="215444"/>
                                                              </a:xfrm>
                                                              <a:prstGeom prst="rect">
                                                                <a:avLst/>
                                                              </a:prstGeom>
                                                              <a:noFill/>
                                                            </p:spPr>
                                                            <p:txBody>
                                                              <a:bodyPr wrap="none" rtlCol="0">
                                                                <a:spAutoFit/>
                                                              </a:bodyPr>
                                                              <a:lstStyle/>
                                                              <a:p>
                                                                <a:r>
                                                                  <a:rPr lang="hu-HU" sz="800" dirty="0"/>
                                                                  <a:t>DMSO</a:t>
                                                                </a:r>
                                                              </a:p>
                                                            </p:txBody>
                                                          </p:sp>
                                                          <p:sp>
                                                            <p:nvSpPr>
                                                              <p:cNvPr id="54" name="Szövegdoboz 53">
                                                                <a:extLst>
                                                                  <a:ext uri="{FF2B5EF4-FFF2-40B4-BE49-F238E27FC236}">
                                                                    <a16:creationId xmlns:a16="http://schemas.microsoft.com/office/drawing/2014/main" id="{FBEA5532-CAE2-88D1-FBDE-A57D01FAD56E}"/>
                                                                  </a:ext>
                                                                </a:extLst>
                                                              </p:cNvPr>
                                                              <p:cNvSpPr txBox="1"/>
                                                              <p:nvPr/>
                                                            </p:nvSpPr>
                                                            <p:spPr>
                                                              <a:xfrm>
                                                                <a:off x="2898822" y="295882"/>
                                                                <a:ext cx="457176" cy="215444"/>
                                                              </a:xfrm>
                                                              <a:prstGeom prst="rect">
                                                                <a:avLst/>
                                                              </a:prstGeom>
                                                              <a:noFill/>
                                                            </p:spPr>
                                                            <p:txBody>
                                                              <a:bodyPr wrap="none" rtlCol="0">
                                                                <a:spAutoFit/>
                                                              </a:bodyPr>
                                                              <a:lstStyle/>
                                                              <a:p>
                                                                <a:r>
                                                                  <a:rPr lang="hu-HU" sz="800" dirty="0"/>
                                                                  <a:t>UDCA</a:t>
                                                                </a:r>
                                                              </a:p>
                                                            </p:txBody>
                                                          </p:sp>
                                                        </p:grpSp>
                                                        <p:sp>
                                                          <p:nvSpPr>
                                                            <p:cNvPr id="52" name="Szövegdoboz 51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id="{87C03FB1-0305-6610-B2F8-3AF2F9687DAF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2533973" y="415641"/>
                                                              <a:ext cx="332142" cy="307777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non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r>
                                                                <a:rPr lang="hu-HU" sz="1400" b="1" dirty="0"/>
                                                                <a:t>1.</a:t>
                                                              </a:r>
                                                            </a:p>
                                                          </p:txBody>
                                                        </p:sp>
                                                      </p:grpSp>
                                                      <p:sp>
                                                        <p:nvSpPr>
                                                          <p:cNvPr id="48" name="Szövegdoboz 47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id="{FF8775A9-DE28-A990-FA6B-A5EA7988A5B4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SpPr txBox="1"/>
                                                          <p:nvPr/>
                                                        </p:nvSpPr>
                                                        <p:spPr>
                                                          <a:xfrm>
                                                            <a:off x="6271647" y="416294"/>
                                                            <a:ext cx="335348" cy="307777"/>
                                                          </a:xfrm>
                                                          <a:prstGeom prst="rect">
                                                            <a:avLst/>
                                                          </a:prstGeom>
                                                          <a:noFill/>
                                                        </p:spPr>
                                                        <p:txBody>
                                                          <a:bodyPr wrap="none" rtlCol="0">
                                                            <a:spAutoFit/>
                                                          </a:bodyPr>
                                                          <a:lstStyle/>
                                                          <a:p>
                                                            <a:r>
                                                              <a:rPr lang="hu-HU" sz="1400" b="1" dirty="0"/>
                                                              <a:t>2.</a:t>
                                                            </a:r>
                                                          </a:p>
                                                        </p:txBody>
                                                      </p:sp>
                                                      <p:sp>
                                                        <p:nvSpPr>
                                                          <p:cNvPr id="49" name="Szövegdoboz 48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id="{D9333B53-470F-176B-2960-30B707B78615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SpPr txBox="1"/>
                                                          <p:nvPr/>
                                                        </p:nvSpPr>
                                                        <p:spPr>
                                                          <a:xfrm>
                                                            <a:off x="10016820" y="415477"/>
                                                            <a:ext cx="335348" cy="307777"/>
                                                          </a:xfrm>
                                                          <a:prstGeom prst="rect">
                                                            <a:avLst/>
                                                          </a:prstGeom>
                                                          <a:noFill/>
                                                        </p:spPr>
                                                        <p:txBody>
                                                          <a:bodyPr wrap="none" rtlCol="0">
                                                            <a:spAutoFit/>
                                                          </a:bodyPr>
                                                          <a:lstStyle/>
                                                          <a:p>
                                                            <a:r>
                                                              <a:rPr lang="hu-HU" sz="1400" b="1" dirty="0"/>
                                                              <a:t>3.</a:t>
                                                            </a:r>
                                                          </a:p>
                                                        </p:txBody>
                                                      </p:sp>
                                                      <p:sp>
                                                        <p:nvSpPr>
                                                          <p:cNvPr id="50" name="Téglalap 49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id="{7EE5AF85-79AD-2E88-859A-74FA3BC508C3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SpPr/>
                                                          <p:nvPr/>
                                                        </p:nvSpPr>
                                                        <p:spPr>
                                                          <a:xfrm>
                                                            <a:off x="70822" y="474905"/>
                                                            <a:ext cx="11962095" cy="3792226"/>
                                                          </a:xfrm>
                                                          <a:prstGeom prst="rect">
                                                            <a:avLst/>
                                                          </a:prstGeom>
                                                          <a:noFill/>
                                                        </p:spPr>
                                                        <p:style>
                                                          <a:lnRef idx="2">
                                                            <a:schemeClr val="accent1">
                                                              <a:shade val="15000"/>
                                                            </a:schemeClr>
                                                          </a:lnRef>
                                                          <a:fillRef idx="1">
                                                            <a:schemeClr val="accent1"/>
                                                          </a:fillRef>
                                                          <a:effectRef idx="0">
                                                            <a:schemeClr val="accent1"/>
                                                          </a:effectRef>
                                                          <a:fontRef idx="minor">
                                                            <a:schemeClr val="lt1"/>
                                                          </a:fontRef>
                                                        </p:style>
                                                        <p:txBody>
                                                          <a:bodyPr rtlCol="0" anchor="ctr"/>
                                                          <a:lstStyle/>
                                                          <a:p>
                                                            <a:pPr algn="ctr"/>
                                                            <a:endParaRPr lang="hu-HU"/>
                                                          </a:p>
                                                        </p:txBody>
                                                      </p:sp>
                                                    </p:grpSp>
                                                  </p:grpSp>
                                                  <p:sp>
                                                    <p:nvSpPr>
                                                      <p:cNvPr id="19" name="Szövegdoboz 18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BF3BA821-64F9-7542-13DC-3694C7DD53BF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9859655" y="622936"/>
                                                        <a:ext cx="470000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DMSO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20" name="Szövegdoboz 19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BFA7C2B5-D68F-0DB7-73EE-E123146A0886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10456485" y="627249"/>
                                                        <a:ext cx="457176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UDCA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</p:grpSp>
                                              </p:grpSp>
                                              <p:sp>
                                                <p:nvSpPr>
                                                  <p:cNvPr id="58" name="Szövegdoboz 57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0FA3A88A-7BFD-0A39-C497-4857235015E0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1461389" y="780680"/>
                                                    <a:ext cx="348172" cy="215444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800" dirty="0"/>
                                                      <a:t>250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</p:grpSp>
                                            <p:sp>
                                              <p:nvSpPr>
                                                <p:cNvPr id="63" name="Szövegdoboz 62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1C6F6342-181D-2A47-4D70-C59B7A57178E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1513903" y="3446887"/>
                                                  <a:ext cx="293670" cy="215444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800" dirty="0"/>
                                                    <a:t>55</a:t>
                                                  </a:r>
                                                </a:p>
                                              </p:txBody>
                                            </p:sp>
                                          </p:grpSp>
                                          <p:sp>
                                            <p:nvSpPr>
                                              <p:cNvPr id="74" name="Szövegdoboz 73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3B0CFB52-98AD-0BAE-3F2B-AA20920D756B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5324245" y="3896642"/>
                                                <a:ext cx="293670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35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75" name="Szövegdoboz 74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CA52119A-7028-EC42-B001-B72931896E94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5324616" y="3474660"/>
                                                <a:ext cx="293670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55</a:t>
                                                </a:r>
                                              </a:p>
                                            </p:txBody>
                                          </p:sp>
                                        </p:grpSp>
                                        <p:sp>
                                          <p:nvSpPr>
                                            <p:cNvPr id="80" name="Szövegdoboz 79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BE0AE24B-F7DA-5C43-7207-DD5032C6A0E0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9057063" y="3437150"/>
                                              <a:ext cx="29367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55</a:t>
                                              </a:r>
                                            </a:p>
                                          </p:txBody>
                                        </p:sp>
                                      </p:grpSp>
                                      <p:sp>
                                        <p:nvSpPr>
                                          <p:cNvPr id="18" name="Szövegdoboz 17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5EB4E4E8-4465-901C-0C1F-467C42EC9A2A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1462957" y="1055631"/>
                                            <a:ext cx="348172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130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21" name="Szövegdoboz 20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7056F621-6DE4-7B91-184D-1C9EE20A6CD2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1455100" y="1330582"/>
                                            <a:ext cx="348172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100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  <p:sp>
                                      <p:nvSpPr>
                                        <p:cNvPr id="32" name="Szövegdoboz 31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4E50FDCC-5278-358B-F6B8-D5CD847F8219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1515476" y="3891525"/>
                                          <a:ext cx="29367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35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73" name="Szövegdoboz 72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8C45F1EF-436E-B74A-BAF6-0C9C20D9DD4E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9059363" y="3888947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35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34" name="Szövegdoboz 33">
                                      <a:extLst>
                                        <a:ext uri="{FF2B5EF4-FFF2-40B4-BE49-F238E27FC236}">
                                          <a16:creationId xmlns:a16="http://schemas.microsoft.com/office/drawing/2014/main" id="{D6188A28-89D5-0BC1-3F9E-AA1D8E4330A2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513230" y="1596106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70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56" name="Szövegdoboz 55">
                                      <a:extLst>
                                        <a:ext uri="{FF2B5EF4-FFF2-40B4-BE49-F238E27FC236}">
                                          <a16:creationId xmlns:a16="http://schemas.microsoft.com/office/drawing/2014/main" id="{778D88D3-004B-40A4-8772-7C5179BFE2C8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514799" y="1965323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55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57" name="Szövegdoboz 56">
                                      <a:extLst>
                                        <a:ext uri="{FF2B5EF4-FFF2-40B4-BE49-F238E27FC236}">
                                          <a16:creationId xmlns:a16="http://schemas.microsoft.com/office/drawing/2014/main" id="{B3086FA4-43ED-D397-9146-153FC02C3204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516367" y="2626771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35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60" name="Szövegdoboz 59">
                                      <a:extLst>
                                        <a:ext uri="{FF2B5EF4-FFF2-40B4-BE49-F238E27FC236}">
                                          <a16:creationId xmlns:a16="http://schemas.microsoft.com/office/drawing/2014/main" id="{2A8686C0-6365-EA89-9281-2E73920E1302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517936" y="3014841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25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86" name="Szövegdoboz 85">
                                    <a:extLst>
                                      <a:ext uri="{FF2B5EF4-FFF2-40B4-BE49-F238E27FC236}">
                                        <a16:creationId xmlns:a16="http://schemas.microsoft.com/office/drawing/2014/main" id="{0693B11E-92DF-39B0-D387-D3FB051A70F1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271393" y="782248"/>
                                    <a:ext cx="348172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250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87" name="Szövegdoboz 86">
                                    <a:extLst>
                                      <a:ext uri="{FF2B5EF4-FFF2-40B4-BE49-F238E27FC236}">
                                        <a16:creationId xmlns:a16="http://schemas.microsoft.com/office/drawing/2014/main" id="{4E98C77A-06EE-4D26-5CCC-08214BE303B0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272961" y="1094907"/>
                                    <a:ext cx="348172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130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90" name="Szövegdoboz 89">
                                    <a:extLst>
                                      <a:ext uri="{FF2B5EF4-FFF2-40B4-BE49-F238E27FC236}">
                                        <a16:creationId xmlns:a16="http://schemas.microsoft.com/office/drawing/2014/main" id="{4DBB35F8-07E1-9B61-35EA-01E038C1F9BB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265104" y="1369858"/>
                                    <a:ext cx="348172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100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94" name="Szövegdoboz 93">
                                    <a:extLst>
                                      <a:ext uri="{FF2B5EF4-FFF2-40B4-BE49-F238E27FC236}">
                                        <a16:creationId xmlns:a16="http://schemas.microsoft.com/office/drawing/2014/main" id="{99386176-73FB-619A-4958-D055BA5B4A99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323234" y="1663663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70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95" name="Szövegdoboz 94">
                                    <a:extLst>
                                      <a:ext uri="{FF2B5EF4-FFF2-40B4-BE49-F238E27FC236}">
                                        <a16:creationId xmlns:a16="http://schemas.microsoft.com/office/drawing/2014/main" id="{D0C2B3E6-9AF9-8904-5746-A2176C2085BA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324803" y="2014026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55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96" name="Szövegdoboz 95">
                                    <a:extLst>
                                      <a:ext uri="{FF2B5EF4-FFF2-40B4-BE49-F238E27FC236}">
                                        <a16:creationId xmlns:a16="http://schemas.microsoft.com/office/drawing/2014/main" id="{95591784-E206-CB66-6D7E-3C4A63073FFC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326371" y="2647193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35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99" name="Szövegdoboz 98">
                                    <a:extLst>
                                      <a:ext uri="{FF2B5EF4-FFF2-40B4-BE49-F238E27FC236}">
                                        <a16:creationId xmlns:a16="http://schemas.microsoft.com/office/drawing/2014/main" id="{965D7DDF-485F-B599-62AA-DF22CC5D34D8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5327940" y="3016409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25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121" name="Szövegdoboz 120">
                                  <a:extLst>
                                    <a:ext uri="{FF2B5EF4-FFF2-40B4-BE49-F238E27FC236}">
                                      <a16:creationId xmlns:a16="http://schemas.microsoft.com/office/drawing/2014/main" id="{1898A444-C0BB-657E-8DFA-3B4670C7E1A4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9015407" y="774392"/>
                                  <a:ext cx="348172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250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22" name="Szövegdoboz 121">
                                  <a:extLst>
                                    <a:ext uri="{FF2B5EF4-FFF2-40B4-BE49-F238E27FC236}">
                                      <a16:creationId xmlns:a16="http://schemas.microsoft.com/office/drawing/2014/main" id="{675B4CCE-8577-94CA-47BF-8D183D85472D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9016975" y="1030489"/>
                                  <a:ext cx="348172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130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23" name="Szövegdoboz 122">
                                  <a:extLst>
                                    <a:ext uri="{FF2B5EF4-FFF2-40B4-BE49-F238E27FC236}">
                                      <a16:creationId xmlns:a16="http://schemas.microsoft.com/office/drawing/2014/main" id="{70AE2675-25E4-D3B3-4A93-BF29DC660B18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9009118" y="1248878"/>
                                  <a:ext cx="348172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100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25" name="Szövegdoboz 124">
                                  <a:extLst>
                                    <a:ext uri="{FF2B5EF4-FFF2-40B4-BE49-F238E27FC236}">
                                      <a16:creationId xmlns:a16="http://schemas.microsoft.com/office/drawing/2014/main" id="{6640F9D8-DCA3-E292-8EEB-41A6A9E10DC6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9067248" y="1486121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70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26" name="Szövegdoboz 125">
                                  <a:extLst>
                                    <a:ext uri="{FF2B5EF4-FFF2-40B4-BE49-F238E27FC236}">
                                      <a16:creationId xmlns:a16="http://schemas.microsoft.com/office/drawing/2014/main" id="{66CA1591-7E31-C235-69FE-F544839705CC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9068817" y="1732794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55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27" name="Szövegdoboz 126">
                                  <a:extLst>
                                    <a:ext uri="{FF2B5EF4-FFF2-40B4-BE49-F238E27FC236}">
                                      <a16:creationId xmlns:a16="http://schemas.microsoft.com/office/drawing/2014/main" id="{A735A463-8D83-3D66-9A8D-1F0A54E1846D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9070385" y="2252838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35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28" name="Szövegdoboz 127">
                                  <a:extLst>
                                    <a:ext uri="{FF2B5EF4-FFF2-40B4-BE49-F238E27FC236}">
                                      <a16:creationId xmlns:a16="http://schemas.microsoft.com/office/drawing/2014/main" id="{319E8886-DC4B-8AD4-4292-99B313652AEE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9053100" y="2565492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25</a:t>
                                  </a:r>
                                </a:p>
                              </p:txBody>
                            </p:sp>
                          </p:grpSp>
                          <p:pic>
                            <p:nvPicPr>
                              <p:cNvPr id="12" name="Kép 11" descr="A képen fekete-fehér, monokróm, Monokróm fényképezés, fekete látható&#10;&#10;Automatikusan generált leírás">
                                <a:extLst>
                                  <a:ext uri="{FF2B5EF4-FFF2-40B4-BE49-F238E27FC236}">
                                    <a16:creationId xmlns:a16="http://schemas.microsoft.com/office/drawing/2014/main" id="{FDD0F20C-156E-AF2B-3629-9F7BBA9EE1F6}"/>
                                  </a:ext>
                                </a:extLst>
                              </p:cNvPr>
                              <p:cNvPicPr>
                                <a:picLocks/>
                              </p:cNvPicPr>
                              <p:nvPr/>
                            </p:nvPicPr>
                            <p:blipFill>
                              <a:blip r:embed="rId3">
                                <a:extLst>
                                  <a:ext uri="{28A0092B-C50C-407E-A947-70E740481C1C}">
                                    <a14:useLocalDpi xmlns:a14="http://schemas.microsoft.com/office/drawing/2010/main" val="0"/>
                                  </a:ext>
                                </a:extLst>
                              </a:blip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823800" y="853779"/>
                                <a:ext cx="1620000" cy="2340000"/>
                              </a:xfrm>
                              <a:prstGeom prst="rect">
                                <a:avLst/>
                              </a:prstGeom>
                              <a:ln w="9525">
                                <a:solidFill>
                                  <a:schemeClr val="tx1"/>
                                </a:solidFill>
                              </a:ln>
                            </p:spPr>
                          </p:pic>
                        </p:grpSp>
                        <p:pic>
                          <p:nvPicPr>
                            <p:cNvPr id="15" name="Kép 14" descr="A képen röntgenfilm, fekete, monokróm, fekete-fehér látható&#10;&#10;Automatikusan generált leírás">
                              <a:extLst>
                                <a:ext uri="{FF2B5EF4-FFF2-40B4-BE49-F238E27FC236}">
                                  <a16:creationId xmlns:a16="http://schemas.microsoft.com/office/drawing/2014/main" id="{CD4472B6-1C3D-B154-35EA-A8D6F471EB49}"/>
                                </a:ext>
                              </a:extLst>
                            </p:cNvPr>
                            <p:cNvPicPr>
                              <a:picLocks/>
                            </p:cNvPicPr>
                            <p:nvPr/>
                          </p:nvPicPr>
                          <p:blipFill>
                            <a:blip r:embed="rId4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820603" y="3514058"/>
                              <a:ext cx="1620000" cy="540000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grpSp>
                      <p:pic>
                        <p:nvPicPr>
                          <p:cNvPr id="28" name="Kép 27" descr="A képen fekete-fehér, monokróm, Monokróm fényképezés, fekete látható&#10;&#10;Automatikusan generált leírás">
                            <a:extLst>
                              <a:ext uri="{FF2B5EF4-FFF2-40B4-BE49-F238E27FC236}">
                                <a16:creationId xmlns:a16="http://schemas.microsoft.com/office/drawing/2014/main" id="{7D7F51B0-1C0E-C52A-CA95-BB53B880DCB2}"/>
                              </a:ext>
                            </a:extLst>
                          </p:cNvPr>
                          <p:cNvPicPr>
                            <a:picLocks/>
                          </p:cNvPicPr>
                          <p:nvPr/>
                        </p:nvPicPr>
                        <p:blipFill>
                          <a:blip r:embed="rId5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5619894" y="845620"/>
                            <a:ext cx="1620000" cy="2340000"/>
                          </a:xfrm>
                          <a:prstGeom prst="rect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</p:pic>
                    </p:grpSp>
                    <p:pic>
                      <p:nvPicPr>
                        <p:cNvPr id="30" name="Kép 29" descr="A képen röntgenfilm, fekete, monokróm, fekete-fehér látható&#10;&#10;Automatikusan generált leírás">
                          <a:extLst>
                            <a:ext uri="{FF2B5EF4-FFF2-40B4-BE49-F238E27FC236}">
                              <a16:creationId xmlns:a16="http://schemas.microsoft.com/office/drawing/2014/main" id="{B1DCFB5A-925B-DE17-08A8-BB62B05B9D4D}"/>
                            </a:ext>
                          </a:extLst>
                        </p:cNvPr>
                        <p:cNvPicPr>
                          <a:picLocks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5619677" y="3514622"/>
                          <a:ext cx="1620000" cy="540000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</p:pic>
                  </p:grpSp>
                  <p:pic>
                    <p:nvPicPr>
                      <p:cNvPr id="37" name="Kép 36" descr="A képen szöveg, fekete-fehér látható&#10;&#10;Automatikusan generált leírás">
                        <a:extLst>
                          <a:ext uri="{FF2B5EF4-FFF2-40B4-BE49-F238E27FC236}">
                            <a16:creationId xmlns:a16="http://schemas.microsoft.com/office/drawing/2014/main" id="{F92AC85E-0955-E67D-525E-7DB582DC9E23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9364055" y="851198"/>
                        <a:ext cx="1620000" cy="2340000"/>
                      </a:xfrm>
                      <a:prstGeom prst="rect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</p:pic>
                </p:grpSp>
                <p:sp>
                  <p:nvSpPr>
                    <p:cNvPr id="42" name="Szövegdoboz 41">
                      <a:extLst>
                        <a:ext uri="{FF2B5EF4-FFF2-40B4-BE49-F238E27FC236}">
                          <a16:creationId xmlns:a16="http://schemas.microsoft.com/office/drawing/2014/main" id="{4D4A37AB-B068-2E03-D831-2506C8B3057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054668" y="2953563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15</a:t>
                      </a:r>
                    </a:p>
                  </p:txBody>
                </p:sp>
              </p:grpSp>
            </p:grpSp>
            <p:cxnSp>
              <p:nvCxnSpPr>
                <p:cNvPr id="2" name="Egyenes összekötő nyíllal 1">
                  <a:extLst>
                    <a:ext uri="{FF2B5EF4-FFF2-40B4-BE49-F238E27FC236}">
                      <a16:creationId xmlns:a16="http://schemas.microsoft.com/office/drawing/2014/main" id="{DB8F5B02-A240-219C-4E9C-FDC178CA27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515578" y="1443693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" name="Egyenes összekötő nyíllal 2">
                  <a:extLst>
                    <a:ext uri="{FF2B5EF4-FFF2-40B4-BE49-F238E27FC236}">
                      <a16:creationId xmlns:a16="http://schemas.microsoft.com/office/drawing/2014/main" id="{C032551A-DEDA-4356-FE55-C171C49119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515578" y="1817333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Egyenes összekötő nyíllal 13">
                  <a:extLst>
                    <a:ext uri="{FF2B5EF4-FFF2-40B4-BE49-F238E27FC236}">
                      <a16:creationId xmlns:a16="http://schemas.microsoft.com/office/drawing/2014/main" id="{F61FCD76-B516-DCC0-F444-E01F736C8E3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515578" y="2054494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Egyenes összekötő nyíllal 25">
                  <a:extLst>
                    <a:ext uri="{FF2B5EF4-FFF2-40B4-BE49-F238E27FC236}">
                      <a16:creationId xmlns:a16="http://schemas.microsoft.com/office/drawing/2014/main" id="{B7AC2F25-F0EF-DBB6-79E8-4DA29C590C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514151" y="2386360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Egyenes összekötő nyíllal 26">
                  <a:extLst>
                    <a:ext uri="{FF2B5EF4-FFF2-40B4-BE49-F238E27FC236}">
                      <a16:creationId xmlns:a16="http://schemas.microsoft.com/office/drawing/2014/main" id="{ECA6CF2E-A626-FF13-CD07-38B16A89532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512725" y="2641311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6" name="Egyenes összekötő nyíllal 35">
                <a:extLst>
                  <a:ext uri="{FF2B5EF4-FFF2-40B4-BE49-F238E27FC236}">
                    <a16:creationId xmlns:a16="http://schemas.microsoft.com/office/drawing/2014/main" id="{6E39419A-B206-1FC7-CED0-588437DDEEC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74310" y="1416627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Egyenes összekötő nyíllal 37">
                <a:extLst>
                  <a:ext uri="{FF2B5EF4-FFF2-40B4-BE49-F238E27FC236}">
                    <a16:creationId xmlns:a16="http://schemas.microsoft.com/office/drawing/2014/main" id="{E1874E34-5FA6-03EB-1DC8-284EF329314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74310" y="1790267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Egyenes összekötő nyíllal 54">
                <a:extLst>
                  <a:ext uri="{FF2B5EF4-FFF2-40B4-BE49-F238E27FC236}">
                    <a16:creationId xmlns:a16="http://schemas.microsoft.com/office/drawing/2014/main" id="{D53CF4BF-3F80-DD48-DB19-D1DF3631062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74310" y="2027428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Egyenes összekötő nyíllal 61">
                <a:extLst>
                  <a:ext uri="{FF2B5EF4-FFF2-40B4-BE49-F238E27FC236}">
                    <a16:creationId xmlns:a16="http://schemas.microsoft.com/office/drawing/2014/main" id="{5E21DCB3-0D1B-074D-5370-46482EF1608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72883" y="2282380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Egyenes összekötő nyíllal 64">
                <a:extLst>
                  <a:ext uri="{FF2B5EF4-FFF2-40B4-BE49-F238E27FC236}">
                    <a16:creationId xmlns:a16="http://schemas.microsoft.com/office/drawing/2014/main" id="{2214F318-1CEA-8947-5BD6-FC5E04B5AD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71457" y="2614245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7" name="Egyenes összekötő nyíllal 66">
              <a:extLst>
                <a:ext uri="{FF2B5EF4-FFF2-40B4-BE49-F238E27FC236}">
                  <a16:creationId xmlns:a16="http://schemas.microsoft.com/office/drawing/2014/main" id="{7B7904A4-C07C-98C3-3756-64D10E58E19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33042" y="1252831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Egyenes összekötő nyíllal 67">
              <a:extLst>
                <a:ext uri="{FF2B5EF4-FFF2-40B4-BE49-F238E27FC236}">
                  <a16:creationId xmlns:a16="http://schemas.microsoft.com/office/drawing/2014/main" id="{7FC150A1-3058-4B19-0CE4-6AEA50A0DFD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33042" y="1660655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Egyenes összekötő nyíllal 68">
              <a:extLst>
                <a:ext uri="{FF2B5EF4-FFF2-40B4-BE49-F238E27FC236}">
                  <a16:creationId xmlns:a16="http://schemas.microsoft.com/office/drawing/2014/main" id="{22DB7891-B8BC-225B-247E-8312674D13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33042" y="1803810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Egyenes összekötő nyíllal 69">
              <a:extLst>
                <a:ext uri="{FF2B5EF4-FFF2-40B4-BE49-F238E27FC236}">
                  <a16:creationId xmlns:a16="http://schemas.microsoft.com/office/drawing/2014/main" id="{B6FBD36F-B9AC-18BB-7445-F3883C39921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31615" y="1998940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Egyenes összekötő nyíllal 70">
              <a:extLst>
                <a:ext uri="{FF2B5EF4-FFF2-40B4-BE49-F238E27FC236}">
                  <a16:creationId xmlns:a16="http://schemas.microsoft.com/office/drawing/2014/main" id="{C11943DD-7B23-84F2-A750-9AEB313E669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30189" y="2356444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8286916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4E61EA46-CF03-FBB6-50D2-3D75129E7EDA}"/>
              </a:ext>
            </a:extLst>
          </p:cNvPr>
          <p:cNvSpPr txBox="1"/>
          <p:nvPr/>
        </p:nvSpPr>
        <p:spPr>
          <a:xfrm>
            <a:off x="68367" y="68366"/>
            <a:ext cx="2250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/>
              <a:t>Nitrotyrosine</a:t>
            </a:r>
            <a:r>
              <a:rPr lang="hu-HU" b="1" dirty="0"/>
              <a:t>:</a:t>
            </a:r>
          </a:p>
        </p:txBody>
      </p:sp>
      <p:grpSp>
        <p:nvGrpSpPr>
          <p:cNvPr id="135" name="Csoportba foglalás 134">
            <a:extLst>
              <a:ext uri="{FF2B5EF4-FFF2-40B4-BE49-F238E27FC236}">
                <a16:creationId xmlns:a16="http://schemas.microsoft.com/office/drawing/2014/main" id="{097D1641-EE25-E34B-4B37-318AC9AAA9BD}"/>
              </a:ext>
            </a:extLst>
          </p:cNvPr>
          <p:cNvGrpSpPr/>
          <p:nvPr/>
        </p:nvGrpSpPr>
        <p:grpSpPr>
          <a:xfrm>
            <a:off x="58711" y="437698"/>
            <a:ext cx="11964550" cy="4256850"/>
            <a:chOff x="58711" y="437698"/>
            <a:chExt cx="11964550" cy="4256850"/>
          </a:xfrm>
        </p:grpSpPr>
        <p:grpSp>
          <p:nvGrpSpPr>
            <p:cNvPr id="134" name="Csoportba foglalás 133">
              <a:extLst>
                <a:ext uri="{FF2B5EF4-FFF2-40B4-BE49-F238E27FC236}">
                  <a16:creationId xmlns:a16="http://schemas.microsoft.com/office/drawing/2014/main" id="{7F612669-F9A2-328E-5F4F-B47A2D81DD0D}"/>
                </a:ext>
              </a:extLst>
            </p:cNvPr>
            <p:cNvGrpSpPr/>
            <p:nvPr/>
          </p:nvGrpSpPr>
          <p:grpSpPr>
            <a:xfrm>
              <a:off x="58711" y="437698"/>
              <a:ext cx="11964550" cy="4256850"/>
              <a:chOff x="58711" y="437698"/>
              <a:chExt cx="11964550" cy="4256850"/>
            </a:xfrm>
          </p:grpSpPr>
          <p:grpSp>
            <p:nvGrpSpPr>
              <p:cNvPr id="133" name="Csoportba foglalás 132">
                <a:extLst>
                  <a:ext uri="{FF2B5EF4-FFF2-40B4-BE49-F238E27FC236}">
                    <a16:creationId xmlns:a16="http://schemas.microsoft.com/office/drawing/2014/main" id="{A798B024-904B-4A83-31F4-979170F2E782}"/>
                  </a:ext>
                </a:extLst>
              </p:cNvPr>
              <p:cNvGrpSpPr/>
              <p:nvPr/>
            </p:nvGrpSpPr>
            <p:grpSpPr>
              <a:xfrm>
                <a:off x="58711" y="437698"/>
                <a:ext cx="11964550" cy="4256850"/>
                <a:chOff x="68367" y="437698"/>
                <a:chExt cx="11964550" cy="4256850"/>
              </a:xfrm>
            </p:grpSpPr>
            <p:sp>
              <p:nvSpPr>
                <p:cNvPr id="79" name="Szövegdoboz 78">
                  <a:extLst>
                    <a:ext uri="{FF2B5EF4-FFF2-40B4-BE49-F238E27FC236}">
                      <a16:creationId xmlns:a16="http://schemas.microsoft.com/office/drawing/2014/main" id="{23B2F42B-B71E-4FDC-8CAC-8692249AB5B2}"/>
                    </a:ext>
                  </a:extLst>
                </p:cNvPr>
                <p:cNvSpPr txBox="1"/>
                <p:nvPr/>
              </p:nvSpPr>
              <p:spPr>
                <a:xfrm>
                  <a:off x="7848492" y="3345071"/>
                  <a:ext cx="4700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DMSO</a:t>
                  </a:r>
                </a:p>
              </p:txBody>
            </p:sp>
            <p:sp>
              <p:nvSpPr>
                <p:cNvPr id="81" name="Szövegdoboz 80">
                  <a:extLst>
                    <a:ext uri="{FF2B5EF4-FFF2-40B4-BE49-F238E27FC236}">
                      <a16:creationId xmlns:a16="http://schemas.microsoft.com/office/drawing/2014/main" id="{3A4B952A-F654-ADA8-3F10-FA320782E273}"/>
                    </a:ext>
                  </a:extLst>
                </p:cNvPr>
                <p:cNvSpPr txBox="1"/>
                <p:nvPr/>
              </p:nvSpPr>
              <p:spPr>
                <a:xfrm>
                  <a:off x="8483895" y="3351407"/>
                  <a:ext cx="45717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UDCA</a:t>
                  </a:r>
                </a:p>
              </p:txBody>
            </p:sp>
            <p:grpSp>
              <p:nvGrpSpPr>
                <p:cNvPr id="131" name="Csoportba foglalás 130">
                  <a:extLst>
                    <a:ext uri="{FF2B5EF4-FFF2-40B4-BE49-F238E27FC236}">
                      <a16:creationId xmlns:a16="http://schemas.microsoft.com/office/drawing/2014/main" id="{62E2944B-926C-224C-0893-7853845DFD50}"/>
                    </a:ext>
                  </a:extLst>
                </p:cNvPr>
                <p:cNvGrpSpPr/>
                <p:nvPr/>
              </p:nvGrpSpPr>
              <p:grpSpPr>
                <a:xfrm>
                  <a:off x="68367" y="437698"/>
                  <a:ext cx="11964550" cy="4256850"/>
                  <a:chOff x="68367" y="437698"/>
                  <a:chExt cx="11964550" cy="4256850"/>
                </a:xfrm>
              </p:grpSpPr>
              <p:sp>
                <p:nvSpPr>
                  <p:cNvPr id="88" name="Szövegdoboz 87">
                    <a:extLst>
                      <a:ext uri="{FF2B5EF4-FFF2-40B4-BE49-F238E27FC236}">
                        <a16:creationId xmlns:a16="http://schemas.microsoft.com/office/drawing/2014/main" id="{5F2728BF-071F-557F-4187-DD919346DC7F}"/>
                      </a:ext>
                    </a:extLst>
                  </p:cNvPr>
                  <p:cNvSpPr txBox="1"/>
                  <p:nvPr/>
                </p:nvSpPr>
                <p:spPr>
                  <a:xfrm>
                    <a:off x="7135752" y="4306431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35</a:t>
                    </a:r>
                  </a:p>
                </p:txBody>
              </p:sp>
              <p:sp>
                <p:nvSpPr>
                  <p:cNvPr id="89" name="Szövegdoboz 88">
                    <a:extLst>
                      <a:ext uri="{FF2B5EF4-FFF2-40B4-BE49-F238E27FC236}">
                        <a16:creationId xmlns:a16="http://schemas.microsoft.com/office/drawing/2014/main" id="{0B024926-B429-0016-8646-D5F84D58FA22}"/>
                      </a:ext>
                    </a:extLst>
                  </p:cNvPr>
                  <p:cNvSpPr txBox="1"/>
                  <p:nvPr/>
                </p:nvSpPr>
                <p:spPr>
                  <a:xfrm>
                    <a:off x="7136123" y="3545084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55</a:t>
                    </a:r>
                  </a:p>
                </p:txBody>
              </p:sp>
              <p:sp>
                <p:nvSpPr>
                  <p:cNvPr id="91" name="Szövegdoboz 90">
                    <a:extLst>
                      <a:ext uri="{FF2B5EF4-FFF2-40B4-BE49-F238E27FC236}">
                        <a16:creationId xmlns:a16="http://schemas.microsoft.com/office/drawing/2014/main" id="{F080AA08-7C10-0B1D-D0E3-213A362721F6}"/>
                      </a:ext>
                    </a:extLst>
                  </p:cNvPr>
                  <p:cNvSpPr txBox="1"/>
                  <p:nvPr/>
                </p:nvSpPr>
                <p:spPr>
                  <a:xfrm>
                    <a:off x="7092327" y="843245"/>
                    <a:ext cx="3481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250</a:t>
                    </a:r>
                  </a:p>
                </p:txBody>
              </p:sp>
              <p:sp>
                <p:nvSpPr>
                  <p:cNvPr id="92" name="Szövegdoboz 91">
                    <a:extLst>
                      <a:ext uri="{FF2B5EF4-FFF2-40B4-BE49-F238E27FC236}">
                        <a16:creationId xmlns:a16="http://schemas.microsoft.com/office/drawing/2014/main" id="{2BA56BF0-410C-3785-F052-4F866C0670E5}"/>
                      </a:ext>
                    </a:extLst>
                  </p:cNvPr>
                  <p:cNvSpPr txBox="1"/>
                  <p:nvPr/>
                </p:nvSpPr>
                <p:spPr>
                  <a:xfrm>
                    <a:off x="7084468" y="1118196"/>
                    <a:ext cx="3481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130</a:t>
                    </a:r>
                  </a:p>
                </p:txBody>
              </p:sp>
              <p:sp>
                <p:nvSpPr>
                  <p:cNvPr id="93" name="Szövegdoboz 92">
                    <a:extLst>
                      <a:ext uri="{FF2B5EF4-FFF2-40B4-BE49-F238E27FC236}">
                        <a16:creationId xmlns:a16="http://schemas.microsoft.com/office/drawing/2014/main" id="{1208E93D-29E5-84CF-9785-4686C6248167}"/>
                      </a:ext>
                    </a:extLst>
                  </p:cNvPr>
                  <p:cNvSpPr txBox="1"/>
                  <p:nvPr/>
                </p:nvSpPr>
                <p:spPr>
                  <a:xfrm>
                    <a:off x="7076611" y="1383720"/>
                    <a:ext cx="3481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100</a:t>
                    </a:r>
                  </a:p>
                </p:txBody>
              </p:sp>
              <p:sp>
                <p:nvSpPr>
                  <p:cNvPr id="97" name="Szövegdoboz 96">
                    <a:extLst>
                      <a:ext uri="{FF2B5EF4-FFF2-40B4-BE49-F238E27FC236}">
                        <a16:creationId xmlns:a16="http://schemas.microsoft.com/office/drawing/2014/main" id="{DB6DFAF2-5FCA-4EF4-EACA-9BEFC6581B28}"/>
                      </a:ext>
                    </a:extLst>
                  </p:cNvPr>
                  <p:cNvSpPr txBox="1"/>
                  <p:nvPr/>
                </p:nvSpPr>
                <p:spPr>
                  <a:xfrm>
                    <a:off x="7144168" y="1668098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70</a:t>
                    </a:r>
                  </a:p>
                </p:txBody>
              </p:sp>
              <p:sp>
                <p:nvSpPr>
                  <p:cNvPr id="98" name="Szövegdoboz 97">
                    <a:extLst>
                      <a:ext uri="{FF2B5EF4-FFF2-40B4-BE49-F238E27FC236}">
                        <a16:creationId xmlns:a16="http://schemas.microsoft.com/office/drawing/2014/main" id="{7DBA96E5-EE1E-7EB2-8077-C49AF45C5E01}"/>
                      </a:ext>
                    </a:extLst>
                  </p:cNvPr>
                  <p:cNvSpPr txBox="1"/>
                  <p:nvPr/>
                </p:nvSpPr>
                <p:spPr>
                  <a:xfrm>
                    <a:off x="7145737" y="2075023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55</a:t>
                    </a:r>
                  </a:p>
                </p:txBody>
              </p:sp>
              <p:sp>
                <p:nvSpPr>
                  <p:cNvPr id="100" name="Szövegdoboz 99">
                    <a:extLst>
                      <a:ext uri="{FF2B5EF4-FFF2-40B4-BE49-F238E27FC236}">
                        <a16:creationId xmlns:a16="http://schemas.microsoft.com/office/drawing/2014/main" id="{471E4A1E-D92C-005C-3442-D17520036736}"/>
                      </a:ext>
                    </a:extLst>
                  </p:cNvPr>
                  <p:cNvSpPr txBox="1"/>
                  <p:nvPr/>
                </p:nvSpPr>
                <p:spPr>
                  <a:xfrm>
                    <a:off x="7166159" y="2689336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35</a:t>
                    </a:r>
                  </a:p>
                </p:txBody>
              </p:sp>
              <p:sp>
                <p:nvSpPr>
                  <p:cNvPr id="101" name="Szövegdoboz 100">
                    <a:extLst>
                      <a:ext uri="{FF2B5EF4-FFF2-40B4-BE49-F238E27FC236}">
                        <a16:creationId xmlns:a16="http://schemas.microsoft.com/office/drawing/2014/main" id="{8B0B7624-14C3-6F76-B211-D38E6CAA8C8D}"/>
                      </a:ext>
                    </a:extLst>
                  </p:cNvPr>
                  <p:cNvSpPr txBox="1"/>
                  <p:nvPr/>
                </p:nvSpPr>
                <p:spPr>
                  <a:xfrm>
                    <a:off x="7148874" y="3058552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25</a:t>
                    </a:r>
                  </a:p>
                </p:txBody>
              </p:sp>
              <p:grpSp>
                <p:nvGrpSpPr>
                  <p:cNvPr id="130" name="Csoportba foglalás 129">
                    <a:extLst>
                      <a:ext uri="{FF2B5EF4-FFF2-40B4-BE49-F238E27FC236}">
                        <a16:creationId xmlns:a16="http://schemas.microsoft.com/office/drawing/2014/main" id="{5DF9DA8A-848B-2F76-EEFA-D4CDD198813E}"/>
                      </a:ext>
                    </a:extLst>
                  </p:cNvPr>
                  <p:cNvGrpSpPr/>
                  <p:nvPr/>
                </p:nvGrpSpPr>
                <p:grpSpPr>
                  <a:xfrm>
                    <a:off x="68367" y="437698"/>
                    <a:ext cx="11964550" cy="4256850"/>
                    <a:chOff x="68367" y="437698"/>
                    <a:chExt cx="11964550" cy="4256850"/>
                  </a:xfrm>
                </p:grpSpPr>
                <p:sp>
                  <p:nvSpPr>
                    <p:cNvPr id="83" name="Szövegdoboz 82">
                      <a:extLst>
                        <a:ext uri="{FF2B5EF4-FFF2-40B4-BE49-F238E27FC236}">
                          <a16:creationId xmlns:a16="http://schemas.microsoft.com/office/drawing/2014/main" id="{4128A934-D5D0-5096-1B50-3D0E034BC8C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842376" y="692008"/>
                      <a:ext cx="47000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DMSO</a:t>
                      </a:r>
                    </a:p>
                  </p:txBody>
                </p:sp>
                <p:sp>
                  <p:nvSpPr>
                    <p:cNvPr id="84" name="Szövegdoboz 83">
                      <a:extLst>
                        <a:ext uri="{FF2B5EF4-FFF2-40B4-BE49-F238E27FC236}">
                          <a16:creationId xmlns:a16="http://schemas.microsoft.com/office/drawing/2014/main" id="{36FDC535-6900-BE45-6A03-5D77C901EF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515478" y="679489"/>
                      <a:ext cx="45717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UDCA</a:t>
                      </a:r>
                    </a:p>
                  </p:txBody>
                </p:sp>
                <p:sp>
                  <p:nvSpPr>
                    <p:cNvPr id="85" name="Szövegdoboz 84">
                      <a:extLst>
                        <a:ext uri="{FF2B5EF4-FFF2-40B4-BE49-F238E27FC236}">
                          <a16:creationId xmlns:a16="http://schemas.microsoft.com/office/drawing/2014/main" id="{191D5E78-A9FE-36D8-A141-A51EFBE6DF3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83154" y="449511"/>
                      <a:ext cx="33534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1400" b="1" dirty="0"/>
                        <a:t>3.</a:t>
                      </a:r>
                    </a:p>
                  </p:txBody>
                </p:sp>
                <p:grpSp>
                  <p:nvGrpSpPr>
                    <p:cNvPr id="114" name="Csoportba foglalás 113">
                      <a:extLst>
                        <a:ext uri="{FF2B5EF4-FFF2-40B4-BE49-F238E27FC236}">
                          <a16:creationId xmlns:a16="http://schemas.microsoft.com/office/drawing/2014/main" id="{460D6644-F3B7-2EDF-A699-B2974958A10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7" y="437698"/>
                      <a:ext cx="11964550" cy="4256850"/>
                      <a:chOff x="68367" y="437698"/>
                      <a:chExt cx="11964550" cy="4256850"/>
                    </a:xfrm>
                  </p:grpSpPr>
                  <p:grpSp>
                    <p:nvGrpSpPr>
                      <p:cNvPr id="113" name="Csoportba foglalás 112">
                        <a:extLst>
                          <a:ext uri="{FF2B5EF4-FFF2-40B4-BE49-F238E27FC236}">
                            <a16:creationId xmlns:a16="http://schemas.microsoft.com/office/drawing/2014/main" id="{70DC482E-9314-67AC-75E4-80B732E0020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7" y="437698"/>
                        <a:ext cx="11964550" cy="4256850"/>
                        <a:chOff x="68367" y="437698"/>
                        <a:chExt cx="11964550" cy="4256850"/>
                      </a:xfrm>
                    </p:grpSpPr>
                    <p:grpSp>
                      <p:nvGrpSpPr>
                        <p:cNvPr id="68" name="Csoportba foglalás 67">
                          <a:extLst>
                            <a:ext uri="{FF2B5EF4-FFF2-40B4-BE49-F238E27FC236}">
                              <a16:creationId xmlns:a16="http://schemas.microsoft.com/office/drawing/2014/main" id="{FCECE2B4-9FEB-B204-2472-94643D23166E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7" y="437698"/>
                          <a:ext cx="11964550" cy="4256850"/>
                          <a:chOff x="68367" y="437698"/>
                          <a:chExt cx="11964550" cy="4256850"/>
                        </a:xfrm>
                      </p:grpSpPr>
                      <p:grpSp>
                        <p:nvGrpSpPr>
                          <p:cNvPr id="65" name="Csoportba foglalás 64">
                            <a:extLst>
                              <a:ext uri="{FF2B5EF4-FFF2-40B4-BE49-F238E27FC236}">
                                <a16:creationId xmlns:a16="http://schemas.microsoft.com/office/drawing/2014/main" id="{66B8B9ED-EC38-40E1-A999-125B5A6FCA5A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7" y="437698"/>
                            <a:ext cx="11964550" cy="4256850"/>
                            <a:chOff x="68367" y="437698"/>
                            <a:chExt cx="11964550" cy="4256850"/>
                          </a:xfrm>
                        </p:grpSpPr>
                        <p:grpSp>
                          <p:nvGrpSpPr>
                            <p:cNvPr id="44" name="Csoportba foglalás 43">
                              <a:extLst>
                                <a:ext uri="{FF2B5EF4-FFF2-40B4-BE49-F238E27FC236}">
                                  <a16:creationId xmlns:a16="http://schemas.microsoft.com/office/drawing/2014/main" id="{5541E771-60B5-ED8D-221C-64250992CCD4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7" y="437698"/>
                              <a:ext cx="11964550" cy="4256850"/>
                              <a:chOff x="68367" y="437698"/>
                              <a:chExt cx="11964550" cy="4256850"/>
                            </a:xfrm>
                          </p:grpSpPr>
                          <p:grpSp>
                            <p:nvGrpSpPr>
                              <p:cNvPr id="12" name="Csoportba foglalás 11">
                                <a:extLst>
                                  <a:ext uri="{FF2B5EF4-FFF2-40B4-BE49-F238E27FC236}">
                                    <a16:creationId xmlns:a16="http://schemas.microsoft.com/office/drawing/2014/main" id="{BDF13394-5C3F-6B55-B905-C5ABB503F6FF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7" y="437698"/>
                                <a:ext cx="11964550" cy="4256850"/>
                                <a:chOff x="68367" y="437698"/>
                                <a:chExt cx="11964550" cy="4256850"/>
                              </a:xfrm>
                            </p:grpSpPr>
                            <p:grpSp>
                              <p:nvGrpSpPr>
                                <p:cNvPr id="129" name="Csoportba foglalás 128">
                                  <a:extLst>
                                    <a:ext uri="{FF2B5EF4-FFF2-40B4-BE49-F238E27FC236}">
                                      <a16:creationId xmlns:a16="http://schemas.microsoft.com/office/drawing/2014/main" id="{5520BFF5-8A90-0445-343E-1A426AB1C18E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8367" y="437698"/>
                                  <a:ext cx="11964550" cy="4256850"/>
                                  <a:chOff x="68367" y="378270"/>
                                  <a:chExt cx="11964550" cy="4256850"/>
                                </a:xfrm>
                              </p:grpSpPr>
                              <p:grpSp>
                                <p:nvGrpSpPr>
                                  <p:cNvPr id="102" name="Csoportba foglalás 101">
                                    <a:extLst>
                                      <a:ext uri="{FF2B5EF4-FFF2-40B4-BE49-F238E27FC236}">
                                        <a16:creationId xmlns:a16="http://schemas.microsoft.com/office/drawing/2014/main" id="{2093C254-E0DA-7308-383C-98B07D39683E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8367" y="378270"/>
                                    <a:ext cx="11964550" cy="4256850"/>
                                    <a:chOff x="68367" y="378270"/>
                                    <a:chExt cx="11964550" cy="4256850"/>
                                  </a:xfrm>
                                </p:grpSpPr>
                                <p:grpSp>
                                  <p:nvGrpSpPr>
                                    <p:cNvPr id="61" name="Csoportba foglalás 60">
                                      <a:extLst>
                                        <a:ext uri="{FF2B5EF4-FFF2-40B4-BE49-F238E27FC236}">
                                          <a16:creationId xmlns:a16="http://schemas.microsoft.com/office/drawing/2014/main" id="{36FDC435-F37D-965C-CF10-8F2CBC0071F1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8367" y="378270"/>
                                      <a:ext cx="11964550" cy="4256850"/>
                                      <a:chOff x="68367" y="378270"/>
                                      <a:chExt cx="11964550" cy="4256850"/>
                                    </a:xfrm>
                                  </p:grpSpPr>
                                  <p:grpSp>
                                    <p:nvGrpSpPr>
                                      <p:cNvPr id="77" name="Csoportba foglalás 76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C569ACAC-D16B-0D65-7D7D-1F76F44BC39F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8367" y="378270"/>
                                        <a:ext cx="11964550" cy="4256850"/>
                                        <a:chOff x="68367" y="378270"/>
                                        <a:chExt cx="11964550" cy="4256850"/>
                                      </a:xfrm>
                                    </p:grpSpPr>
                                    <p:grpSp>
                                      <p:nvGrpSpPr>
                                        <p:cNvPr id="33" name="Csoportba foglalás 32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74234755-A58A-362A-7964-89361751F9AD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8367" y="378270"/>
                                          <a:ext cx="11964550" cy="4256850"/>
                                          <a:chOff x="68367" y="378270"/>
                                          <a:chExt cx="11964550" cy="4256850"/>
                                        </a:xfrm>
                                      </p:grpSpPr>
                                      <p:grpSp>
                                        <p:nvGrpSpPr>
                                          <p:cNvPr id="22" name="Csoportba foglalás 21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BEE41243-DEF0-695A-74F2-20214D9B4C58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68367" y="378270"/>
                                            <a:ext cx="11964550" cy="4256850"/>
                                            <a:chOff x="68367" y="378270"/>
                                            <a:chExt cx="11964550" cy="4256850"/>
                                          </a:xfrm>
                                        </p:grpSpPr>
                                        <p:grpSp>
                                          <p:nvGrpSpPr>
                                            <p:cNvPr id="82" name="Csoportba foglalás 81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E4D819F0-F49E-F51F-1614-D4572937A902}"/>
                                                </a:ext>
                                              </a:extLst>
                                            </p:cNvPr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68367" y="378270"/>
                                              <a:ext cx="11964550" cy="4256850"/>
                                              <a:chOff x="68367" y="378270"/>
                                              <a:chExt cx="11964550" cy="4256850"/>
                                            </a:xfrm>
                                          </p:grpSpPr>
                                          <p:grpSp>
                                            <p:nvGrpSpPr>
                                              <p:cNvPr id="76" name="Csoportba foglalás 75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07F847BE-36B5-68B3-4646-5E2854D87DFD}"/>
                                                  </a:ext>
                                                </a:extLst>
                                              </p:cNvPr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68367" y="378270"/>
                                                <a:ext cx="11964550" cy="4256850"/>
                                                <a:chOff x="68367" y="378270"/>
                                                <a:chExt cx="11964550" cy="4256850"/>
                                              </a:xfrm>
                                            </p:grpSpPr>
                                            <p:grpSp>
                                              <p:nvGrpSpPr>
                                                <p:cNvPr id="64" name="Csoportba foglalás 63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99070FB3-458C-B6BA-F426-7CBE7ACAB0A8}"/>
                                                    </a:ext>
                                                  </a:extLst>
                                                </p:cNvPr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68367" y="378270"/>
                                                  <a:ext cx="11964550" cy="4256850"/>
                                                  <a:chOff x="68367" y="378270"/>
                                                  <a:chExt cx="11964550" cy="4256850"/>
                                                </a:xfrm>
                                              </p:grpSpPr>
                                              <p:grpSp>
                                                <p:nvGrpSpPr>
                                                  <p:cNvPr id="59" name="Csoportba foglalás 58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D69FBEC8-63C6-D8A3-6667-5AB6865BEE97}"/>
                                                      </a:ext>
                                                    </a:extLst>
                                                  </p:cNvPr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68367" y="378270"/>
                                                    <a:ext cx="11964550" cy="4256850"/>
                                                    <a:chOff x="68367" y="378270"/>
                                                    <a:chExt cx="11964550" cy="4256850"/>
                                                  </a:xfrm>
                                                </p:grpSpPr>
                                                <p:grpSp>
                                                  <p:nvGrpSpPr>
                                                    <p:cNvPr id="5" name="Csoportba foglalás 4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666EC76C-2260-6217-0624-8D898ED5A4E4}"/>
                                                        </a:ext>
                                                      </a:extLst>
                                                    </p:cNvPr>
                                                    <p:cNvGrpSpPr/>
                                                    <p:nvPr/>
                                                  </p:nvGrpSpPr>
                                                  <p:grpSpPr>
                                                    <a:xfrm>
                                                      <a:off x="68367" y="378270"/>
                                                      <a:ext cx="11964550" cy="4256850"/>
                                                      <a:chOff x="68367" y="378270"/>
                                                      <a:chExt cx="11964550" cy="4256850"/>
                                                    </a:xfrm>
                                                  </p:grpSpPr>
                                                  <p:sp>
                                                    <p:nvSpPr>
                                                      <p:cNvPr id="6" name="Szövegdoboz 5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1EE92C5E-E4EC-2CEC-670B-01AFCBAF0098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5226271" y="3293501"/>
                                                        <a:ext cx="470000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DMSO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7" name="Szövegdoboz 6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DCA53139-B3EF-2478-66CC-2DBFD2DA811A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5871101" y="3290410"/>
                                                        <a:ext cx="457176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UDCA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8" name="Szövegdoboz 7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59B18E5D-9CAA-1B96-B3D8-B587D74C772B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2278218" y="3294565"/>
                                                        <a:ext cx="470000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DMSO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9" name="Szövegdoboz 8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CBA7CB9F-0B07-F693-FF24-6BAB2FD09EA9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2875917" y="3291475"/>
                                                        <a:ext cx="457176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UDCA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10" name="Szövegdoboz 9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26D52466-16B5-4210-DBA7-126A8D1CC5F2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10704907" y="3285007"/>
                                                        <a:ext cx="470000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DMSO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11" name="Szövegdoboz 10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E1C1C8CB-BEF3-799C-6817-7756DC67E587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11320576" y="3289320"/>
                                                        <a:ext cx="457176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UDCA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grpSp>
                                                    <p:nvGrpSpPr>
                                                      <p:cNvPr id="13" name="Csoportba foglalás 12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F7953510-80C4-08DE-5F12-30E0E9381EFE}"/>
                                                          </a:ext>
                                                        </a:extLst>
                                                      </p:cNvPr>
                                                      <p:cNvGrpSpPr/>
                                                      <p:nvPr/>
                                                    </p:nvGrpSpPr>
                                                    <p:grpSpPr>
                                                      <a:xfrm>
                                                        <a:off x="68367" y="378270"/>
                                                        <a:ext cx="11964550" cy="4256850"/>
                                                        <a:chOff x="68367" y="378270"/>
                                                        <a:chExt cx="11964550" cy="4256850"/>
                                                      </a:xfrm>
                                                    </p:grpSpPr>
                                                    <p:grpSp>
                                                      <p:nvGrpSpPr>
                                                        <p:cNvPr id="17" name="Csoportba foglalás 16">
                                                          <a:extLst>
                                                            <a:ext uri="{FF2B5EF4-FFF2-40B4-BE49-F238E27FC236}">
                                                              <a16:creationId xmlns:a16="http://schemas.microsoft.com/office/drawing/2014/main" id="{D2869022-5E02-D495-459D-4C73CF0945AD}"/>
                                                            </a:ext>
                                                          </a:extLst>
                                                        </p:cNvPr>
                                                        <p:cNvGrpSpPr/>
                                                        <p:nvPr/>
                                                      </p:nvGrpSpPr>
                                                      <p:grpSpPr>
                                                        <a:xfrm>
                                                          <a:off x="68367" y="378270"/>
                                                          <a:ext cx="11964550" cy="4256850"/>
                                                          <a:chOff x="68367" y="378270"/>
                                                          <a:chExt cx="11964550" cy="4256850"/>
                                                        </a:xfrm>
                                                      </p:grpSpPr>
                                                      <p:sp>
                                                        <p:nvSpPr>
                                                          <p:cNvPr id="24" name="Szövegdoboz 23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id="{9DBE9E64-7749-5286-A934-87C2DA3328AA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SpPr txBox="1"/>
                                                          <p:nvPr/>
                                                        </p:nvSpPr>
                                                        <p:spPr>
                                                          <a:xfrm>
                                                            <a:off x="5182446" y="621584"/>
                                                            <a:ext cx="470000" cy="215444"/>
                                                          </a:xfrm>
                                                          <a:prstGeom prst="rect">
                                                            <a:avLst/>
                                                          </a:prstGeom>
                                                          <a:noFill/>
                                                        </p:spPr>
                                                        <p:txBody>
                                                          <a:bodyPr wrap="none" rtlCol="0">
                                                            <a:spAutoFit/>
                                                          </a:bodyPr>
                                                          <a:lstStyle/>
                                                          <a:p>
                                                            <a:r>
                                                              <a:rPr lang="hu-HU" sz="800" dirty="0"/>
                                                              <a:t>DMSO</a:t>
                                                            </a:r>
                                                          </a:p>
                                                        </p:txBody>
                                                      </p:sp>
                                                      <p:sp>
                                                        <p:nvSpPr>
                                                          <p:cNvPr id="25" name="Szövegdoboz 24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id="{74AB1839-0AF7-9320-D373-719005F5B9E5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SpPr txBox="1"/>
                                                          <p:nvPr/>
                                                        </p:nvSpPr>
                                                        <p:spPr>
                                                          <a:xfrm>
                                                            <a:off x="5827268" y="618492"/>
                                                            <a:ext cx="457176" cy="215444"/>
                                                          </a:xfrm>
                                                          <a:prstGeom prst="rect">
                                                            <a:avLst/>
                                                          </a:prstGeom>
                                                          <a:noFill/>
                                                        </p:spPr>
                                                        <p:txBody>
                                                          <a:bodyPr wrap="none" rtlCol="0">
                                                            <a:spAutoFit/>
                                                          </a:bodyPr>
                                                          <a:lstStyle/>
                                                          <a:p>
                                                            <a:r>
                                                              <a:rPr lang="hu-HU" sz="800" dirty="0"/>
                                                              <a:t>UDCA</a:t>
                                                            </a:r>
                                                          </a:p>
                                                        </p:txBody>
                                                      </p:sp>
                                                      <p:grpSp>
                                                        <p:nvGrpSpPr>
                                                          <p:cNvPr id="40" name="Csoportba foglalás 39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id="{AD74C5FA-955A-53AC-A5DE-7102165BBD28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GrpSpPr/>
                                                          <p:nvPr/>
                                                        </p:nvGrpSpPr>
                                                        <p:grpSpPr>
                                                          <a:xfrm>
                                                            <a:off x="68367" y="378270"/>
                                                            <a:ext cx="11964550" cy="4256850"/>
                                                            <a:chOff x="68367" y="415477"/>
                                                            <a:chExt cx="11964550" cy="4256850"/>
                                                          </a:xfrm>
                                                        </p:grpSpPr>
                                                        <p:sp>
                                                          <p:nvSpPr>
                                                            <p:cNvPr id="45" name="Szövegdoboz 44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id="{66D3585D-B626-E2C5-481E-54A1670C3C57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68367" y="869125"/>
                                                              <a:ext cx="1271179" cy="307777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squar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r>
                                                                <a:rPr lang="hu-HU" sz="1400" dirty="0" err="1"/>
                                                                <a:t>Nitrotyrosine</a:t>
                                                              </a:r>
                                                              <a:r>
                                                                <a:rPr lang="hu-HU" sz="1400" dirty="0"/>
                                                                <a:t>:</a:t>
                                                              </a:r>
                                                            </a:p>
                                                          </p:txBody>
                                                        </p:sp>
                                                        <p:sp>
                                                          <p:nvSpPr>
                                                            <p:cNvPr id="46" name="Szövegdoboz 45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id="{D28978E5-AA9F-8E23-7150-26C97BBEA88B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68367" y="3653777"/>
                                                              <a:ext cx="803304" cy="307777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squar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r>
                                                                <a:rPr lang="hu-HU" sz="1400" dirty="0"/>
                                                                <a:t>β-</a:t>
                                                              </a:r>
                                                              <a:r>
                                                                <a:rPr lang="hu-HU" sz="1400" dirty="0" err="1"/>
                                                                <a:t>actin</a:t>
                                                              </a:r>
                                                              <a:r>
                                                                <a:rPr lang="hu-HU" sz="1400" dirty="0"/>
                                                                <a:t>:</a:t>
                                                              </a:r>
                                                            </a:p>
                                                          </p:txBody>
                                                        </p:sp>
                                                        <p:grpSp>
                                                          <p:nvGrpSpPr>
                                                            <p:cNvPr id="47" name="Csoportba foglalás 46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id="{ECC78131-FA46-9B9E-121A-F2AFAC1773DF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GrpSpPr/>
                                                            <p:nvPr/>
                                                          </p:nvGrpSpPr>
                                                          <p:grpSpPr>
                                                            <a:xfrm>
                                                              <a:off x="2310554" y="415641"/>
                                                              <a:ext cx="1064298" cy="471695"/>
                                                              <a:chOff x="2310554" y="415641"/>
                                                              <a:chExt cx="1064298" cy="471695"/>
                                                            </a:xfrm>
                                                          </p:grpSpPr>
                                                          <p:grpSp>
                                                            <p:nvGrpSpPr>
                                                              <p:cNvPr id="51" name="Csoportba foglalás 50">
                                                                <a:extLst>
                                                                  <a:ext uri="{FF2B5EF4-FFF2-40B4-BE49-F238E27FC236}">
                                                                    <a16:creationId xmlns:a16="http://schemas.microsoft.com/office/drawing/2014/main" id="{D1F86804-959C-FDB1-6496-7E5C944541AE}"/>
                                                                  </a:ext>
                                                                </a:extLst>
                                                              </p:cNvPr>
                                                              <p:cNvGrpSpPr/>
                                                              <p:nvPr/>
                                                            </p:nvGrpSpPr>
                                                            <p:grpSpPr>
                                                              <a:xfrm>
                                                                <a:off x="2310554" y="665557"/>
                                                                <a:ext cx="1064298" cy="221779"/>
                                                                <a:chOff x="2310554" y="289547"/>
                                                                <a:chExt cx="1064298" cy="221779"/>
                                                              </a:xfrm>
                                                            </p:grpSpPr>
                                                            <p:sp>
                                                              <p:nvSpPr>
                                                                <p:cNvPr id="53" name="Szövegdoboz 52">
                                                                  <a:extLst>
                                                                    <a:ext uri="{FF2B5EF4-FFF2-40B4-BE49-F238E27FC236}">
                                                                      <a16:creationId xmlns:a16="http://schemas.microsoft.com/office/drawing/2014/main" id="{4185ACB4-2E26-53E4-7817-E9EC98D80B21}"/>
                                                                    </a:ext>
                                                                  </a:extLst>
                                                                </p:cNvPr>
                                                                <p:cNvSpPr txBox="1"/>
                                                                <p:nvPr/>
                                                              </p:nvSpPr>
                                                              <p:spPr>
                                                                <a:xfrm>
                                                                  <a:off x="2310554" y="289547"/>
                                                                  <a:ext cx="470000" cy="215444"/>
                                                                </a:xfrm>
                                                                <a:prstGeom prst="rect">
                                                                  <a:avLst/>
                                                                </a:prstGeom>
                                                                <a:noFill/>
                                                              </p:spPr>
                                                              <p:txBody>
                                                                <a:bodyPr wrap="none" rtlCol="0">
                                                                  <a:spAutoFit/>
                                                                </a:bodyPr>
                                                                <a:lstStyle/>
                                                                <a:p>
                                                                  <a:r>
                                                                    <a:rPr lang="hu-HU" sz="800" dirty="0"/>
                                                                    <a:t>DMSO</a:t>
                                                                  </a:r>
                                                                </a:p>
                                                              </p:txBody>
                                                            </p:sp>
                                                            <p:sp>
                                                              <p:nvSpPr>
                                                                <p:cNvPr id="54" name="Szövegdoboz 53">
                                                                  <a:extLst>
                                                                    <a:ext uri="{FF2B5EF4-FFF2-40B4-BE49-F238E27FC236}">
                                                                      <a16:creationId xmlns:a16="http://schemas.microsoft.com/office/drawing/2014/main" id="{FBEA5532-CAE2-88D1-FBDE-A57D01FAD56E}"/>
                                                                    </a:ext>
                                                                  </a:extLst>
                                                                </p:cNvPr>
                                                                <p:cNvSpPr txBox="1"/>
                                                                <p:nvPr/>
                                                              </p:nvSpPr>
                                                              <p:spPr>
                                                                <a:xfrm>
                                                                  <a:off x="2917676" y="295882"/>
                                                                  <a:ext cx="457176" cy="215444"/>
                                                                </a:xfrm>
                                                                <a:prstGeom prst="rect">
                                                                  <a:avLst/>
                                                                </a:prstGeom>
                                                                <a:noFill/>
                                                              </p:spPr>
                                                              <p:txBody>
                                                                <a:bodyPr wrap="none" rtlCol="0">
                                                                  <a:spAutoFit/>
                                                                </a:bodyPr>
                                                                <a:lstStyle/>
                                                                <a:p>
                                                                  <a:r>
                                                                    <a:rPr lang="hu-HU" sz="800" dirty="0"/>
                                                                    <a:t>UDCA</a:t>
                                                                  </a:r>
                                                                </a:p>
                                                              </p:txBody>
                                                            </p:sp>
                                                          </p:grpSp>
                                                          <p:sp>
                                                            <p:nvSpPr>
                                                              <p:cNvPr id="52" name="Szövegdoboz 51">
                                                                <a:extLst>
                                                                  <a:ext uri="{FF2B5EF4-FFF2-40B4-BE49-F238E27FC236}">
                                                                    <a16:creationId xmlns:a16="http://schemas.microsoft.com/office/drawing/2014/main" id="{87C03FB1-0305-6610-B2F8-3AF2F9687DAF}"/>
                                                                  </a:ext>
                                                                </a:extLst>
                                                              </p:cNvPr>
                                                              <p:cNvSpPr txBox="1"/>
                                                              <p:nvPr/>
                                                            </p:nvSpPr>
                                                            <p:spPr>
                                                              <a:xfrm>
                                                                <a:off x="2533973" y="415641"/>
                                                                <a:ext cx="332142" cy="307777"/>
                                                              </a:xfrm>
                                                              <a:prstGeom prst="rect">
                                                                <a:avLst/>
                                                              </a:prstGeom>
                                                              <a:noFill/>
                                                            </p:spPr>
                                                            <p:txBody>
                                                              <a:bodyPr wrap="none" rtlCol="0">
                                                                <a:spAutoFit/>
                                                              </a:bodyPr>
                                                              <a:lstStyle/>
                                                              <a:p>
                                                                <a:r>
                                                                  <a:rPr lang="hu-HU" sz="1400" b="1" dirty="0"/>
                                                                  <a:t>1.</a:t>
                                                                </a:r>
                                                              </a:p>
                                                            </p:txBody>
                                                          </p:sp>
                                                        </p:grpSp>
                                                        <p:sp>
                                                          <p:nvSpPr>
                                                            <p:cNvPr id="48" name="Szövegdoboz 47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id="{FF8775A9-DE28-A990-FA6B-A5EA7988A5B4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5376090" y="416294"/>
                                                              <a:ext cx="335348" cy="307777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non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r>
                                                                <a:rPr lang="hu-HU" sz="1400" b="1" dirty="0"/>
                                                                <a:t>2.</a:t>
                                                              </a:r>
                                                            </a:p>
                                                          </p:txBody>
                                                        </p:sp>
                                                        <p:sp>
                                                          <p:nvSpPr>
                                                            <p:cNvPr id="49" name="Szövegdoboz 48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id="{D9333B53-470F-176B-2960-30B707B78615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10818102" y="415477"/>
                                                              <a:ext cx="335348" cy="307777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non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r>
                                                                <a:rPr lang="hu-HU" sz="1400" b="1" dirty="0"/>
                                                                <a:t>4.</a:t>
                                                              </a:r>
                                                            </a:p>
                                                          </p:txBody>
                                                        </p:sp>
                                                        <p:sp>
                                                          <p:nvSpPr>
                                                            <p:cNvPr id="50" name="Téglalap 49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id="{7EE5AF85-79AD-2E88-859A-74FA3BC508C3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SpPr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70822" y="474905"/>
                                                              <a:ext cx="11962095" cy="4197422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style>
                                                            <a:lnRef idx="2">
                                                              <a:schemeClr val="accent1">
                                                                <a:shade val="15000"/>
                                                              </a:schemeClr>
                                                            </a:lnRef>
                                                            <a:fillRef idx="1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lt1"/>
                                                            </a:fontRef>
                                                          </p:style>
                                                          <p:txBody>
                                                            <a:bodyPr rtlCol="0" anchor="ctr"/>
                                                            <a:lstStyle/>
                                                            <a:p>
                                                              <a:pPr algn="ctr"/>
                                                              <a:endParaRPr lang="hu-HU"/>
                                                            </a:p>
                                                          </p:txBody>
                                                        </p:sp>
                                                      </p:grpSp>
                                                    </p:grpSp>
                                                    <p:sp>
                                                      <p:nvSpPr>
                                                        <p:cNvPr id="19" name="Szövegdoboz 18">
                                                          <a:extLst>
                                                            <a:ext uri="{FF2B5EF4-FFF2-40B4-BE49-F238E27FC236}">
                                                              <a16:creationId xmlns:a16="http://schemas.microsoft.com/office/drawing/2014/main" id="{BF3BA821-64F9-7542-13DC-3694C7DD53BF}"/>
                                                            </a:ext>
                                                          </a:extLst>
                                                        </p:cNvPr>
                                                        <p:cNvSpPr txBox="1"/>
                                                        <p:nvPr/>
                                                      </p:nvSpPr>
                                                      <p:spPr>
                                                        <a:xfrm>
                                                          <a:off x="10708072" y="622936"/>
                                                          <a:ext cx="470000" cy="215444"/>
                                                        </a:xfrm>
                                                        <a:prstGeom prst="rect">
                                                          <a:avLst/>
                                                        </a:prstGeom>
                                                        <a:noFill/>
                                                      </p:spPr>
                                                      <p:txBody>
                                                        <a:bodyPr wrap="none" rtlCol="0">
                                                          <a:spAutoFit/>
                                                        </a:bodyPr>
                                                        <a:lstStyle/>
                                                        <a:p>
                                                          <a:r>
                                                            <a:rPr lang="hu-HU" sz="800" dirty="0"/>
                                                            <a:t>DMSO</a:t>
                                                          </a:r>
                                                        </a:p>
                                                      </p:txBody>
                                                    </p:sp>
                                                    <p:sp>
                                                      <p:nvSpPr>
                                                        <p:cNvPr id="20" name="Szövegdoboz 19">
                                                          <a:extLst>
                                                            <a:ext uri="{FF2B5EF4-FFF2-40B4-BE49-F238E27FC236}">
                                                              <a16:creationId xmlns:a16="http://schemas.microsoft.com/office/drawing/2014/main" id="{BFA7C2B5-D68F-0DB7-73EE-E123146A0886}"/>
                                                            </a:ext>
                                                          </a:extLst>
                                                        </p:cNvPr>
                                                        <p:cNvSpPr txBox="1"/>
                                                        <p:nvPr/>
                                                      </p:nvSpPr>
                                                      <p:spPr>
                                                        <a:xfrm>
                                                          <a:off x="11314329" y="627249"/>
                                                          <a:ext cx="457176" cy="215444"/>
                                                        </a:xfrm>
                                                        <a:prstGeom prst="rect">
                                                          <a:avLst/>
                                                        </a:prstGeom>
                                                        <a:noFill/>
                                                      </p:spPr>
                                                      <p:txBody>
                                                        <a:bodyPr wrap="none" rtlCol="0">
                                                          <a:spAutoFit/>
                                                        </a:bodyPr>
                                                        <a:lstStyle/>
                                                        <a:p>
                                                          <a:r>
                                                            <a:rPr lang="hu-HU" sz="800" dirty="0"/>
                                                            <a:t>UDCA</a:t>
                                                          </a:r>
                                                        </a:p>
                                                      </p:txBody>
                                                    </p:sp>
                                                  </p:grpSp>
                                                </p:grpSp>
                                                <p:sp>
                                                  <p:nvSpPr>
                                                    <p:cNvPr id="58" name="Szövegdoboz 57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0FA3A88A-7BFD-0A39-C497-4857235015E0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1461389" y="780680"/>
                                                      <a:ext cx="348172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250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</p:grpSp>
                                              <p:sp>
                                                <p:nvSpPr>
                                                  <p:cNvPr id="63" name="Szövegdoboz 62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1C6F6342-181D-2A47-4D70-C59B7A57178E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1523330" y="3475168"/>
                                                    <a:ext cx="293670" cy="215444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800" dirty="0"/>
                                                      <a:t>55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</p:grpSp>
                                            <p:sp>
                                              <p:nvSpPr>
                                                <p:cNvPr id="74" name="Szövegdoboz 73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3B0CFB52-98AD-0BAE-3F2B-AA20920D756B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4428688" y="4236007"/>
                                                  <a:ext cx="293670" cy="215444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800" dirty="0"/>
                                                    <a:t>35</a:t>
                                                  </a:r>
                                                </a:p>
                                              </p:txBody>
                                            </p:sp>
                                            <p:sp>
                                              <p:nvSpPr>
                                                <p:cNvPr id="75" name="Szövegdoboz 74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CA52119A-7028-EC42-B001-B72931896E94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4429059" y="3474660"/>
                                                  <a:ext cx="293670" cy="215444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800" dirty="0"/>
                                                    <a:t>55</a:t>
                                                  </a:r>
                                                </a:p>
                                              </p:txBody>
                                            </p:sp>
                                          </p:grpSp>
                                          <p:sp>
                                            <p:nvSpPr>
                                              <p:cNvPr id="80" name="Szövegdoboz 79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BE0AE24B-F7DA-5C43-7207-DD5032C6A0E0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9858345" y="3493712"/>
                                                <a:ext cx="293670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55</a:t>
                                                </a:r>
                                              </a:p>
                                            </p:txBody>
                                          </p:sp>
                                        </p:grpSp>
                                        <p:sp>
                                          <p:nvSpPr>
                                            <p:cNvPr id="18" name="Szövegdoboz 17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5EB4E4E8-4465-901C-0C1F-467C42EC9A2A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462957" y="1055631"/>
                                              <a:ext cx="348172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130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21" name="Szövegdoboz 20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7056F621-6DE4-7B91-184D-1C9EE20A6CD2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464527" y="1340009"/>
                                              <a:ext cx="348172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100</a:t>
                                              </a:r>
                                            </a:p>
                                          </p:txBody>
                                        </p:sp>
                                      </p:grpSp>
                                      <p:sp>
                                        <p:nvSpPr>
                                          <p:cNvPr id="32" name="Szövegdoboz 31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4E50FDCC-5278-358B-F6B8-D5CD847F8219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1524903" y="4221461"/>
                                            <a:ext cx="29367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35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  <p:sp>
                                      <p:nvSpPr>
                                        <p:cNvPr id="73" name="Szövegdoboz 72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8C45F1EF-436E-B74A-BAF6-0C9C20D9DD4E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9851218" y="4209456"/>
                                          <a:ext cx="29367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35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34" name="Szövegdoboz 33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D6188A28-89D5-0BC1-3F9E-AA1D8E4330A2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522657" y="1624387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70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56" name="Szövegdoboz 55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778D88D3-004B-40A4-8772-7C5179BFE2C8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514799" y="1965323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55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57" name="Szövegdoboz 56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B3086FA4-43ED-D397-9146-153FC02C3204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516367" y="2626771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35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60" name="Szövegdoboz 59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2A8686C0-6365-EA89-9281-2E73920E1302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517936" y="3014841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25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86" name="Szövegdoboz 85">
                                      <a:extLst>
                                        <a:ext uri="{FF2B5EF4-FFF2-40B4-BE49-F238E27FC236}">
                                          <a16:creationId xmlns:a16="http://schemas.microsoft.com/office/drawing/2014/main" id="{0693B11E-92DF-39B0-D387-D3FB051A70F1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375836" y="876518"/>
                                      <a:ext cx="348172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250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87" name="Szövegdoboz 86">
                                      <a:extLst>
                                        <a:ext uri="{FF2B5EF4-FFF2-40B4-BE49-F238E27FC236}">
                                          <a16:creationId xmlns:a16="http://schemas.microsoft.com/office/drawing/2014/main" id="{4E98C77A-06EE-4D26-5CCC-08214BE303B0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377404" y="1113761"/>
                                      <a:ext cx="348172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130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90" name="Szövegdoboz 89">
                                      <a:extLst>
                                        <a:ext uri="{FF2B5EF4-FFF2-40B4-BE49-F238E27FC236}">
                                          <a16:creationId xmlns:a16="http://schemas.microsoft.com/office/drawing/2014/main" id="{4DBB35F8-07E1-9B61-35EA-01E038C1F9BB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369547" y="1369858"/>
                                      <a:ext cx="348172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100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94" name="Szövegdoboz 93">
                                      <a:extLst>
                                        <a:ext uri="{FF2B5EF4-FFF2-40B4-BE49-F238E27FC236}">
                                          <a16:creationId xmlns:a16="http://schemas.microsoft.com/office/drawing/2014/main" id="{99386176-73FB-619A-4958-D055BA5B4A99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427677" y="1663663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70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95" name="Szövegdoboz 94">
                                      <a:extLst>
                                        <a:ext uri="{FF2B5EF4-FFF2-40B4-BE49-F238E27FC236}">
                                          <a16:creationId xmlns:a16="http://schemas.microsoft.com/office/drawing/2014/main" id="{D0C2B3E6-9AF9-8904-5746-A2176C2085BA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438673" y="1929183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55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96" name="Szövegdoboz 95">
                                      <a:extLst>
                                        <a:ext uri="{FF2B5EF4-FFF2-40B4-BE49-F238E27FC236}">
                                          <a16:creationId xmlns:a16="http://schemas.microsoft.com/office/drawing/2014/main" id="{95591784-E206-CB66-6D7E-3C4A63073FFC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440241" y="2534069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35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99" name="Szövegdoboz 98">
                                      <a:extLst>
                                        <a:ext uri="{FF2B5EF4-FFF2-40B4-BE49-F238E27FC236}">
                                          <a16:creationId xmlns:a16="http://schemas.microsoft.com/office/drawing/2014/main" id="{965D7DDF-485F-B599-62AA-DF22CC5D34D8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441810" y="2959847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25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121" name="Szövegdoboz 120">
                                    <a:extLst>
                                      <a:ext uri="{FF2B5EF4-FFF2-40B4-BE49-F238E27FC236}">
                                        <a16:creationId xmlns:a16="http://schemas.microsoft.com/office/drawing/2014/main" id="{1898A444-C0BB-657E-8DFA-3B4670C7E1A4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9816689" y="878089"/>
                                    <a:ext cx="348172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250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22" name="Szövegdoboz 121">
                                    <a:extLst>
                                      <a:ext uri="{FF2B5EF4-FFF2-40B4-BE49-F238E27FC236}">
                                        <a16:creationId xmlns:a16="http://schemas.microsoft.com/office/drawing/2014/main" id="{675B4CCE-8577-94CA-47BF-8D183D85472D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9818257" y="1124759"/>
                                    <a:ext cx="348172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130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23" name="Szövegdoboz 122">
                                    <a:extLst>
                                      <a:ext uri="{FF2B5EF4-FFF2-40B4-BE49-F238E27FC236}">
                                        <a16:creationId xmlns:a16="http://schemas.microsoft.com/office/drawing/2014/main" id="{70AE2675-25E4-D3B3-4A93-BF29DC660B18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9810400" y="1371429"/>
                                    <a:ext cx="348172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100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25" name="Szövegdoboz 124">
                                    <a:extLst>
                                      <a:ext uri="{FF2B5EF4-FFF2-40B4-BE49-F238E27FC236}">
                                        <a16:creationId xmlns:a16="http://schemas.microsoft.com/office/drawing/2014/main" id="{6640F9D8-DCA3-E292-8EEB-41A6A9E10DC6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9868530" y="1627526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70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26" name="Szövegdoboz 125">
                                    <a:extLst>
                                      <a:ext uri="{FF2B5EF4-FFF2-40B4-BE49-F238E27FC236}">
                                        <a16:creationId xmlns:a16="http://schemas.microsoft.com/office/drawing/2014/main" id="{66CA1591-7E31-C235-69FE-F544839705CC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9870099" y="1911900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55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27" name="Szövegdoboz 126">
                                    <a:extLst>
                                      <a:ext uri="{FF2B5EF4-FFF2-40B4-BE49-F238E27FC236}">
                                        <a16:creationId xmlns:a16="http://schemas.microsoft.com/office/drawing/2014/main" id="{A735A463-8D83-3D66-9A8D-1F0A54E1846D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9871667" y="2535640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35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28" name="Szövegdoboz 127">
                                    <a:extLst>
                                      <a:ext uri="{FF2B5EF4-FFF2-40B4-BE49-F238E27FC236}">
                                        <a16:creationId xmlns:a16="http://schemas.microsoft.com/office/drawing/2014/main" id="{319E8886-DC4B-8AD4-4292-99B313652AEE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9863809" y="2933137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25</a:t>
                                    </a:r>
                                  </a:p>
                                </p:txBody>
                              </p:sp>
                            </p:grpSp>
                            <p:pic>
                              <p:nvPicPr>
                                <p:cNvPr id="3" name="Kép 2" descr="A képen fekete-fehér, Monokróm fényképezés, monokróm, fekete látható&#10;&#10;Automatikusan generált leírás">
                                  <a:extLst>
                                    <a:ext uri="{FF2B5EF4-FFF2-40B4-BE49-F238E27FC236}">
                                      <a16:creationId xmlns:a16="http://schemas.microsoft.com/office/drawing/2014/main" id="{1CE15D00-BD74-3156-5CD2-02C3DF4DA32E}"/>
                                    </a:ext>
                                  </a:extLst>
                                </p:cNvPr>
                                <p:cNvPicPr>
                                  <a:picLocks/>
                                </p:cNvPicPr>
                                <p:nvPr/>
                              </p:nvPicPr>
                              <p:blipFill>
                                <a:blip r:embed="rId2">
                                  <a:extLst>
                                    <a:ext uri="{28A0092B-C50C-407E-A947-70E740481C1C}">
                                      <a14:useLocalDpi xmlns:a14="http://schemas.microsoft.com/office/drawing/2010/main" val="0"/>
                                    </a:ext>
                                  </a:extLst>
                                </a:blip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10170104" y="903454"/>
                                  <a:ext cx="1620000" cy="2340000"/>
                                </a:xfrm>
                                <a:prstGeom prst="rect">
                                  <a:avLst/>
                                </a:prstGeom>
                                <a:ln w="9525">
                                  <a:solidFill>
                                    <a:schemeClr val="tx1"/>
                                  </a:solidFill>
                                </a:ln>
                              </p:spPr>
                            </p:pic>
                          </p:grpSp>
                          <p:pic>
                            <p:nvPicPr>
                              <p:cNvPr id="43" name="Kép 42" descr="A képen fehér, fekete-fehér, monokróm látható&#10;&#10;Automatikusan generált leírás">
                                <a:extLst>
                                  <a:ext uri="{FF2B5EF4-FFF2-40B4-BE49-F238E27FC236}">
                                    <a16:creationId xmlns:a16="http://schemas.microsoft.com/office/drawing/2014/main" id="{FFA73860-55E7-8E2B-A88E-3F143FCDF22C}"/>
                                  </a:ext>
                                </a:extLst>
                              </p:cNvPr>
                              <p:cNvPicPr>
                                <a:picLocks/>
                              </p:cNvPicPr>
                              <p:nvPr/>
                            </p:nvPicPr>
                            <p:blipFill>
                              <a:blip r:embed="rId3">
                                <a:extLst>
                                  <a:ext uri="{28A0092B-C50C-407E-A947-70E740481C1C}">
                                    <a14:useLocalDpi xmlns:a14="http://schemas.microsoft.com/office/drawing/2010/main" val="0"/>
                                  </a:ext>
                                </a:extLst>
                              </a:blip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0151505" y="3577622"/>
                                <a:ext cx="1620000" cy="900000"/>
                              </a:xfrm>
                              <a:prstGeom prst="rect">
                                <a:avLst/>
                              </a:prstGeom>
                              <a:ln w="9525">
                                <a:solidFill>
                                  <a:schemeClr val="tx1"/>
                                </a:solidFill>
                              </a:ln>
                            </p:spPr>
                          </p:pic>
                        </p:grpSp>
                        <p:pic>
                          <p:nvPicPr>
                            <p:cNvPr id="62" name="Kép 61" descr="A képen szöveg, fekete-fehér, homályos, monokróm látható&#10;&#10;Automatikusan generált leírás">
                              <a:extLst>
                                <a:ext uri="{FF2B5EF4-FFF2-40B4-BE49-F238E27FC236}">
                                  <a16:creationId xmlns:a16="http://schemas.microsoft.com/office/drawing/2014/main" id="{2F974AC0-7B11-4F8D-FF6C-282397D258A3}"/>
                                </a:ext>
                              </a:extLst>
                            </p:cNvPr>
                            <p:cNvPicPr>
                              <a:picLocks/>
                            </p:cNvPicPr>
                            <p:nvPr/>
                          </p:nvPicPr>
                          <p:blipFill>
                            <a:blip r:embed="rId4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826195" y="903454"/>
                              <a:ext cx="1620000" cy="2340000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grpSp>
                      <p:pic>
                        <p:nvPicPr>
                          <p:cNvPr id="67" name="Kép 66" descr="A képen fekete, monokróm, fekete-fehér, homályos látható&#10;&#10;Automatikusan generált leírás">
                            <a:extLst>
                              <a:ext uri="{FF2B5EF4-FFF2-40B4-BE49-F238E27FC236}">
                                <a16:creationId xmlns:a16="http://schemas.microsoft.com/office/drawing/2014/main" id="{EB83C124-136F-FC5D-C987-074DF3D4CA42}"/>
                              </a:ext>
                            </a:extLst>
                          </p:cNvPr>
                          <p:cNvPicPr>
                            <a:picLocks/>
                          </p:cNvPicPr>
                          <p:nvPr/>
                        </p:nvPicPr>
                        <p:blipFill>
                          <a:blip r:embed="rId5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1826195" y="3582344"/>
                            <a:ext cx="1620000" cy="900000"/>
                          </a:xfrm>
                          <a:prstGeom prst="rect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</p:pic>
                    </p:grpSp>
                    <p:pic>
                      <p:nvPicPr>
                        <p:cNvPr id="110" name="Kép 109" descr="A képen szöveg, fekete-fehér, monokróm, fekete látható&#10;&#10;Automatikusan generált leírás">
                          <a:extLst>
                            <a:ext uri="{FF2B5EF4-FFF2-40B4-BE49-F238E27FC236}">
                              <a16:creationId xmlns:a16="http://schemas.microsoft.com/office/drawing/2014/main" id="{7FE8A55A-0876-9BA5-C21D-6B48598EECC9}"/>
                            </a:ext>
                          </a:extLst>
                        </p:cNvPr>
                        <p:cNvPicPr>
                          <a:picLocks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7451128" y="903125"/>
                          <a:ext cx="1620000" cy="2340000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</p:pic>
                  </p:grpSp>
                  <p:pic>
                    <p:nvPicPr>
                      <p:cNvPr id="112" name="Kép 111" descr="A képen monokróm, fekete, fekete-fehér, homályos látható&#10;&#10;Automatikusan generált leírás">
                        <a:extLst>
                          <a:ext uri="{FF2B5EF4-FFF2-40B4-BE49-F238E27FC236}">
                            <a16:creationId xmlns:a16="http://schemas.microsoft.com/office/drawing/2014/main" id="{6F9E996D-A1EB-7053-4BD1-4B64FA6A25F8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7451128" y="3576278"/>
                        <a:ext cx="1620000" cy="900000"/>
                      </a:xfrm>
                      <a:prstGeom prst="rect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</p:pic>
                </p:grpSp>
              </p:grpSp>
            </p:grpSp>
          </p:grpSp>
          <p:pic>
            <p:nvPicPr>
              <p:cNvPr id="117" name="Kép 116" descr="A képen monokróm, fekete-fehér, Monokróm fényképezés, szöveg látható&#10;&#10;Automatikusan generált leírás">
                <a:extLst>
                  <a:ext uri="{FF2B5EF4-FFF2-40B4-BE49-F238E27FC236}">
                    <a16:creationId xmlns:a16="http://schemas.microsoft.com/office/drawing/2014/main" id="{020FFE2E-6FAA-BD12-4498-C82AEFC3FBDC}"/>
                  </a:ext>
                </a:extLst>
              </p:cNvPr>
              <p:cNvPicPr>
                <a:picLocks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30179" y="903125"/>
                <a:ext cx="1620000" cy="23400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  <p:pic>
          <p:nvPicPr>
            <p:cNvPr id="124" name="Kép 123" descr="A képen monokróm, fekete, fekete-fehér, Monokróm fényképezés látható&#10;&#10;Automatikusan generált leírás">
              <a:extLst>
                <a:ext uri="{FF2B5EF4-FFF2-40B4-BE49-F238E27FC236}">
                  <a16:creationId xmlns:a16="http://schemas.microsoft.com/office/drawing/2014/main" id="{B59FA27D-D59F-778E-8C19-F9A553BE959E}"/>
                </a:ext>
              </a:extLst>
            </p:cNvPr>
            <p:cNvPicPr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33809" y="3582344"/>
              <a:ext cx="1620000" cy="90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</p:grpSp>
      <p:cxnSp>
        <p:nvCxnSpPr>
          <p:cNvPr id="14" name="Egyenes összekötő nyíllal 13">
            <a:extLst>
              <a:ext uri="{FF2B5EF4-FFF2-40B4-BE49-F238E27FC236}">
                <a16:creationId xmlns:a16="http://schemas.microsoft.com/office/drawing/2014/main" id="{95E50F94-1743-16B4-C0AE-81632A2DC305}"/>
              </a:ext>
            </a:extLst>
          </p:cNvPr>
          <p:cNvCxnSpPr>
            <a:cxnSpLocks/>
          </p:cNvCxnSpPr>
          <p:nvPr/>
        </p:nvCxnSpPr>
        <p:spPr>
          <a:xfrm flipH="1">
            <a:off x="6404081" y="2161134"/>
            <a:ext cx="289903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Egyenes összekötő nyíllal 15">
            <a:extLst>
              <a:ext uri="{FF2B5EF4-FFF2-40B4-BE49-F238E27FC236}">
                <a16:creationId xmlns:a16="http://schemas.microsoft.com/office/drawing/2014/main" id="{507F9B97-F3F9-9BFF-E1C0-2C8812852503}"/>
              </a:ext>
            </a:extLst>
          </p:cNvPr>
          <p:cNvCxnSpPr>
            <a:cxnSpLocks/>
          </p:cNvCxnSpPr>
          <p:nvPr/>
        </p:nvCxnSpPr>
        <p:spPr>
          <a:xfrm flipH="1">
            <a:off x="9112748" y="2150213"/>
            <a:ext cx="289903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Egyenes összekötő nyíllal 22">
            <a:extLst>
              <a:ext uri="{FF2B5EF4-FFF2-40B4-BE49-F238E27FC236}">
                <a16:creationId xmlns:a16="http://schemas.microsoft.com/office/drawing/2014/main" id="{5DCB5623-2134-EE9B-02D9-7CA8979437F5}"/>
              </a:ext>
            </a:extLst>
          </p:cNvPr>
          <p:cNvCxnSpPr>
            <a:cxnSpLocks/>
          </p:cNvCxnSpPr>
          <p:nvPr/>
        </p:nvCxnSpPr>
        <p:spPr>
          <a:xfrm flipH="1">
            <a:off x="3484840" y="2162553"/>
            <a:ext cx="289903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Egyenes összekötő nyíllal 25">
            <a:extLst>
              <a:ext uri="{FF2B5EF4-FFF2-40B4-BE49-F238E27FC236}">
                <a16:creationId xmlns:a16="http://schemas.microsoft.com/office/drawing/2014/main" id="{2975F53E-6FEA-95DB-47F7-8FBCC48A401D}"/>
              </a:ext>
            </a:extLst>
          </p:cNvPr>
          <p:cNvCxnSpPr>
            <a:cxnSpLocks/>
          </p:cNvCxnSpPr>
          <p:nvPr/>
        </p:nvCxnSpPr>
        <p:spPr>
          <a:xfrm flipH="1">
            <a:off x="11831724" y="2037091"/>
            <a:ext cx="289903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448903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4E61EA46-CF03-FBB6-50D2-3D75129E7EDA}"/>
              </a:ext>
            </a:extLst>
          </p:cNvPr>
          <p:cNvSpPr txBox="1"/>
          <p:nvPr/>
        </p:nvSpPr>
        <p:spPr>
          <a:xfrm>
            <a:off x="68367" y="68366"/>
            <a:ext cx="2250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/>
              <a:t>BxPC3 </a:t>
            </a:r>
            <a:r>
              <a:rPr lang="hu-HU" b="1" dirty="0" err="1"/>
              <a:t>blots</a:t>
            </a:r>
            <a:r>
              <a:rPr lang="hu-HU" b="1" dirty="0"/>
              <a:t>:</a:t>
            </a:r>
          </a:p>
        </p:txBody>
      </p:sp>
      <p:grpSp>
        <p:nvGrpSpPr>
          <p:cNvPr id="102" name="Csoportba foglalás 101">
            <a:extLst>
              <a:ext uri="{FF2B5EF4-FFF2-40B4-BE49-F238E27FC236}">
                <a16:creationId xmlns:a16="http://schemas.microsoft.com/office/drawing/2014/main" id="{CE3EC3CA-7626-5C13-0CDE-3C9446200AA1}"/>
              </a:ext>
            </a:extLst>
          </p:cNvPr>
          <p:cNvGrpSpPr/>
          <p:nvPr/>
        </p:nvGrpSpPr>
        <p:grpSpPr>
          <a:xfrm>
            <a:off x="68367" y="642759"/>
            <a:ext cx="11964550" cy="2059144"/>
            <a:chOff x="68367" y="2517741"/>
            <a:chExt cx="11964550" cy="2059144"/>
          </a:xfrm>
        </p:grpSpPr>
        <p:grpSp>
          <p:nvGrpSpPr>
            <p:cNvPr id="96" name="Csoportba foglalás 95">
              <a:extLst>
                <a:ext uri="{FF2B5EF4-FFF2-40B4-BE49-F238E27FC236}">
                  <a16:creationId xmlns:a16="http://schemas.microsoft.com/office/drawing/2014/main" id="{E9C902F9-92DA-7E6E-40A1-8001D15A3B3C}"/>
                </a:ext>
              </a:extLst>
            </p:cNvPr>
            <p:cNvGrpSpPr/>
            <p:nvPr/>
          </p:nvGrpSpPr>
          <p:grpSpPr>
            <a:xfrm>
              <a:off x="68367" y="2517741"/>
              <a:ext cx="11964550" cy="2059144"/>
              <a:chOff x="68367" y="2517741"/>
              <a:chExt cx="11964550" cy="2059144"/>
            </a:xfrm>
          </p:grpSpPr>
          <p:grpSp>
            <p:nvGrpSpPr>
              <p:cNvPr id="94" name="Csoportba foglalás 93">
                <a:extLst>
                  <a:ext uri="{FF2B5EF4-FFF2-40B4-BE49-F238E27FC236}">
                    <a16:creationId xmlns:a16="http://schemas.microsoft.com/office/drawing/2014/main" id="{6446AE6D-A49D-E754-88E8-E915DEC02534}"/>
                  </a:ext>
                </a:extLst>
              </p:cNvPr>
              <p:cNvGrpSpPr/>
              <p:nvPr/>
            </p:nvGrpSpPr>
            <p:grpSpPr>
              <a:xfrm>
                <a:off x="68367" y="2517741"/>
                <a:ext cx="11964550" cy="2059144"/>
                <a:chOff x="68367" y="2517741"/>
                <a:chExt cx="11964550" cy="2059144"/>
              </a:xfrm>
            </p:grpSpPr>
            <p:grpSp>
              <p:nvGrpSpPr>
                <p:cNvPr id="86" name="Csoportba foglalás 85">
                  <a:extLst>
                    <a:ext uri="{FF2B5EF4-FFF2-40B4-BE49-F238E27FC236}">
                      <a16:creationId xmlns:a16="http://schemas.microsoft.com/office/drawing/2014/main" id="{D7454042-4039-C527-B579-F8062CE1DBCA}"/>
                    </a:ext>
                  </a:extLst>
                </p:cNvPr>
                <p:cNvGrpSpPr/>
                <p:nvPr/>
              </p:nvGrpSpPr>
              <p:grpSpPr>
                <a:xfrm>
                  <a:off x="68367" y="2517741"/>
                  <a:ext cx="11964550" cy="2059144"/>
                  <a:chOff x="68367" y="2517741"/>
                  <a:chExt cx="11964550" cy="2059144"/>
                </a:xfrm>
              </p:grpSpPr>
              <p:grpSp>
                <p:nvGrpSpPr>
                  <p:cNvPr id="81" name="Csoportba foglalás 80">
                    <a:extLst>
                      <a:ext uri="{FF2B5EF4-FFF2-40B4-BE49-F238E27FC236}">
                        <a16:creationId xmlns:a16="http://schemas.microsoft.com/office/drawing/2014/main" id="{6F2A4DC0-7405-678F-000D-532D461839A9}"/>
                      </a:ext>
                    </a:extLst>
                  </p:cNvPr>
                  <p:cNvGrpSpPr/>
                  <p:nvPr/>
                </p:nvGrpSpPr>
                <p:grpSpPr>
                  <a:xfrm>
                    <a:off x="68367" y="2517741"/>
                    <a:ext cx="11964550" cy="2059144"/>
                    <a:chOff x="68367" y="2517741"/>
                    <a:chExt cx="11964550" cy="2059144"/>
                  </a:xfrm>
                </p:grpSpPr>
                <p:grpSp>
                  <p:nvGrpSpPr>
                    <p:cNvPr id="72" name="Csoportba foglalás 71">
                      <a:extLst>
                        <a:ext uri="{FF2B5EF4-FFF2-40B4-BE49-F238E27FC236}">
                          <a16:creationId xmlns:a16="http://schemas.microsoft.com/office/drawing/2014/main" id="{55B3E9C5-E536-00CC-2802-236F05809B2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7" y="2517741"/>
                      <a:ext cx="11964550" cy="2059144"/>
                      <a:chOff x="68367" y="2517741"/>
                      <a:chExt cx="11964550" cy="2059144"/>
                    </a:xfrm>
                  </p:grpSpPr>
                  <p:grpSp>
                    <p:nvGrpSpPr>
                      <p:cNvPr id="62" name="Csoportba foglalás 61">
                        <a:extLst>
                          <a:ext uri="{FF2B5EF4-FFF2-40B4-BE49-F238E27FC236}">
                            <a16:creationId xmlns:a16="http://schemas.microsoft.com/office/drawing/2014/main" id="{C8DB0E6C-6561-42D4-8398-CC8320A06E1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7" y="2517741"/>
                        <a:ext cx="11964550" cy="2059144"/>
                        <a:chOff x="68367" y="2517741"/>
                        <a:chExt cx="11964550" cy="2059144"/>
                      </a:xfrm>
                    </p:grpSpPr>
                    <p:grpSp>
                      <p:nvGrpSpPr>
                        <p:cNvPr id="57" name="Csoportba foglalás 56">
                          <a:extLst>
                            <a:ext uri="{FF2B5EF4-FFF2-40B4-BE49-F238E27FC236}">
                              <a16:creationId xmlns:a16="http://schemas.microsoft.com/office/drawing/2014/main" id="{4A87F124-29A1-9919-5B05-612F50B829D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7" y="2517741"/>
                          <a:ext cx="11964550" cy="2059144"/>
                          <a:chOff x="68367" y="2517741"/>
                          <a:chExt cx="11964550" cy="2059144"/>
                        </a:xfrm>
                      </p:grpSpPr>
                      <p:grpSp>
                        <p:nvGrpSpPr>
                          <p:cNvPr id="34" name="Csoportba foglalás 33">
                            <a:extLst>
                              <a:ext uri="{FF2B5EF4-FFF2-40B4-BE49-F238E27FC236}">
                                <a16:creationId xmlns:a16="http://schemas.microsoft.com/office/drawing/2014/main" id="{0F02122C-F4DD-6DFA-0DF3-EEB78E4E25CF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7" y="2517741"/>
                            <a:ext cx="11964550" cy="2059144"/>
                            <a:chOff x="68367" y="2517741"/>
                            <a:chExt cx="11964550" cy="2059144"/>
                          </a:xfrm>
                        </p:grpSpPr>
                        <p:grpSp>
                          <p:nvGrpSpPr>
                            <p:cNvPr id="114" name="Csoportba foglalás 113">
                              <a:extLst>
                                <a:ext uri="{FF2B5EF4-FFF2-40B4-BE49-F238E27FC236}">
                                  <a16:creationId xmlns:a16="http://schemas.microsoft.com/office/drawing/2014/main" id="{0265D2BA-C624-F47D-46BF-1D13DC465C40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7" y="2517741"/>
                              <a:ext cx="11964550" cy="2059144"/>
                              <a:chOff x="68367" y="2517741"/>
                              <a:chExt cx="11964550" cy="2059144"/>
                            </a:xfrm>
                          </p:grpSpPr>
                          <p:grpSp>
                            <p:nvGrpSpPr>
                              <p:cNvPr id="93" name="Csoportba foglalás 92">
                                <a:extLst>
                                  <a:ext uri="{FF2B5EF4-FFF2-40B4-BE49-F238E27FC236}">
                                    <a16:creationId xmlns:a16="http://schemas.microsoft.com/office/drawing/2014/main" id="{B4BF2BDF-2EB7-A1C8-D2D7-9755198A847C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7" y="2517741"/>
                                <a:ext cx="11964550" cy="2059144"/>
                                <a:chOff x="68367" y="2517741"/>
                                <a:chExt cx="11964550" cy="2059144"/>
                              </a:xfrm>
                            </p:grpSpPr>
                            <p:grpSp>
                              <p:nvGrpSpPr>
                                <p:cNvPr id="3" name="Csoportba foglalás 2">
                                  <a:extLst>
                                    <a:ext uri="{FF2B5EF4-FFF2-40B4-BE49-F238E27FC236}">
                                      <a16:creationId xmlns:a16="http://schemas.microsoft.com/office/drawing/2014/main" id="{29AD2744-BA9D-EBEE-87A9-E0CC31EFBC68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8367" y="2517741"/>
                                  <a:ext cx="11964550" cy="2059144"/>
                                  <a:chOff x="68367" y="378270"/>
                                  <a:chExt cx="11964550" cy="2059144"/>
                                </a:xfrm>
                              </p:grpSpPr>
                              <p:grpSp>
                                <p:nvGrpSpPr>
                                  <p:cNvPr id="15" name="Csoportba foglalás 14">
                                    <a:extLst>
                                      <a:ext uri="{FF2B5EF4-FFF2-40B4-BE49-F238E27FC236}">
                                        <a16:creationId xmlns:a16="http://schemas.microsoft.com/office/drawing/2014/main" id="{4CD5BDF3-1E96-50C1-D1F8-09CAA96DED45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8367" y="378270"/>
                                    <a:ext cx="11964550" cy="2059144"/>
                                    <a:chOff x="68367" y="378270"/>
                                    <a:chExt cx="11964550" cy="2059144"/>
                                  </a:xfrm>
                                </p:grpSpPr>
                                <p:grpSp>
                                  <p:nvGrpSpPr>
                                    <p:cNvPr id="23" name="Csoportba foglalás 22">
                                      <a:extLst>
                                        <a:ext uri="{FF2B5EF4-FFF2-40B4-BE49-F238E27FC236}">
                                          <a16:creationId xmlns:a16="http://schemas.microsoft.com/office/drawing/2014/main" id="{48AFB3D1-AFAF-FE71-A078-1C54CA3D2679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8367" y="378270"/>
                                      <a:ext cx="11964550" cy="2059144"/>
                                      <a:chOff x="68367" y="378270"/>
                                      <a:chExt cx="11964550" cy="2059144"/>
                                    </a:xfrm>
                                  </p:grpSpPr>
                                  <p:grpSp>
                                    <p:nvGrpSpPr>
                                      <p:cNvPr id="39" name="Csoportba foglalás 38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B426255A-D7C9-9379-61BB-C1D719A3D6C3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8367" y="378270"/>
                                        <a:ext cx="11964550" cy="2059144"/>
                                        <a:chOff x="68367" y="378270"/>
                                        <a:chExt cx="11964550" cy="2059144"/>
                                      </a:xfrm>
                                    </p:grpSpPr>
                                    <p:grpSp>
                                      <p:nvGrpSpPr>
                                        <p:cNvPr id="115" name="Csoportba foglalás 114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ED6C8540-0F0B-76EE-1329-F88D9A0C0C9D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8367" y="378270"/>
                                          <a:ext cx="11964550" cy="2059144"/>
                                          <a:chOff x="68367" y="378270"/>
                                          <a:chExt cx="11964550" cy="2059144"/>
                                        </a:xfrm>
                                      </p:grpSpPr>
                                      <p:grpSp>
                                        <p:nvGrpSpPr>
                                          <p:cNvPr id="130" name="Csoportba foglalás 129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A509F151-A84F-9423-5DF1-59B58F8AE480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68367" y="378270"/>
                                            <a:ext cx="11964550" cy="2059144"/>
                                            <a:chOff x="68367" y="378270"/>
                                            <a:chExt cx="11964550" cy="2059144"/>
                                          </a:xfrm>
                                        </p:grpSpPr>
                                        <p:sp>
                                          <p:nvSpPr>
                                            <p:cNvPr id="133" name="Szövegdoboz 132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7FE0271E-D3CB-1C63-5D4F-3CC4B7A21D1C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5985297" y="1490424"/>
                                              <a:ext cx="47000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DMSO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34" name="Szövegdoboz 133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8F76D84F-8BE4-1BDE-14F1-09E6E49443BB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6366182" y="1487332"/>
                                              <a:ext cx="457176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UDCA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35" name="Szövegdoboz 134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CEAEA855-17FC-469A-FB82-07D7014C67DB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2887156" y="1497190"/>
                                              <a:ext cx="47000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DMSO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36" name="Szövegdoboz 135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E12913C1-395B-367D-94F1-8264BC926283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3202049" y="1503525"/>
                                              <a:ext cx="457176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UDCA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37" name="Szövegdoboz 136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392CEEB2-A6B3-4649-4170-7A90B9F2CA7F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0417401" y="1491776"/>
                                              <a:ext cx="47000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DMSO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39" name="Szövegdoboz 138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81E4901D-40D8-867B-3BA3-191A7204492F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0844546" y="1486662"/>
                                              <a:ext cx="457176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UDCA</a:t>
                                              </a:r>
                                            </a:p>
                                          </p:txBody>
                                        </p:sp>
                                        <p:grpSp>
                                          <p:nvGrpSpPr>
                                            <p:cNvPr id="140" name="Csoportba foglalás 139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35DC03D4-D429-718A-ADFA-50F44C9CCC46}"/>
                                                </a:ext>
                                              </a:extLst>
                                            </p:cNvPr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68367" y="378270"/>
                                              <a:ext cx="11964550" cy="2059144"/>
                                              <a:chOff x="68367" y="378270"/>
                                              <a:chExt cx="11964550" cy="2059144"/>
                                            </a:xfrm>
                                          </p:grpSpPr>
                                          <p:grpSp>
                                            <p:nvGrpSpPr>
                                              <p:cNvPr id="143" name="Csoportba foglalás 142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E3A05487-DF0E-F5F2-CA77-6152AD03521F}"/>
                                                  </a:ext>
                                                </a:extLst>
                                              </p:cNvPr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68367" y="378270"/>
                                                <a:ext cx="11964550" cy="2059144"/>
                                                <a:chOff x="68367" y="378270"/>
                                                <a:chExt cx="11964550" cy="2059144"/>
                                              </a:xfrm>
                                            </p:grpSpPr>
                                            <p:sp>
                                              <p:nvSpPr>
                                                <p:cNvPr id="147" name="Szövegdoboz 146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EFFF1FB2-9399-D9BB-FFDD-A85F3460B6E4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021434" y="631011"/>
                                                  <a:ext cx="470000" cy="215444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800" dirty="0"/>
                                                    <a:t>DMSO</a:t>
                                                  </a:r>
                                                </a:p>
                                              </p:txBody>
                                            </p:sp>
                                            <p:sp>
                                              <p:nvSpPr>
                                                <p:cNvPr id="149" name="Szövegdoboz 148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AE8CDBE1-23CC-11FE-E5EC-8D6A4BABCB73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411737" y="637346"/>
                                                  <a:ext cx="457176" cy="215444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800" dirty="0"/>
                                                    <a:t>UDCA</a:t>
                                                  </a:r>
                                                </a:p>
                                              </p:txBody>
                                            </p:sp>
                                            <p:grpSp>
                                              <p:nvGrpSpPr>
                                                <p:cNvPr id="186" name="Csoportba foglalás 185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285BE8DF-32E8-22A3-20F7-CF02D2079DC6}"/>
                                                    </a:ext>
                                                  </a:extLst>
                                                </p:cNvPr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68367" y="378270"/>
                                                  <a:ext cx="11964550" cy="2059144"/>
                                                  <a:chOff x="68367" y="415477"/>
                                                  <a:chExt cx="11964550" cy="2059144"/>
                                                </a:xfrm>
                                              </p:grpSpPr>
                                              <p:sp>
                                                <p:nvSpPr>
                                                  <p:cNvPr id="189" name="Szövegdoboz 188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EA75328F-B48D-F03F-2FDA-CBC7A9E58CCF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68367" y="1048238"/>
                                                    <a:ext cx="999857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squar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dirty="0"/>
                                                      <a:t>NRF-2: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  <p:sp>
                                                <p:nvSpPr>
                                                  <p:cNvPr id="192" name="Szövegdoboz 191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5E76A2CE-7AC3-01BE-3D67-B90DF5823806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68367" y="1815547"/>
                                                    <a:ext cx="803304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squar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dirty="0"/>
                                                      <a:t>β-</a:t>
                                                    </a:r>
                                                    <a:r>
                                                      <a:rPr lang="hu-HU" sz="1400" dirty="0" err="1"/>
                                                      <a:t>actin</a:t>
                                                    </a:r>
                                                    <a:r>
                                                      <a:rPr lang="hu-HU" sz="1400" dirty="0"/>
                                                      <a:t>: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  <p:grpSp>
                                                <p:nvGrpSpPr>
                                                  <p:cNvPr id="195" name="Csoportba foglalás 194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B7351B9A-5D5E-0455-5CCF-B3EDB1CD1C3C}"/>
                                                      </a:ext>
                                                    </a:extLst>
                                                  </p:cNvPr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2791321" y="415641"/>
                                                    <a:ext cx="762637" cy="484214"/>
                                                    <a:chOff x="2791321" y="415641"/>
                                                    <a:chExt cx="762637" cy="484214"/>
                                                  </a:xfrm>
                                                </p:grpSpPr>
                                                <p:grpSp>
                                                  <p:nvGrpSpPr>
                                                    <p:cNvPr id="205" name="Csoportba foglalás 204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613031AC-857D-AC4B-8136-6C051C9F3484}"/>
                                                        </a:ext>
                                                      </a:extLst>
                                                    </p:cNvPr>
                                                    <p:cNvGrpSpPr/>
                                                    <p:nvPr/>
                                                  </p:nvGrpSpPr>
                                                  <p:grpSpPr>
                                                    <a:xfrm>
                                                      <a:off x="2791321" y="681319"/>
                                                      <a:ext cx="762637" cy="218536"/>
                                                      <a:chOff x="2791321" y="305309"/>
                                                      <a:chExt cx="762637" cy="218536"/>
                                                    </a:xfrm>
                                                  </p:grpSpPr>
                                                  <p:sp>
                                                    <p:nvSpPr>
                                                      <p:cNvPr id="207" name="Szövegdoboz 206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DC785693-AAC4-97FB-553B-E083977F6204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2791321" y="308401"/>
                                                        <a:ext cx="470000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DMSO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208" name="Szövegdoboz 207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B16D0573-0BF7-CAD3-AA9F-EDCC9EDB04A4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3096782" y="305309"/>
                                                        <a:ext cx="457176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UDCA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</p:grpSp>
                                                <p:sp>
                                                  <p:nvSpPr>
                                                    <p:cNvPr id="206" name="Szövegdoboz 205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2DE4BE31-441A-0328-59CA-A36DCD064A70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2797923" y="415641"/>
                                                      <a:ext cx="332142" cy="307777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1400" b="1" dirty="0"/>
                                                        <a:t>1.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</p:grpSp>
                                              <p:sp>
                                                <p:nvSpPr>
                                                  <p:cNvPr id="198" name="Szövegdoboz 197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02759803-CC98-45F3-C3AF-05AA128F230E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6271647" y="416294"/>
                                                    <a:ext cx="335348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b="1" dirty="0"/>
                                                      <a:t>2.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  <p:sp>
                                                <p:nvSpPr>
                                                  <p:cNvPr id="201" name="Szövegdoboz 200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678E5271-9918-AC90-2357-67BFA5024666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10016820" y="415477"/>
                                                    <a:ext cx="335348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b="1" dirty="0"/>
                                                      <a:t>3.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  <p:sp>
                                                <p:nvSpPr>
                                                  <p:cNvPr id="204" name="Téglalap 203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4C3F2B9E-A1F5-7A7A-9176-71FEBFDFC3EA}"/>
                                                      </a:ext>
                                                    </a:extLst>
                                                  </p:cNvPr>
                                                  <p:cNvSpPr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70822" y="474905"/>
                                                    <a:ext cx="11962095" cy="1999716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style>
                                                  <a:lnRef idx="2">
                                                    <a:schemeClr val="accent1">
                                                      <a:shade val="15000"/>
                                                    </a:schemeClr>
                                                  </a:lnRef>
                                                  <a:fillRef idx="1">
                                                    <a:schemeClr val="accent1"/>
                                                  </a:fillRef>
                                                  <a:effectRef idx="0">
                                                    <a:schemeClr val="accent1"/>
                                                  </a:effectRef>
                                                  <a:fontRef idx="minor">
                                                    <a:schemeClr val="lt1"/>
                                                  </a:fontRef>
                                                </p:style>
                                                <p:txBody>
                                                  <a:bodyPr rtlCol="0" anchor="ctr"/>
                                                  <a:lstStyle/>
                                                  <a:p>
                                                    <a:pPr algn="ctr"/>
                                                    <a:endParaRPr lang="hu-HU"/>
                                                  </a:p>
                                                </p:txBody>
                                              </p:sp>
                                            </p:grpSp>
                                          </p:grpSp>
                                          <p:sp>
                                            <p:nvSpPr>
                                              <p:cNvPr id="144" name="Szövegdoboz 143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B353D6E0-33E5-4052-E997-B758DF0FB1C7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10453544" y="632363"/>
                                                <a:ext cx="470000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DMSO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146" name="Szövegdoboz 145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C66FFE90-BC18-3A9A-55AF-7D8583D71C87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10842984" y="636676"/>
                                                <a:ext cx="457176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UDCA</a:t>
                                                </a:r>
                                              </a:p>
                                            </p:txBody>
                                          </p:sp>
                                        </p:grpSp>
                                      </p:grpSp>
                                      <p:sp>
                                        <p:nvSpPr>
                                          <p:cNvPr id="124" name="Szövegdoboz 123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D2D11BC2-8FE7-CD2C-C2B0-A9B8AF23FB61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4140763" y="1102631"/>
                                            <a:ext cx="29367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70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  <p:sp>
                                      <p:nvSpPr>
                                        <p:cNvPr id="110" name="Szövegdoboz 109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DE19081A-DD7E-9FA7-EDC8-57A916A3B82D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4140297" y="1695871"/>
                                          <a:ext cx="29367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55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35" name="Szövegdoboz 34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0D156093-C65F-6627-1C5D-86D78BFF401B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4970562" y="2086986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35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36" name="Szövegdoboz 35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AB41236A-3040-EA7A-6E8E-16E7A6061A29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4962703" y="1683202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55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26" name="Szövegdoboz 25">
                                      <a:extLst>
                                        <a:ext uri="{FF2B5EF4-FFF2-40B4-BE49-F238E27FC236}">
                                          <a16:creationId xmlns:a16="http://schemas.microsoft.com/office/drawing/2014/main" id="{A008058A-D773-4A7D-0941-BE81F252B167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8628166" y="1672200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55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30" name="Szövegdoboz 29">
                                      <a:extLst>
                                        <a:ext uri="{FF2B5EF4-FFF2-40B4-BE49-F238E27FC236}">
                                          <a16:creationId xmlns:a16="http://schemas.microsoft.com/office/drawing/2014/main" id="{1F2B1F8E-AAB0-46F7-F656-1B485C600C2E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8620307" y="1211863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55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16" name="Szövegdoboz 15">
                                    <a:extLst>
                                      <a:ext uri="{FF2B5EF4-FFF2-40B4-BE49-F238E27FC236}">
                                        <a16:creationId xmlns:a16="http://schemas.microsoft.com/office/drawing/2014/main" id="{2A9B8FFF-1BBA-A59E-31B5-51D0C5AB3B7F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8620307" y="815930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70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92" name="Szövegdoboz 91">
                                  <a:extLst>
                                    <a:ext uri="{FF2B5EF4-FFF2-40B4-BE49-F238E27FC236}">
                                      <a16:creationId xmlns:a16="http://schemas.microsoft.com/office/drawing/2014/main" id="{F348676C-8760-0DCF-9E86-23026630F7BA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112111" y="3072550"/>
                                  <a:ext cx="348172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100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113" name="Szövegdoboz 112">
                                <a:extLst>
                                  <a:ext uri="{FF2B5EF4-FFF2-40B4-BE49-F238E27FC236}">
                                    <a16:creationId xmlns:a16="http://schemas.microsoft.com/office/drawing/2014/main" id="{C74EC081-888C-897C-B697-3DAA235729A7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8620307" y="4218595"/>
                                <a:ext cx="29367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35</a:t>
                                </a:r>
                              </a:p>
                            </p:txBody>
                          </p:sp>
                        </p:grpSp>
                        <p:pic>
                          <p:nvPicPr>
                            <p:cNvPr id="27" name="Kép 26" descr="A képen fehér, fekete, fekete-fehér, monokróm látható&#10;&#10;Automatikusan generált leírás">
                              <a:extLst>
                                <a:ext uri="{FF2B5EF4-FFF2-40B4-BE49-F238E27FC236}">
                                  <a16:creationId xmlns:a16="http://schemas.microsoft.com/office/drawing/2014/main" id="{5EE7E58D-75FB-A82B-D205-FBCA074C44C4}"/>
                                </a:ext>
                              </a:extLst>
                            </p:cNvPr>
                            <p:cNvPicPr>
                              <a:picLocks/>
                            </p:cNvPicPr>
                            <p:nvPr/>
                          </p:nvPicPr>
                          <p:blipFill>
                            <a:blip r:embed="rId2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792695" y="2994510"/>
                              <a:ext cx="2340000" cy="540000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grpSp>
                      <p:sp>
                        <p:nvSpPr>
                          <p:cNvPr id="56" name="Szövegdoboz 55">
                            <a:extLst>
                              <a:ext uri="{FF2B5EF4-FFF2-40B4-BE49-F238E27FC236}">
                                <a16:creationId xmlns:a16="http://schemas.microsoft.com/office/drawing/2014/main" id="{DBFD3ED0-9DF4-8360-E196-8120E2087E6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104252" y="2904099"/>
                            <a:ext cx="348172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130</a:t>
                            </a:r>
                          </a:p>
                        </p:txBody>
                      </p:sp>
                    </p:grpSp>
                    <p:pic>
                      <p:nvPicPr>
                        <p:cNvPr id="61" name="Kép 60">
                          <a:extLst>
                            <a:ext uri="{FF2B5EF4-FFF2-40B4-BE49-F238E27FC236}">
                              <a16:creationId xmlns:a16="http://schemas.microsoft.com/office/drawing/2014/main" id="{55B549B6-0541-53B3-E375-35308C0D8E3E}"/>
                            </a:ext>
                          </a:extLst>
                        </p:cNvPr>
                        <p:cNvPicPr>
                          <a:picLocks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97842" y="3863490"/>
                          <a:ext cx="2340000" cy="540000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</p:pic>
                  </p:grpSp>
                  <p:pic>
                    <p:nvPicPr>
                      <p:cNvPr id="71" name="Kép 70" descr="A képen fekete, fekete-fehér, monokróm, Monokróm fényképezés látható&#10;&#10;Automatikusan generált leírás">
                        <a:extLst>
                          <a:ext uri="{FF2B5EF4-FFF2-40B4-BE49-F238E27FC236}">
                            <a16:creationId xmlns:a16="http://schemas.microsoft.com/office/drawing/2014/main" id="{90E9F14E-20DF-29F1-949C-B1088A0CD7A1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271251" y="2994510"/>
                        <a:ext cx="2340000" cy="540000"/>
                      </a:xfrm>
                      <a:prstGeom prst="rect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</p:pic>
                </p:grpSp>
                <p:sp>
                  <p:nvSpPr>
                    <p:cNvPr id="79" name="Szövegdoboz 78">
                      <a:extLst>
                        <a:ext uri="{FF2B5EF4-FFF2-40B4-BE49-F238E27FC236}">
                          <a16:creationId xmlns:a16="http://schemas.microsoft.com/office/drawing/2014/main" id="{1AB44755-6F1D-FAD4-6260-B0707E12CE9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69601" y="2946875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70</a:t>
                      </a:r>
                    </a:p>
                  </p:txBody>
                </p:sp>
              </p:grpSp>
              <p:sp>
                <p:nvSpPr>
                  <p:cNvPr id="85" name="Szövegdoboz 84">
                    <a:extLst>
                      <a:ext uri="{FF2B5EF4-FFF2-40B4-BE49-F238E27FC236}">
                        <a16:creationId xmlns:a16="http://schemas.microsoft.com/office/drawing/2014/main" id="{8E664D19-6C23-F10D-DB69-5B9384BEE9B3}"/>
                      </a:ext>
                    </a:extLst>
                  </p:cNvPr>
                  <p:cNvSpPr txBox="1"/>
                  <p:nvPr/>
                </p:nvSpPr>
                <p:spPr>
                  <a:xfrm>
                    <a:off x="4964272" y="3381181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55</a:t>
                    </a:r>
                  </a:p>
                </p:txBody>
              </p:sp>
            </p:grpSp>
            <p:pic>
              <p:nvPicPr>
                <p:cNvPr id="90" name="Kép 89" descr="A képen fekete, monokróm, fekete-fehér, képernyőkép látható&#10;&#10;Automatikusan generált leírás">
                  <a:extLst>
                    <a:ext uri="{FF2B5EF4-FFF2-40B4-BE49-F238E27FC236}">
                      <a16:creationId xmlns:a16="http://schemas.microsoft.com/office/drawing/2014/main" id="{23174421-85C8-835C-F83D-579BACA0D55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269321" y="3858332"/>
                  <a:ext cx="2340000" cy="54000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</p:grpSp>
          <p:pic>
            <p:nvPicPr>
              <p:cNvPr id="95" name="Kép 94" descr="A képen fekete, fekete-fehér, monokróm, Monokróm fényképezés látható&#10;&#10;Automatikusan generált leírás">
                <a:extLst>
                  <a:ext uri="{FF2B5EF4-FFF2-40B4-BE49-F238E27FC236}">
                    <a16:creationId xmlns:a16="http://schemas.microsoft.com/office/drawing/2014/main" id="{AC2AE8CA-63F5-BF51-7859-BF16D004223D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28370" y="2995985"/>
                <a:ext cx="2340000" cy="5400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  <p:pic>
          <p:nvPicPr>
            <p:cNvPr id="99" name="Kép 98" descr="A képen fekete, monokróm, fekete-fehér, képernyőkép látható&#10;&#10;Automatikusan generált leírás">
              <a:extLst>
                <a:ext uri="{FF2B5EF4-FFF2-40B4-BE49-F238E27FC236}">
                  <a16:creationId xmlns:a16="http://schemas.microsoft.com/office/drawing/2014/main" id="{EE5792CB-54C8-47BE-EE8F-A9A17EA491EE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28370" y="3858332"/>
              <a:ext cx="2340000" cy="54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3955391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4E61EA46-CF03-FBB6-50D2-3D75129E7EDA}"/>
              </a:ext>
            </a:extLst>
          </p:cNvPr>
          <p:cNvSpPr txBox="1"/>
          <p:nvPr/>
        </p:nvSpPr>
        <p:spPr>
          <a:xfrm>
            <a:off x="68367" y="68366"/>
            <a:ext cx="2250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/>
              <a:t>BxPC3 </a:t>
            </a:r>
            <a:r>
              <a:rPr lang="hu-HU" b="1" dirty="0" err="1"/>
              <a:t>blots</a:t>
            </a:r>
            <a:r>
              <a:rPr lang="hu-HU" b="1" dirty="0"/>
              <a:t>:</a:t>
            </a:r>
          </a:p>
        </p:txBody>
      </p:sp>
      <p:grpSp>
        <p:nvGrpSpPr>
          <p:cNvPr id="66" name="Csoportba foglalás 65">
            <a:extLst>
              <a:ext uri="{FF2B5EF4-FFF2-40B4-BE49-F238E27FC236}">
                <a16:creationId xmlns:a16="http://schemas.microsoft.com/office/drawing/2014/main" id="{7A966770-0B88-880A-830A-64CDD88D6937}"/>
              </a:ext>
            </a:extLst>
          </p:cNvPr>
          <p:cNvGrpSpPr/>
          <p:nvPr/>
        </p:nvGrpSpPr>
        <p:grpSpPr>
          <a:xfrm>
            <a:off x="68367" y="378270"/>
            <a:ext cx="11964550" cy="3851654"/>
            <a:chOff x="68367" y="378270"/>
            <a:chExt cx="11964550" cy="3851654"/>
          </a:xfrm>
        </p:grpSpPr>
        <p:grpSp>
          <p:nvGrpSpPr>
            <p:cNvPr id="41" name="Csoportba foglalás 40">
              <a:extLst>
                <a:ext uri="{FF2B5EF4-FFF2-40B4-BE49-F238E27FC236}">
                  <a16:creationId xmlns:a16="http://schemas.microsoft.com/office/drawing/2014/main" id="{36DF632E-15E6-C69B-B063-6A54D9F9175C}"/>
                </a:ext>
              </a:extLst>
            </p:cNvPr>
            <p:cNvGrpSpPr/>
            <p:nvPr/>
          </p:nvGrpSpPr>
          <p:grpSpPr>
            <a:xfrm>
              <a:off x="68367" y="378270"/>
              <a:ext cx="11964550" cy="3851654"/>
              <a:chOff x="68367" y="378270"/>
              <a:chExt cx="11964550" cy="3851654"/>
            </a:xfrm>
          </p:grpSpPr>
          <p:grpSp>
            <p:nvGrpSpPr>
              <p:cNvPr id="29" name="Csoportba foglalás 28">
                <a:extLst>
                  <a:ext uri="{FF2B5EF4-FFF2-40B4-BE49-F238E27FC236}">
                    <a16:creationId xmlns:a16="http://schemas.microsoft.com/office/drawing/2014/main" id="{4AD7CF36-CBE5-E7EE-A8F9-2D3AB4461940}"/>
                  </a:ext>
                </a:extLst>
              </p:cNvPr>
              <p:cNvGrpSpPr/>
              <p:nvPr/>
            </p:nvGrpSpPr>
            <p:grpSpPr>
              <a:xfrm>
                <a:off x="68367" y="378270"/>
                <a:ext cx="11964550" cy="3851654"/>
                <a:chOff x="68367" y="378270"/>
                <a:chExt cx="11964550" cy="3851654"/>
              </a:xfrm>
            </p:grpSpPr>
            <p:grpSp>
              <p:nvGrpSpPr>
                <p:cNvPr id="70" name="Csoportba foglalás 69">
                  <a:extLst>
                    <a:ext uri="{FF2B5EF4-FFF2-40B4-BE49-F238E27FC236}">
                      <a16:creationId xmlns:a16="http://schemas.microsoft.com/office/drawing/2014/main" id="{8A7D3AFC-CCC7-A9CC-3205-0CC1DDB89AAA}"/>
                    </a:ext>
                  </a:extLst>
                </p:cNvPr>
                <p:cNvGrpSpPr/>
                <p:nvPr/>
              </p:nvGrpSpPr>
              <p:grpSpPr>
                <a:xfrm>
                  <a:off x="68367" y="378270"/>
                  <a:ext cx="11964550" cy="3851654"/>
                  <a:chOff x="68367" y="378270"/>
                  <a:chExt cx="11964550" cy="3851654"/>
                </a:xfrm>
              </p:grpSpPr>
              <p:grpSp>
                <p:nvGrpSpPr>
                  <p:cNvPr id="65" name="Csoportba foglalás 64">
                    <a:extLst>
                      <a:ext uri="{FF2B5EF4-FFF2-40B4-BE49-F238E27FC236}">
                        <a16:creationId xmlns:a16="http://schemas.microsoft.com/office/drawing/2014/main" id="{D3746092-7748-4FA3-FE40-3B0BECDDF424}"/>
                      </a:ext>
                    </a:extLst>
                  </p:cNvPr>
                  <p:cNvGrpSpPr/>
                  <p:nvPr/>
                </p:nvGrpSpPr>
                <p:grpSpPr>
                  <a:xfrm>
                    <a:off x="68367" y="378270"/>
                    <a:ext cx="11964550" cy="3851654"/>
                    <a:chOff x="68367" y="378270"/>
                    <a:chExt cx="11964550" cy="3851654"/>
                  </a:xfrm>
                </p:grpSpPr>
                <p:grpSp>
                  <p:nvGrpSpPr>
                    <p:cNvPr id="62" name="Csoportba foglalás 61">
                      <a:extLst>
                        <a:ext uri="{FF2B5EF4-FFF2-40B4-BE49-F238E27FC236}">
                          <a16:creationId xmlns:a16="http://schemas.microsoft.com/office/drawing/2014/main" id="{0E50E6AB-D7C4-806B-C030-FA3F2C27A42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7" y="378270"/>
                      <a:ext cx="11964550" cy="3851654"/>
                      <a:chOff x="68367" y="378270"/>
                      <a:chExt cx="11964550" cy="3851654"/>
                    </a:xfrm>
                  </p:grpSpPr>
                  <p:grpSp>
                    <p:nvGrpSpPr>
                      <p:cNvPr id="27" name="Csoportba foglalás 26">
                        <a:extLst>
                          <a:ext uri="{FF2B5EF4-FFF2-40B4-BE49-F238E27FC236}">
                            <a16:creationId xmlns:a16="http://schemas.microsoft.com/office/drawing/2014/main" id="{4FBDFE18-5DB0-C5B6-416A-4622D8C2481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7" y="378270"/>
                        <a:ext cx="11964550" cy="3851654"/>
                        <a:chOff x="68367" y="378270"/>
                        <a:chExt cx="11964550" cy="3851654"/>
                      </a:xfrm>
                    </p:grpSpPr>
                    <p:grpSp>
                      <p:nvGrpSpPr>
                        <p:cNvPr id="2" name="Csoportba foglalás 1">
                          <a:extLst>
                            <a:ext uri="{FF2B5EF4-FFF2-40B4-BE49-F238E27FC236}">
                              <a16:creationId xmlns:a16="http://schemas.microsoft.com/office/drawing/2014/main" id="{7EC54CAD-836F-3229-1E51-9EA74CAE8A7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7" y="378270"/>
                          <a:ext cx="11964550" cy="3851654"/>
                          <a:chOff x="68367" y="378270"/>
                          <a:chExt cx="11964550" cy="3851654"/>
                        </a:xfrm>
                      </p:grpSpPr>
                      <p:grpSp>
                        <p:nvGrpSpPr>
                          <p:cNvPr id="129" name="Csoportba foglalás 128">
                            <a:extLst>
                              <a:ext uri="{FF2B5EF4-FFF2-40B4-BE49-F238E27FC236}">
                                <a16:creationId xmlns:a16="http://schemas.microsoft.com/office/drawing/2014/main" id="{5520BFF5-8A90-0445-343E-1A426AB1C18E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7" y="378270"/>
                            <a:ext cx="11964550" cy="3851654"/>
                            <a:chOff x="68367" y="378270"/>
                            <a:chExt cx="11964550" cy="3851654"/>
                          </a:xfrm>
                        </p:grpSpPr>
                        <p:grpSp>
                          <p:nvGrpSpPr>
                            <p:cNvPr id="102" name="Csoportba foglalás 101">
                              <a:extLst>
                                <a:ext uri="{FF2B5EF4-FFF2-40B4-BE49-F238E27FC236}">
                                  <a16:creationId xmlns:a16="http://schemas.microsoft.com/office/drawing/2014/main" id="{2093C254-E0DA-7308-383C-98B07D39683E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7" y="378270"/>
                              <a:ext cx="11964550" cy="3851654"/>
                              <a:chOff x="68367" y="378270"/>
                              <a:chExt cx="11964550" cy="3851654"/>
                            </a:xfrm>
                          </p:grpSpPr>
                          <p:grpSp>
                            <p:nvGrpSpPr>
                              <p:cNvPr id="61" name="Csoportba foglalás 60">
                                <a:extLst>
                                  <a:ext uri="{FF2B5EF4-FFF2-40B4-BE49-F238E27FC236}">
                                    <a16:creationId xmlns:a16="http://schemas.microsoft.com/office/drawing/2014/main" id="{36FDC435-F37D-965C-CF10-8F2CBC0071F1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7" y="378270"/>
                                <a:ext cx="11964550" cy="3851654"/>
                                <a:chOff x="68367" y="378270"/>
                                <a:chExt cx="11964550" cy="3851654"/>
                              </a:xfrm>
                            </p:grpSpPr>
                            <p:grpSp>
                              <p:nvGrpSpPr>
                                <p:cNvPr id="77" name="Csoportba foglalás 76">
                                  <a:extLst>
                                    <a:ext uri="{FF2B5EF4-FFF2-40B4-BE49-F238E27FC236}">
                                      <a16:creationId xmlns:a16="http://schemas.microsoft.com/office/drawing/2014/main" id="{C569ACAC-D16B-0D65-7D7D-1F76F44BC39F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8367" y="378270"/>
                                  <a:ext cx="11964550" cy="3851654"/>
                                  <a:chOff x="68367" y="378270"/>
                                  <a:chExt cx="11964550" cy="3851654"/>
                                </a:xfrm>
                              </p:grpSpPr>
                              <p:grpSp>
                                <p:nvGrpSpPr>
                                  <p:cNvPr id="33" name="Csoportba foglalás 32">
                                    <a:extLst>
                                      <a:ext uri="{FF2B5EF4-FFF2-40B4-BE49-F238E27FC236}">
                                        <a16:creationId xmlns:a16="http://schemas.microsoft.com/office/drawing/2014/main" id="{74234755-A58A-362A-7964-89361751F9AD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8367" y="378270"/>
                                    <a:ext cx="11964550" cy="3851654"/>
                                    <a:chOff x="68367" y="378270"/>
                                    <a:chExt cx="11964550" cy="3851654"/>
                                  </a:xfrm>
                                </p:grpSpPr>
                                <p:grpSp>
                                  <p:nvGrpSpPr>
                                    <p:cNvPr id="22" name="Csoportba foglalás 21">
                                      <a:extLst>
                                        <a:ext uri="{FF2B5EF4-FFF2-40B4-BE49-F238E27FC236}">
                                          <a16:creationId xmlns:a16="http://schemas.microsoft.com/office/drawing/2014/main" id="{BEE41243-DEF0-695A-74F2-20214D9B4C58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8367" y="378270"/>
                                      <a:ext cx="11964550" cy="3851654"/>
                                      <a:chOff x="68367" y="378270"/>
                                      <a:chExt cx="11964550" cy="3851654"/>
                                    </a:xfrm>
                                  </p:grpSpPr>
                                  <p:grpSp>
                                    <p:nvGrpSpPr>
                                      <p:cNvPr id="76" name="Csoportba foglalás 75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07F847BE-36B5-68B3-4646-5E2854D87DFD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8367" y="378270"/>
                                        <a:ext cx="11964550" cy="3851654"/>
                                        <a:chOff x="68367" y="378270"/>
                                        <a:chExt cx="11964550" cy="3851654"/>
                                      </a:xfrm>
                                    </p:grpSpPr>
                                    <p:grpSp>
                                      <p:nvGrpSpPr>
                                        <p:cNvPr id="59" name="Csoportba foglalás 58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D69FBEC8-63C6-D8A3-6667-5AB6865BEE97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8367" y="378270"/>
                                          <a:ext cx="11964550" cy="3851654"/>
                                          <a:chOff x="68367" y="378270"/>
                                          <a:chExt cx="11964550" cy="3851654"/>
                                        </a:xfrm>
                                      </p:grpSpPr>
                                      <p:grpSp>
                                        <p:nvGrpSpPr>
                                          <p:cNvPr id="5" name="Csoportba foglalás 4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666EC76C-2260-6217-0624-8D898ED5A4E4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68367" y="378270"/>
                                            <a:ext cx="11964550" cy="3851654"/>
                                            <a:chOff x="68367" y="378270"/>
                                            <a:chExt cx="11964550" cy="3851654"/>
                                          </a:xfrm>
                                        </p:grpSpPr>
                                        <p:sp>
                                          <p:nvSpPr>
                                            <p:cNvPr id="6" name="Szövegdoboz 5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1EE92C5E-E4EC-2CEC-670B-01AFCBAF0098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5773029" y="3293501"/>
                                              <a:ext cx="47000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DMSO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7" name="Szövegdoboz 6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DCA53139-B3EF-2478-66CC-2DBFD2DA811A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6559268" y="3290410"/>
                                              <a:ext cx="457176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UDCA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8" name="Szövegdoboz 7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59B18E5D-9CAA-1B96-B3D8-B587D74C772B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2136813" y="3294565"/>
                                              <a:ext cx="47000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DMSO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9" name="Szövegdoboz 8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CBA7CB9F-0B07-F693-FF24-6BAB2FD09EA9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2819355" y="3291475"/>
                                              <a:ext cx="457176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UDCA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0" name="Szövegdoboz 9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26D52466-16B5-4210-DBA7-126A8D1CC5F2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9752793" y="3285007"/>
                                              <a:ext cx="47000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DMSO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1" name="Szövegdoboz 10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E1C1C8CB-BEF3-799C-6817-7756DC67E587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0415597" y="3289320"/>
                                              <a:ext cx="457176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UDCA</a:t>
                                              </a:r>
                                            </a:p>
                                          </p:txBody>
                                        </p:sp>
                                        <p:grpSp>
                                          <p:nvGrpSpPr>
                                            <p:cNvPr id="13" name="Csoportba foglalás 12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F7953510-80C4-08DE-5F12-30E0E9381EFE}"/>
                                                </a:ext>
                                              </a:extLst>
                                            </p:cNvPr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68367" y="378270"/>
                                              <a:ext cx="11964550" cy="3851654"/>
                                              <a:chOff x="68367" y="378270"/>
                                              <a:chExt cx="11964550" cy="3851654"/>
                                            </a:xfrm>
                                          </p:grpSpPr>
                                          <p:grpSp>
                                            <p:nvGrpSpPr>
                                              <p:cNvPr id="17" name="Csoportba foglalás 16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D2869022-5E02-D495-459D-4C73CF0945AD}"/>
                                                  </a:ext>
                                                </a:extLst>
                                              </p:cNvPr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68367" y="378270"/>
                                                <a:ext cx="11964550" cy="3851654"/>
                                                <a:chOff x="68367" y="378270"/>
                                                <a:chExt cx="11964550" cy="3851654"/>
                                              </a:xfrm>
                                            </p:grpSpPr>
                                            <p:sp>
                                              <p:nvSpPr>
                                                <p:cNvPr id="24" name="Szövegdoboz 23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9DBE9E64-7749-5286-A934-87C2DA3328AA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5700925" y="602730"/>
                                                  <a:ext cx="470000" cy="215444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800" dirty="0"/>
                                                    <a:t>DMSO</a:t>
                                                  </a:r>
                                                </a:p>
                                              </p:txBody>
                                            </p:sp>
                                            <p:sp>
                                              <p:nvSpPr>
                                                <p:cNvPr id="25" name="Szövegdoboz 24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74AB1839-0AF7-9320-D373-719005F5B9E5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317470" y="609065"/>
                                                  <a:ext cx="457176" cy="215444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800" dirty="0"/>
                                                    <a:t>UDCA</a:t>
                                                  </a:r>
                                                </a:p>
                                              </p:txBody>
                                            </p:sp>
                                            <p:grpSp>
                                              <p:nvGrpSpPr>
                                                <p:cNvPr id="40" name="Csoportba foglalás 39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AD74C5FA-955A-53AC-A5DE-7102165BBD28}"/>
                                                    </a:ext>
                                                  </a:extLst>
                                                </p:cNvPr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68367" y="378270"/>
                                                  <a:ext cx="11964550" cy="3851654"/>
                                                  <a:chOff x="68367" y="415477"/>
                                                  <a:chExt cx="11964550" cy="3851654"/>
                                                </a:xfrm>
                                              </p:grpSpPr>
                                              <p:sp>
                                                <p:nvSpPr>
                                                  <p:cNvPr id="45" name="Szövegdoboz 44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66D3585D-B626-E2C5-481E-54A1670C3C57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68367" y="869125"/>
                                                    <a:ext cx="1271179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squar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dirty="0"/>
                                                      <a:t>4HNE: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  <p:sp>
                                                <p:nvSpPr>
                                                  <p:cNvPr id="46" name="Szövegdoboz 45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D28978E5-AA9F-8E23-7150-26C97BBEA88B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68367" y="3653777"/>
                                                    <a:ext cx="803304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squar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dirty="0"/>
                                                      <a:t>β-</a:t>
                                                    </a:r>
                                                    <a:r>
                                                      <a:rPr lang="hu-HU" sz="1400" dirty="0" err="1"/>
                                                      <a:t>actin</a:t>
                                                    </a:r>
                                                    <a:r>
                                                      <a:rPr lang="hu-HU" sz="1400" dirty="0"/>
                                                      <a:t>: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  <p:grpSp>
                                                <p:nvGrpSpPr>
                                                  <p:cNvPr id="47" name="Csoportba foglalás 46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ECC78131-FA46-9B9E-121A-F2AFAC1773DF}"/>
                                                      </a:ext>
                                                    </a:extLst>
                                                  </p:cNvPr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2112589" y="415641"/>
                                                    <a:ext cx="1073723" cy="443414"/>
                                                    <a:chOff x="2112589" y="415641"/>
                                                    <a:chExt cx="1073723" cy="443414"/>
                                                  </a:xfrm>
                                                </p:grpSpPr>
                                                <p:grpSp>
                                                  <p:nvGrpSpPr>
                                                    <p:cNvPr id="51" name="Csoportba foglalás 50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D1F86804-959C-FDB1-6496-7E5C944541AE}"/>
                                                        </a:ext>
                                                      </a:extLst>
                                                    </p:cNvPr>
                                                    <p:cNvGrpSpPr/>
                                                    <p:nvPr/>
                                                  </p:nvGrpSpPr>
                                                  <p:grpSpPr>
                                                    <a:xfrm>
                                                      <a:off x="2112589" y="637276"/>
                                                      <a:ext cx="1073723" cy="221779"/>
                                                      <a:chOff x="2112589" y="261266"/>
                                                      <a:chExt cx="1073723" cy="221779"/>
                                                    </a:xfrm>
                                                  </p:grpSpPr>
                                                  <p:sp>
                                                    <p:nvSpPr>
                                                      <p:cNvPr id="53" name="Szövegdoboz 52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4185ACB4-2E26-53E4-7817-E9EC98D80B21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2112589" y="261266"/>
                                                        <a:ext cx="470000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DMSO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54" name="Szövegdoboz 53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FBEA5532-CAE2-88D1-FBDE-A57D01FAD56E}"/>
                                                          </a:ext>
                                                        </a:extLst>
                                                      </p:cNvPr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2729136" y="267601"/>
                                                        <a:ext cx="457176" cy="215444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non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r>
                                                          <a:rPr lang="hu-HU" sz="800" dirty="0"/>
                                                          <a:t>UDCA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</p:grpSp>
                                                <p:sp>
                                                  <p:nvSpPr>
                                                    <p:cNvPr id="52" name="Szövegdoboz 51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87C03FB1-0305-6610-B2F8-3AF2F9687DAF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2533973" y="415641"/>
                                                      <a:ext cx="332142" cy="307777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1400" b="1" dirty="0"/>
                                                        <a:t>1.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</p:grpSp>
                                              <p:sp>
                                                <p:nvSpPr>
                                                  <p:cNvPr id="48" name="Szövegdoboz 47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FF8775A9-DE28-A990-FA6B-A5EA7988A5B4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6271647" y="416294"/>
                                                    <a:ext cx="335348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b="1" dirty="0"/>
                                                      <a:t>2.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  <p:sp>
                                                <p:nvSpPr>
                                                  <p:cNvPr id="49" name="Szövegdoboz 48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D9333B53-470F-176B-2960-30B707B78615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10016820" y="415477"/>
                                                    <a:ext cx="335348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b="1" dirty="0"/>
                                                      <a:t>3.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  <p:sp>
                                                <p:nvSpPr>
                                                  <p:cNvPr id="50" name="Téglalap 49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7EE5AF85-79AD-2E88-859A-74FA3BC508C3}"/>
                                                      </a:ext>
                                                    </a:extLst>
                                                  </p:cNvPr>
                                                  <p:cNvSpPr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70822" y="474905"/>
                                                    <a:ext cx="11962095" cy="3792226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style>
                                                  <a:lnRef idx="2">
                                                    <a:schemeClr val="accent1">
                                                      <a:shade val="15000"/>
                                                    </a:schemeClr>
                                                  </a:lnRef>
                                                  <a:fillRef idx="1">
                                                    <a:schemeClr val="accent1"/>
                                                  </a:fillRef>
                                                  <a:effectRef idx="0">
                                                    <a:schemeClr val="accent1"/>
                                                  </a:effectRef>
                                                  <a:fontRef idx="minor">
                                                    <a:schemeClr val="lt1"/>
                                                  </a:fontRef>
                                                </p:style>
                                                <p:txBody>
                                                  <a:bodyPr rtlCol="0" anchor="ctr"/>
                                                  <a:lstStyle/>
                                                  <a:p>
                                                    <a:pPr algn="ctr"/>
                                                    <a:endParaRPr lang="hu-HU"/>
                                                  </a:p>
                                                </p:txBody>
                                              </p:sp>
                                            </p:grpSp>
                                          </p:grpSp>
                                          <p:sp>
                                            <p:nvSpPr>
                                              <p:cNvPr id="19" name="Szövegdoboz 18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BF3BA821-64F9-7542-13DC-3694C7DD53BF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9859655" y="622936"/>
                                                <a:ext cx="470000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DMSO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20" name="Szövegdoboz 19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BFA7C2B5-D68F-0DB7-73EE-E123146A0886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10456485" y="627249"/>
                                                <a:ext cx="457176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UDCA</a:t>
                                                </a:r>
                                              </a:p>
                                            </p:txBody>
                                          </p:sp>
                                        </p:grpSp>
                                      </p:grpSp>
                                      <p:sp>
                                        <p:nvSpPr>
                                          <p:cNvPr id="58" name="Szövegdoboz 57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0FA3A88A-7BFD-0A39-C497-4857235015E0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1706491" y="780680"/>
                                            <a:ext cx="348172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250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  <p:sp>
                                      <p:nvSpPr>
                                        <p:cNvPr id="74" name="Szövegdoboz 73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3B0CFB52-98AD-0BAE-3F2B-AA20920D756B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7237888" y="3896642"/>
                                          <a:ext cx="29367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35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18" name="Szövegdoboz 17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5EB4E4E8-4465-901C-0C1F-467C42EC9A2A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708059" y="961361"/>
                                        <a:ext cx="348172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130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21" name="Szövegdoboz 20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7056F621-6DE4-7B91-184D-1C9EE20A6CD2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700202" y="1170323"/>
                                        <a:ext cx="348172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100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32" name="Szövegdoboz 31">
                                      <a:extLst>
                                        <a:ext uri="{FF2B5EF4-FFF2-40B4-BE49-F238E27FC236}">
                                          <a16:creationId xmlns:a16="http://schemas.microsoft.com/office/drawing/2014/main" id="{4E50FDCC-5278-358B-F6B8-D5CD847F8219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760575" y="3891525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35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73" name="Szövegdoboz 72">
                                    <a:extLst>
                                      <a:ext uri="{FF2B5EF4-FFF2-40B4-BE49-F238E27FC236}">
                                        <a16:creationId xmlns:a16="http://schemas.microsoft.com/office/drawing/2014/main" id="{8C45F1EF-436E-B74A-BAF6-0C9C20D9DD4E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9059363" y="3888947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35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34" name="Szövegdoboz 33">
                                  <a:extLst>
                                    <a:ext uri="{FF2B5EF4-FFF2-40B4-BE49-F238E27FC236}">
                                      <a16:creationId xmlns:a16="http://schemas.microsoft.com/office/drawing/2014/main" id="{D6188A28-89D5-0BC1-3F9E-AA1D8E4330A2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1758332" y="1567824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70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56" name="Szövegdoboz 55">
                                  <a:extLst>
                                    <a:ext uri="{FF2B5EF4-FFF2-40B4-BE49-F238E27FC236}">
                                      <a16:creationId xmlns:a16="http://schemas.microsoft.com/office/drawing/2014/main" id="{778D88D3-004B-40A4-8772-7C5179BFE2C8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1759901" y="1946469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55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57" name="Szövegdoboz 56">
                                  <a:extLst>
                                    <a:ext uri="{FF2B5EF4-FFF2-40B4-BE49-F238E27FC236}">
                                      <a16:creationId xmlns:a16="http://schemas.microsoft.com/office/drawing/2014/main" id="{B3086FA4-43ED-D397-9146-153FC02C3204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1761469" y="2268553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35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60" name="Szövegdoboz 59">
                                  <a:extLst>
                                    <a:ext uri="{FF2B5EF4-FFF2-40B4-BE49-F238E27FC236}">
                                      <a16:creationId xmlns:a16="http://schemas.microsoft.com/office/drawing/2014/main" id="{2A8686C0-6365-EA89-9281-2E73920E1302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1763038" y="2901717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25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86" name="Szövegdoboz 85">
                                <a:extLst>
                                  <a:ext uri="{FF2B5EF4-FFF2-40B4-BE49-F238E27FC236}">
                                    <a16:creationId xmlns:a16="http://schemas.microsoft.com/office/drawing/2014/main" id="{0693B11E-92DF-39B0-D387-D3FB051A70F1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241599" y="782248"/>
                                <a:ext cx="348172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250</a:t>
                                </a:r>
                              </a:p>
                            </p:txBody>
                          </p:sp>
                          <p:sp>
                            <p:nvSpPr>
                              <p:cNvPr id="87" name="Szövegdoboz 86">
                                <a:extLst>
                                  <a:ext uri="{FF2B5EF4-FFF2-40B4-BE49-F238E27FC236}">
                                    <a16:creationId xmlns:a16="http://schemas.microsoft.com/office/drawing/2014/main" id="{4E98C77A-06EE-4D26-5CCC-08214BE303B0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243167" y="1047772"/>
                                <a:ext cx="348172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130</a:t>
                                </a:r>
                              </a:p>
                            </p:txBody>
                          </p:sp>
                          <p:sp>
                            <p:nvSpPr>
                              <p:cNvPr id="90" name="Szövegdoboz 89">
                                <a:extLst>
                                  <a:ext uri="{FF2B5EF4-FFF2-40B4-BE49-F238E27FC236}">
                                    <a16:creationId xmlns:a16="http://schemas.microsoft.com/office/drawing/2014/main" id="{4DBB35F8-07E1-9B61-35EA-01E038C1F9BB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235310" y="1285015"/>
                                <a:ext cx="348172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100</a:t>
                                </a:r>
                              </a:p>
                            </p:txBody>
                          </p:sp>
                          <p:sp>
                            <p:nvSpPr>
                              <p:cNvPr id="94" name="Szövegdoboz 93">
                                <a:extLst>
                                  <a:ext uri="{FF2B5EF4-FFF2-40B4-BE49-F238E27FC236}">
                                    <a16:creationId xmlns:a16="http://schemas.microsoft.com/office/drawing/2014/main" id="{99386176-73FB-619A-4958-D055BA5B4A99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236878" y="1531685"/>
                                <a:ext cx="29367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70</a:t>
                                </a:r>
                              </a:p>
                            </p:txBody>
                          </p:sp>
                          <p:sp>
                            <p:nvSpPr>
                              <p:cNvPr id="95" name="Szövegdoboz 94">
                                <a:extLst>
                                  <a:ext uri="{FF2B5EF4-FFF2-40B4-BE49-F238E27FC236}">
                                    <a16:creationId xmlns:a16="http://schemas.microsoft.com/office/drawing/2014/main" id="{D0C2B3E6-9AF9-8904-5746-A2176C2085BA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238447" y="1825486"/>
                                <a:ext cx="29367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55</a:t>
                                </a:r>
                              </a:p>
                            </p:txBody>
                          </p:sp>
                          <p:sp>
                            <p:nvSpPr>
                              <p:cNvPr id="96" name="Szövegdoboz 95">
                                <a:extLst>
                                  <a:ext uri="{FF2B5EF4-FFF2-40B4-BE49-F238E27FC236}">
                                    <a16:creationId xmlns:a16="http://schemas.microsoft.com/office/drawing/2014/main" id="{95591784-E206-CB66-6D7E-3C4A63073FFC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240015" y="2420946"/>
                                <a:ext cx="29367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35</a:t>
                                </a:r>
                              </a:p>
                            </p:txBody>
                          </p:sp>
                          <p:sp>
                            <p:nvSpPr>
                              <p:cNvPr id="99" name="Szövegdoboz 98">
                                <a:extLst>
                                  <a:ext uri="{FF2B5EF4-FFF2-40B4-BE49-F238E27FC236}">
                                    <a16:creationId xmlns:a16="http://schemas.microsoft.com/office/drawing/2014/main" id="{965D7DDF-485F-B599-62AA-DF22CC5D34D8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241584" y="2827869"/>
                                <a:ext cx="29367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25</a:t>
                                </a:r>
                              </a:p>
                            </p:txBody>
                          </p:sp>
                        </p:grpSp>
                        <p:sp>
                          <p:nvSpPr>
                            <p:cNvPr id="121" name="Szövegdoboz 120">
                              <a:extLst>
                                <a:ext uri="{FF2B5EF4-FFF2-40B4-BE49-F238E27FC236}">
                                  <a16:creationId xmlns:a16="http://schemas.microsoft.com/office/drawing/2014/main" id="{1898A444-C0BB-657E-8DFA-3B4670C7E1A4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9015407" y="774392"/>
                              <a:ext cx="348172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250</a:t>
                              </a:r>
                            </a:p>
                          </p:txBody>
                        </p:sp>
                        <p:sp>
                          <p:nvSpPr>
                            <p:cNvPr id="122" name="Szövegdoboz 121">
                              <a:extLst>
                                <a:ext uri="{FF2B5EF4-FFF2-40B4-BE49-F238E27FC236}">
                                  <a16:creationId xmlns:a16="http://schemas.microsoft.com/office/drawing/2014/main" id="{675B4CCE-8577-94CA-47BF-8D183D85472D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9016975" y="1021062"/>
                              <a:ext cx="348172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130</a:t>
                              </a:r>
                            </a:p>
                          </p:txBody>
                        </p:sp>
                        <p:sp>
                          <p:nvSpPr>
                            <p:cNvPr id="123" name="Szövegdoboz 122">
                              <a:extLst>
                                <a:ext uri="{FF2B5EF4-FFF2-40B4-BE49-F238E27FC236}">
                                  <a16:creationId xmlns:a16="http://schemas.microsoft.com/office/drawing/2014/main" id="{70AE2675-25E4-D3B3-4A93-BF29DC660B18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9009118" y="1239451"/>
                              <a:ext cx="348172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100</a:t>
                              </a:r>
                            </a:p>
                          </p:txBody>
                        </p:sp>
                        <p:sp>
                          <p:nvSpPr>
                            <p:cNvPr id="125" name="Szövegdoboz 124">
                              <a:extLst>
                                <a:ext uri="{FF2B5EF4-FFF2-40B4-BE49-F238E27FC236}">
                                  <a16:creationId xmlns:a16="http://schemas.microsoft.com/office/drawing/2014/main" id="{6640F9D8-DCA3-E292-8EEB-41A6A9E10DC6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9067248" y="1476694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70</a:t>
                              </a:r>
                            </a:p>
                          </p:txBody>
                        </p:sp>
                        <p:sp>
                          <p:nvSpPr>
                            <p:cNvPr id="126" name="Szövegdoboz 125">
                              <a:extLst>
                                <a:ext uri="{FF2B5EF4-FFF2-40B4-BE49-F238E27FC236}">
                                  <a16:creationId xmlns:a16="http://schemas.microsoft.com/office/drawing/2014/main" id="{66CA1591-7E31-C235-69FE-F544839705CC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9068817" y="1817637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55</a:t>
                              </a:r>
                            </a:p>
                          </p:txBody>
                        </p:sp>
                        <p:sp>
                          <p:nvSpPr>
                            <p:cNvPr id="127" name="Szövegdoboz 126">
                              <a:extLst>
                                <a:ext uri="{FF2B5EF4-FFF2-40B4-BE49-F238E27FC236}">
                                  <a16:creationId xmlns:a16="http://schemas.microsoft.com/office/drawing/2014/main" id="{A735A463-8D83-3D66-9A8D-1F0A54E1846D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9070385" y="2431948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35</a:t>
                              </a:r>
                            </a:p>
                          </p:txBody>
                        </p:sp>
                        <p:sp>
                          <p:nvSpPr>
                            <p:cNvPr id="128" name="Szövegdoboz 127">
                              <a:extLst>
                                <a:ext uri="{FF2B5EF4-FFF2-40B4-BE49-F238E27FC236}">
                                  <a16:creationId xmlns:a16="http://schemas.microsoft.com/office/drawing/2014/main" id="{319E8886-DC4B-8AD4-4292-99B313652AEE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9062527" y="2791739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25</a:t>
                              </a:r>
                            </a:p>
                          </p:txBody>
                        </p:sp>
                      </p:grpSp>
                      <p:pic>
                        <p:nvPicPr>
                          <p:cNvPr id="14" name="Kép 13" descr="A képen szöveg, fekete-fehér, Monokróm fényképezés, monokróm látható&#10;&#10;Automatikusan generált leírás">
                            <a:extLst>
                              <a:ext uri="{FF2B5EF4-FFF2-40B4-BE49-F238E27FC236}">
                                <a16:creationId xmlns:a16="http://schemas.microsoft.com/office/drawing/2014/main" id="{BE60E281-F3D7-466D-BB50-AA4D3C0CD4E5}"/>
                              </a:ext>
                            </a:extLst>
                          </p:cNvPr>
                          <p:cNvPicPr>
                            <a:picLocks/>
                          </p:cNvPicPr>
                          <p:nvPr/>
                        </p:nvPicPr>
                        <p:blipFill>
                          <a:blip r:embed="rId2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2064649" y="831918"/>
                            <a:ext cx="1260000" cy="2340000"/>
                          </a:xfrm>
                          <a:prstGeom prst="rect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</p:pic>
                    </p:grpSp>
                    <p:pic>
                      <p:nvPicPr>
                        <p:cNvPr id="26" name="Kép 25">
                          <a:extLst>
                            <a:ext uri="{FF2B5EF4-FFF2-40B4-BE49-F238E27FC236}">
                              <a16:creationId xmlns:a16="http://schemas.microsoft.com/office/drawing/2014/main" id="{BFF5F1CF-D04E-F171-CF88-9BEC4F5A1662}"/>
                            </a:ext>
                          </a:extLst>
                        </p:cNvPr>
                        <p:cNvPicPr>
                          <a:picLocks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2064649" y="3514058"/>
                          <a:ext cx="1260000" cy="540000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</p:pic>
                  </p:grpSp>
                  <p:pic>
                    <p:nvPicPr>
                      <p:cNvPr id="36" name="Kép 35" descr="A képen fekete-fehér, Monokróm fényképezés, monokróm, fekete látható&#10;&#10;Automatikusan generált leírás">
                        <a:extLst>
                          <a:ext uri="{FF2B5EF4-FFF2-40B4-BE49-F238E27FC236}">
                            <a16:creationId xmlns:a16="http://schemas.microsoft.com/office/drawing/2014/main" id="{40724D5C-36B1-F435-153F-669542D0A6BB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614242" y="828649"/>
                        <a:ext cx="1620000" cy="2340000"/>
                      </a:xfrm>
                      <a:prstGeom prst="rect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</p:pic>
                </p:grpSp>
                <p:pic>
                  <p:nvPicPr>
                    <p:cNvPr id="55" name="Kép 54" descr="A képen monokróm, fekete-fehér, fekete, Monokróm fényképezés látható&#10;&#10;Automatikusan generált leírás">
                      <a:extLst>
                        <a:ext uri="{FF2B5EF4-FFF2-40B4-BE49-F238E27FC236}">
                          <a16:creationId xmlns:a16="http://schemas.microsoft.com/office/drawing/2014/main" id="{94A35506-F55A-1CDB-12B1-284DAD9ED8F9}"/>
                        </a:ext>
                      </a:extLst>
                    </p:cNvPr>
                    <p:cNvPicPr>
                      <a:picLocks/>
                    </p:cNvPicPr>
                    <p:nvPr/>
                  </p:nvPicPr>
                  <p:blipFill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614242" y="3514058"/>
                      <a:ext cx="1620000" cy="540000"/>
                    </a:xfrm>
                    <a:prstGeom prst="rect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</p:pic>
              </p:grpSp>
              <p:pic>
                <p:nvPicPr>
                  <p:cNvPr id="67" name="Kép 66" descr="A képen fekete-fehér, monokróm, Monokróm fényképezés, fekete látható&#10;&#10;Automatikusan generált leírás">
                    <a:extLst>
                      <a:ext uri="{FF2B5EF4-FFF2-40B4-BE49-F238E27FC236}">
                        <a16:creationId xmlns:a16="http://schemas.microsoft.com/office/drawing/2014/main" id="{F0C2EB06-70F0-AB9D-5E2D-F7E95A878866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367197" y="824509"/>
                    <a:ext cx="1620000" cy="2340000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  <p:pic>
                <p:nvPicPr>
                  <p:cNvPr id="69" name="Kép 68" descr="A képen fekete, monokróm, fekete-fehér, Monokróm fényképezés látható&#10;&#10;Automatikusan generált leírás">
                    <a:extLst>
                      <a:ext uri="{FF2B5EF4-FFF2-40B4-BE49-F238E27FC236}">
                        <a16:creationId xmlns:a16="http://schemas.microsoft.com/office/drawing/2014/main" id="{38BF238D-1669-A410-2DE1-40CED821209B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360918" y="3514058"/>
                    <a:ext cx="1620000" cy="540000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</p:grpSp>
            <p:cxnSp>
              <p:nvCxnSpPr>
                <p:cNvPr id="12" name="Egyenes összekötő nyíllal 11">
                  <a:extLst>
                    <a:ext uri="{FF2B5EF4-FFF2-40B4-BE49-F238E27FC236}">
                      <a16:creationId xmlns:a16="http://schemas.microsoft.com/office/drawing/2014/main" id="{2B744073-08A6-8BBB-B68E-B6052C579AE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377424" y="1228615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Egyenes összekötő nyíllal 14">
                  <a:extLst>
                    <a:ext uri="{FF2B5EF4-FFF2-40B4-BE49-F238E27FC236}">
                      <a16:creationId xmlns:a16="http://schemas.microsoft.com/office/drawing/2014/main" id="{C801249F-68F3-671A-5F3C-69EAC1AF1A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377424" y="1687708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Egyenes összekötő nyíllal 15">
                  <a:extLst>
                    <a:ext uri="{FF2B5EF4-FFF2-40B4-BE49-F238E27FC236}">
                      <a16:creationId xmlns:a16="http://schemas.microsoft.com/office/drawing/2014/main" id="{503BBA1D-63E7-4130-A87E-C27F6D8841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377424" y="1805232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Egyenes összekötő nyíllal 22">
                  <a:extLst>
                    <a:ext uri="{FF2B5EF4-FFF2-40B4-BE49-F238E27FC236}">
                      <a16:creationId xmlns:a16="http://schemas.microsoft.com/office/drawing/2014/main" id="{FA400682-B3F9-03A9-4688-A61FEEAFBBA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375997" y="1991816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Egyenes összekötő nyíllal 27">
                  <a:extLst>
                    <a:ext uri="{FF2B5EF4-FFF2-40B4-BE49-F238E27FC236}">
                      <a16:creationId xmlns:a16="http://schemas.microsoft.com/office/drawing/2014/main" id="{E2FC1CB9-2A79-4E9E-1F95-F6ED78C902B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374571" y="2246768"/>
                  <a:ext cx="289903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0" name="Egyenes összekötő nyíllal 29">
                <a:extLst>
                  <a:ext uri="{FF2B5EF4-FFF2-40B4-BE49-F238E27FC236}">
                    <a16:creationId xmlns:a16="http://schemas.microsoft.com/office/drawing/2014/main" id="{1CC04FED-F768-ED42-3E1A-AAFA89593D19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 flipV="1">
                <a:off x="5266040" y="1296983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Egyenes összekötő nyíllal 30">
                <a:extLst>
                  <a:ext uri="{FF2B5EF4-FFF2-40B4-BE49-F238E27FC236}">
                    <a16:creationId xmlns:a16="http://schemas.microsoft.com/office/drawing/2014/main" id="{AC4BBFA7-3D72-CCE9-7B61-6D1DC6763E2A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 flipV="1">
                <a:off x="5266040" y="1636439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Egyenes összekötő nyíllal 34">
                <a:extLst>
                  <a:ext uri="{FF2B5EF4-FFF2-40B4-BE49-F238E27FC236}">
                    <a16:creationId xmlns:a16="http://schemas.microsoft.com/office/drawing/2014/main" id="{FA61294E-E1C8-5377-94C7-FBB4A0539F97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 flipV="1">
                <a:off x="5266040" y="1736864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Egyenes összekötő nyíllal 36">
                <a:extLst>
                  <a:ext uri="{FF2B5EF4-FFF2-40B4-BE49-F238E27FC236}">
                    <a16:creationId xmlns:a16="http://schemas.microsoft.com/office/drawing/2014/main" id="{679F3AF0-72DF-8881-8393-831CD3B09A03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 flipV="1">
                <a:off x="5264613" y="2137099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Egyenes összekötő nyíllal 37">
                <a:extLst>
                  <a:ext uri="{FF2B5EF4-FFF2-40B4-BE49-F238E27FC236}">
                    <a16:creationId xmlns:a16="http://schemas.microsoft.com/office/drawing/2014/main" id="{DEEEA565-BDB5-6B92-F33C-2E7236CA0F84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 flipV="1">
                <a:off x="5263187" y="2409141"/>
                <a:ext cx="289903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2" name="Egyenes összekötő nyíllal 41">
              <a:extLst>
                <a:ext uri="{FF2B5EF4-FFF2-40B4-BE49-F238E27FC236}">
                  <a16:creationId xmlns:a16="http://schemas.microsoft.com/office/drawing/2014/main" id="{34A1D7CC-8374-62ED-2280-3F6149736D7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43009" y="1296983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Egyenes összekötő nyíllal 42">
              <a:extLst>
                <a:ext uri="{FF2B5EF4-FFF2-40B4-BE49-F238E27FC236}">
                  <a16:creationId xmlns:a16="http://schemas.microsoft.com/office/drawing/2014/main" id="{20F10E80-444F-73DF-FB7D-6DD39395DD1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43009" y="1662077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Egyenes összekötő nyíllal 43">
              <a:extLst>
                <a:ext uri="{FF2B5EF4-FFF2-40B4-BE49-F238E27FC236}">
                  <a16:creationId xmlns:a16="http://schemas.microsoft.com/office/drawing/2014/main" id="{6C02CC3E-1188-5360-DBBA-1140465AC90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43009" y="1788140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Egyenes összekötő nyíllal 62">
              <a:extLst>
                <a:ext uri="{FF2B5EF4-FFF2-40B4-BE49-F238E27FC236}">
                  <a16:creationId xmlns:a16="http://schemas.microsoft.com/office/drawing/2014/main" id="{878C5AAD-CF62-84A9-CEB5-34472B8E883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41582" y="2162736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Egyenes összekötő nyíllal 63">
              <a:extLst>
                <a:ext uri="{FF2B5EF4-FFF2-40B4-BE49-F238E27FC236}">
                  <a16:creationId xmlns:a16="http://schemas.microsoft.com/office/drawing/2014/main" id="{E0B862F0-BACB-D118-3660-47F0DBDE84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40156" y="2451871"/>
              <a:ext cx="28990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54881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2</TotalTime>
  <Words>277</Words>
  <Application>Microsoft Office PowerPoint</Application>
  <PresentationFormat>Szélesvásznú</PresentationFormat>
  <Paragraphs>238</Paragraphs>
  <Slides>5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-téma</vt:lpstr>
      <vt:lpstr>PowerPoint-bemutató</vt:lpstr>
      <vt:lpstr>PowerPoint-bemutató</vt:lpstr>
      <vt:lpstr>PowerPoint-bemutató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Patrik</dc:creator>
  <cp:lastModifiedBy>Edit</cp:lastModifiedBy>
  <cp:revision>176</cp:revision>
  <dcterms:created xsi:type="dcterms:W3CDTF">2024-03-11T09:39:17Z</dcterms:created>
  <dcterms:modified xsi:type="dcterms:W3CDTF">2024-09-09T09:47:17Z</dcterms:modified>
</cp:coreProperties>
</file>